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7" r:id="rId2"/>
  </p:sldIdLst>
  <p:sldSz cx="12192000" cy="6858000"/>
  <p:notesSz cx="7102475" cy="102346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>
      <p:cViewPr varScale="1">
        <p:scale>
          <a:sx n="108" d="100"/>
          <a:sy n="108" d="100"/>
        </p:scale>
        <p:origin x="71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7" Type="http://schemas.microsoft.com/office/2016/11/relationships/changesInfo" Target="changesInfos/changesInfo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Joanna Bury" userId="0eb69649-27cb-4e1f-82d4-22f29aef5571" providerId="ADAL" clId="{72E2DFC3-2130-425E-AF91-2C796C872C89}"/>
    <pc:docChg chg="undo custSel modSld">
      <pc:chgData name="Joanna Bury" userId="0eb69649-27cb-4e1f-82d4-22f29aef5571" providerId="ADAL" clId="{72E2DFC3-2130-425E-AF91-2C796C872C89}" dt="2020-10-29T19:31:52.850" v="18" actId="6549"/>
      <pc:docMkLst>
        <pc:docMk/>
      </pc:docMkLst>
      <pc:sldChg chg="modSp mod">
        <pc:chgData name="Joanna Bury" userId="0eb69649-27cb-4e1f-82d4-22f29aef5571" providerId="ADAL" clId="{72E2DFC3-2130-425E-AF91-2C796C872C89}" dt="2020-10-29T19:31:52.850" v="18" actId="6549"/>
        <pc:sldMkLst>
          <pc:docMk/>
          <pc:sldMk cId="1247222253" sldId="267"/>
        </pc:sldMkLst>
        <pc:spChg chg="mod">
          <ac:chgData name="Joanna Bury" userId="0eb69649-27cb-4e1f-82d4-22f29aef5571" providerId="ADAL" clId="{72E2DFC3-2130-425E-AF91-2C796C872C89}" dt="2020-10-29T19:31:26.473" v="14" actId="114"/>
          <ac:spMkLst>
            <pc:docMk/>
            <pc:sldMk cId="1247222253" sldId="267"/>
            <ac:spMk id="6" creationId="{00000000-0000-0000-0000-000000000000}"/>
          </ac:spMkLst>
        </pc:spChg>
        <pc:spChg chg="mod">
          <ac:chgData name="Joanna Bury" userId="0eb69649-27cb-4e1f-82d4-22f29aef5571" providerId="ADAL" clId="{72E2DFC3-2130-425E-AF91-2C796C872C89}" dt="2020-10-29T19:31:36.449" v="16" actId="207"/>
          <ac:spMkLst>
            <pc:docMk/>
            <pc:sldMk cId="1247222253" sldId="267"/>
            <ac:spMk id="36" creationId="{00000000-0000-0000-0000-000000000000}"/>
          </ac:spMkLst>
        </pc:spChg>
        <pc:graphicFrameChg chg="modGraphic">
          <ac:chgData name="Joanna Bury" userId="0eb69649-27cb-4e1f-82d4-22f29aef5571" providerId="ADAL" clId="{72E2DFC3-2130-425E-AF91-2C796C872C89}" dt="2020-10-29T19:31:52.850" v="18" actId="6549"/>
          <ac:graphicFrameMkLst>
            <pc:docMk/>
            <pc:sldMk cId="1247222253" sldId="267"/>
            <ac:graphicFrameMk id="5" creationId="{00000000-0000-0000-0000-000000000000}"/>
          </ac:graphicFrameMkLst>
        </pc:graphicFrameChg>
      </pc:sldChg>
    </pc:docChg>
  </pc:docChgLst>
</pc:chgInfo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F:\R2\Fig3&#12289;1230&#8594;21022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6421186585411577E-2"/>
          <c:y val="2.4674414361680642E-2"/>
          <c:w val="0.88247690575269955"/>
          <c:h val="0.79620807159113727"/>
        </c:manualLayout>
      </c:layout>
      <c:scatterChart>
        <c:scatterStyle val="lineMarker"/>
        <c:varyColors val="0"/>
        <c:ser>
          <c:idx val="0"/>
          <c:order val="0"/>
          <c:tx>
            <c:strRef>
              <c:f>Sheet3!$B$905</c:f>
              <c:strCache>
                <c:ptCount val="1"/>
                <c:pt idx="0">
                  <c:v>MELD score &lt;7</c:v>
                </c:pt>
              </c:strCache>
            </c:strRef>
          </c:tx>
          <c:spPr>
            <a:ln w="28575">
              <a:solidFill>
                <a:schemeClr val="tx1"/>
              </a:solidFill>
              <a:prstDash val="solid"/>
            </a:ln>
          </c:spPr>
          <c:marker>
            <c:symbol val="none"/>
          </c:marker>
          <c:xVal>
            <c:numRef>
              <c:f>Sheet3!$A$906:$A$1576</c:f>
              <c:numCache>
                <c:formatCode>General</c:formatCode>
                <c:ptCount val="671"/>
                <c:pt idx="0">
                  <c:v>0</c:v>
                </c:pt>
                <c:pt idx="1">
                  <c:v>6</c:v>
                </c:pt>
                <c:pt idx="2">
                  <c:v>6</c:v>
                </c:pt>
                <c:pt idx="3">
                  <c:v>22</c:v>
                </c:pt>
                <c:pt idx="4">
                  <c:v>23</c:v>
                </c:pt>
                <c:pt idx="5">
                  <c:v>23</c:v>
                </c:pt>
                <c:pt idx="6">
                  <c:v>25</c:v>
                </c:pt>
                <c:pt idx="7">
                  <c:v>25</c:v>
                </c:pt>
                <c:pt idx="8">
                  <c:v>26</c:v>
                </c:pt>
                <c:pt idx="9">
                  <c:v>26</c:v>
                </c:pt>
                <c:pt idx="10">
                  <c:v>29</c:v>
                </c:pt>
                <c:pt idx="11">
                  <c:v>29</c:v>
                </c:pt>
                <c:pt idx="12">
                  <c:v>30</c:v>
                </c:pt>
                <c:pt idx="13">
                  <c:v>31</c:v>
                </c:pt>
                <c:pt idx="14">
                  <c:v>31</c:v>
                </c:pt>
                <c:pt idx="15">
                  <c:v>33</c:v>
                </c:pt>
                <c:pt idx="16">
                  <c:v>33</c:v>
                </c:pt>
                <c:pt idx="17">
                  <c:v>34</c:v>
                </c:pt>
                <c:pt idx="18">
                  <c:v>34</c:v>
                </c:pt>
                <c:pt idx="19">
                  <c:v>35</c:v>
                </c:pt>
                <c:pt idx="20">
                  <c:v>35</c:v>
                </c:pt>
                <c:pt idx="21">
                  <c:v>37</c:v>
                </c:pt>
                <c:pt idx="22">
                  <c:v>37</c:v>
                </c:pt>
                <c:pt idx="23">
                  <c:v>39</c:v>
                </c:pt>
                <c:pt idx="24">
                  <c:v>39</c:v>
                </c:pt>
                <c:pt idx="25">
                  <c:v>41</c:v>
                </c:pt>
                <c:pt idx="26">
                  <c:v>41</c:v>
                </c:pt>
                <c:pt idx="27">
                  <c:v>42</c:v>
                </c:pt>
                <c:pt idx="28">
                  <c:v>42</c:v>
                </c:pt>
                <c:pt idx="29">
                  <c:v>44</c:v>
                </c:pt>
                <c:pt idx="30">
                  <c:v>44</c:v>
                </c:pt>
                <c:pt idx="31">
                  <c:v>46</c:v>
                </c:pt>
                <c:pt idx="32">
                  <c:v>48</c:v>
                </c:pt>
                <c:pt idx="33">
                  <c:v>48</c:v>
                </c:pt>
                <c:pt idx="34">
                  <c:v>51</c:v>
                </c:pt>
                <c:pt idx="35">
                  <c:v>52</c:v>
                </c:pt>
                <c:pt idx="36">
                  <c:v>52</c:v>
                </c:pt>
                <c:pt idx="37">
                  <c:v>56</c:v>
                </c:pt>
                <c:pt idx="38">
                  <c:v>56</c:v>
                </c:pt>
                <c:pt idx="39">
                  <c:v>58</c:v>
                </c:pt>
                <c:pt idx="40">
                  <c:v>58</c:v>
                </c:pt>
                <c:pt idx="41">
                  <c:v>59</c:v>
                </c:pt>
                <c:pt idx="42">
                  <c:v>59</c:v>
                </c:pt>
                <c:pt idx="43">
                  <c:v>62</c:v>
                </c:pt>
                <c:pt idx="44">
                  <c:v>62</c:v>
                </c:pt>
                <c:pt idx="45">
                  <c:v>66</c:v>
                </c:pt>
                <c:pt idx="46">
                  <c:v>66</c:v>
                </c:pt>
                <c:pt idx="47">
                  <c:v>72</c:v>
                </c:pt>
                <c:pt idx="48">
                  <c:v>72</c:v>
                </c:pt>
                <c:pt idx="49">
                  <c:v>75</c:v>
                </c:pt>
                <c:pt idx="50">
                  <c:v>75</c:v>
                </c:pt>
                <c:pt idx="51">
                  <c:v>76</c:v>
                </c:pt>
                <c:pt idx="52">
                  <c:v>76</c:v>
                </c:pt>
                <c:pt idx="53">
                  <c:v>78</c:v>
                </c:pt>
                <c:pt idx="54">
                  <c:v>78</c:v>
                </c:pt>
                <c:pt idx="55">
                  <c:v>79</c:v>
                </c:pt>
                <c:pt idx="56">
                  <c:v>79</c:v>
                </c:pt>
                <c:pt idx="57">
                  <c:v>80</c:v>
                </c:pt>
                <c:pt idx="58">
                  <c:v>80</c:v>
                </c:pt>
                <c:pt idx="59">
                  <c:v>83</c:v>
                </c:pt>
                <c:pt idx="60">
                  <c:v>83</c:v>
                </c:pt>
                <c:pt idx="61">
                  <c:v>85</c:v>
                </c:pt>
                <c:pt idx="62">
                  <c:v>85</c:v>
                </c:pt>
                <c:pt idx="63">
                  <c:v>89</c:v>
                </c:pt>
                <c:pt idx="64">
                  <c:v>89</c:v>
                </c:pt>
                <c:pt idx="65">
                  <c:v>90</c:v>
                </c:pt>
                <c:pt idx="66">
                  <c:v>90</c:v>
                </c:pt>
                <c:pt idx="67">
                  <c:v>92</c:v>
                </c:pt>
                <c:pt idx="68">
                  <c:v>92</c:v>
                </c:pt>
                <c:pt idx="69">
                  <c:v>97</c:v>
                </c:pt>
                <c:pt idx="70">
                  <c:v>98</c:v>
                </c:pt>
                <c:pt idx="71">
                  <c:v>98</c:v>
                </c:pt>
                <c:pt idx="72">
                  <c:v>100</c:v>
                </c:pt>
                <c:pt idx="73">
                  <c:v>100</c:v>
                </c:pt>
                <c:pt idx="74">
                  <c:v>101</c:v>
                </c:pt>
                <c:pt idx="75">
                  <c:v>101</c:v>
                </c:pt>
                <c:pt idx="76">
                  <c:v>105</c:v>
                </c:pt>
                <c:pt idx="77">
                  <c:v>105</c:v>
                </c:pt>
                <c:pt idx="78">
                  <c:v>106</c:v>
                </c:pt>
                <c:pt idx="79">
                  <c:v>106</c:v>
                </c:pt>
                <c:pt idx="80">
                  <c:v>111</c:v>
                </c:pt>
                <c:pt idx="81">
                  <c:v>111</c:v>
                </c:pt>
                <c:pt idx="82">
                  <c:v>112</c:v>
                </c:pt>
                <c:pt idx="83">
                  <c:v>112</c:v>
                </c:pt>
                <c:pt idx="84">
                  <c:v>114</c:v>
                </c:pt>
                <c:pt idx="85">
                  <c:v>114</c:v>
                </c:pt>
                <c:pt idx="86">
                  <c:v>117</c:v>
                </c:pt>
                <c:pt idx="87">
                  <c:v>117</c:v>
                </c:pt>
                <c:pt idx="88">
                  <c:v>122</c:v>
                </c:pt>
                <c:pt idx="89">
                  <c:v>122</c:v>
                </c:pt>
                <c:pt idx="90">
                  <c:v>125</c:v>
                </c:pt>
                <c:pt idx="91">
                  <c:v>125</c:v>
                </c:pt>
                <c:pt idx="92">
                  <c:v>138</c:v>
                </c:pt>
                <c:pt idx="93">
                  <c:v>138</c:v>
                </c:pt>
                <c:pt idx="94">
                  <c:v>142</c:v>
                </c:pt>
                <c:pt idx="95">
                  <c:v>142</c:v>
                </c:pt>
                <c:pt idx="96">
                  <c:v>143</c:v>
                </c:pt>
                <c:pt idx="97">
                  <c:v>143</c:v>
                </c:pt>
                <c:pt idx="98">
                  <c:v>147</c:v>
                </c:pt>
                <c:pt idx="99">
                  <c:v>147</c:v>
                </c:pt>
                <c:pt idx="100">
                  <c:v>149</c:v>
                </c:pt>
                <c:pt idx="101">
                  <c:v>149</c:v>
                </c:pt>
                <c:pt idx="102">
                  <c:v>150</c:v>
                </c:pt>
                <c:pt idx="103">
                  <c:v>150</c:v>
                </c:pt>
                <c:pt idx="104">
                  <c:v>154</c:v>
                </c:pt>
                <c:pt idx="105">
                  <c:v>154</c:v>
                </c:pt>
                <c:pt idx="106">
                  <c:v>155</c:v>
                </c:pt>
                <c:pt idx="107">
                  <c:v>155</c:v>
                </c:pt>
                <c:pt idx="108">
                  <c:v>157</c:v>
                </c:pt>
                <c:pt idx="109">
                  <c:v>157</c:v>
                </c:pt>
                <c:pt idx="110">
                  <c:v>162</c:v>
                </c:pt>
                <c:pt idx="111">
                  <c:v>163</c:v>
                </c:pt>
                <c:pt idx="112">
                  <c:v>163</c:v>
                </c:pt>
                <c:pt idx="113">
                  <c:v>165</c:v>
                </c:pt>
                <c:pt idx="114">
                  <c:v>165</c:v>
                </c:pt>
                <c:pt idx="115">
                  <c:v>167</c:v>
                </c:pt>
                <c:pt idx="116">
                  <c:v>167</c:v>
                </c:pt>
                <c:pt idx="117">
                  <c:v>169</c:v>
                </c:pt>
                <c:pt idx="118">
                  <c:v>172</c:v>
                </c:pt>
                <c:pt idx="119">
                  <c:v>172</c:v>
                </c:pt>
                <c:pt idx="120">
                  <c:v>181</c:v>
                </c:pt>
                <c:pt idx="121">
                  <c:v>182</c:v>
                </c:pt>
                <c:pt idx="122">
                  <c:v>182</c:v>
                </c:pt>
                <c:pt idx="123">
                  <c:v>184</c:v>
                </c:pt>
                <c:pt idx="124">
                  <c:v>184</c:v>
                </c:pt>
                <c:pt idx="125">
                  <c:v>186</c:v>
                </c:pt>
                <c:pt idx="126">
                  <c:v>186</c:v>
                </c:pt>
                <c:pt idx="127">
                  <c:v>188</c:v>
                </c:pt>
                <c:pt idx="128">
                  <c:v>188</c:v>
                </c:pt>
                <c:pt idx="129">
                  <c:v>193</c:v>
                </c:pt>
                <c:pt idx="130">
                  <c:v>193</c:v>
                </c:pt>
                <c:pt idx="131">
                  <c:v>195</c:v>
                </c:pt>
                <c:pt idx="132">
                  <c:v>195</c:v>
                </c:pt>
                <c:pt idx="133">
                  <c:v>200</c:v>
                </c:pt>
                <c:pt idx="134">
                  <c:v>200</c:v>
                </c:pt>
                <c:pt idx="135">
                  <c:v>201</c:v>
                </c:pt>
                <c:pt idx="136">
                  <c:v>201</c:v>
                </c:pt>
                <c:pt idx="137">
                  <c:v>202</c:v>
                </c:pt>
                <c:pt idx="138">
                  <c:v>208</c:v>
                </c:pt>
                <c:pt idx="139">
                  <c:v>208</c:v>
                </c:pt>
                <c:pt idx="140">
                  <c:v>212</c:v>
                </c:pt>
                <c:pt idx="141">
                  <c:v>212</c:v>
                </c:pt>
                <c:pt idx="142">
                  <c:v>229</c:v>
                </c:pt>
                <c:pt idx="143">
                  <c:v>229</c:v>
                </c:pt>
                <c:pt idx="144">
                  <c:v>230</c:v>
                </c:pt>
                <c:pt idx="145">
                  <c:v>230</c:v>
                </c:pt>
                <c:pt idx="146">
                  <c:v>236</c:v>
                </c:pt>
                <c:pt idx="147">
                  <c:v>236</c:v>
                </c:pt>
                <c:pt idx="148">
                  <c:v>239</c:v>
                </c:pt>
                <c:pt idx="149">
                  <c:v>240</c:v>
                </c:pt>
                <c:pt idx="150">
                  <c:v>245</c:v>
                </c:pt>
                <c:pt idx="151">
                  <c:v>245</c:v>
                </c:pt>
                <c:pt idx="152">
                  <c:v>259</c:v>
                </c:pt>
                <c:pt idx="153">
                  <c:v>259</c:v>
                </c:pt>
                <c:pt idx="154">
                  <c:v>268</c:v>
                </c:pt>
                <c:pt idx="155">
                  <c:v>268</c:v>
                </c:pt>
                <c:pt idx="156">
                  <c:v>270</c:v>
                </c:pt>
                <c:pt idx="157">
                  <c:v>270</c:v>
                </c:pt>
                <c:pt idx="158">
                  <c:v>275</c:v>
                </c:pt>
                <c:pt idx="159">
                  <c:v>280</c:v>
                </c:pt>
                <c:pt idx="160">
                  <c:v>280</c:v>
                </c:pt>
                <c:pt idx="161">
                  <c:v>284</c:v>
                </c:pt>
                <c:pt idx="162">
                  <c:v>284</c:v>
                </c:pt>
                <c:pt idx="163">
                  <c:v>285</c:v>
                </c:pt>
                <c:pt idx="164">
                  <c:v>285</c:v>
                </c:pt>
                <c:pt idx="165">
                  <c:v>287</c:v>
                </c:pt>
                <c:pt idx="166">
                  <c:v>287</c:v>
                </c:pt>
                <c:pt idx="167">
                  <c:v>308</c:v>
                </c:pt>
                <c:pt idx="168">
                  <c:v>308</c:v>
                </c:pt>
                <c:pt idx="169">
                  <c:v>311</c:v>
                </c:pt>
                <c:pt idx="170">
                  <c:v>311</c:v>
                </c:pt>
                <c:pt idx="171">
                  <c:v>312</c:v>
                </c:pt>
                <c:pt idx="172">
                  <c:v>312</c:v>
                </c:pt>
                <c:pt idx="173">
                  <c:v>314</c:v>
                </c:pt>
                <c:pt idx="174">
                  <c:v>317</c:v>
                </c:pt>
                <c:pt idx="175">
                  <c:v>317</c:v>
                </c:pt>
                <c:pt idx="176">
                  <c:v>318</c:v>
                </c:pt>
                <c:pt idx="177">
                  <c:v>318</c:v>
                </c:pt>
                <c:pt idx="178">
                  <c:v>322</c:v>
                </c:pt>
                <c:pt idx="179">
                  <c:v>322</c:v>
                </c:pt>
                <c:pt idx="180">
                  <c:v>337</c:v>
                </c:pt>
                <c:pt idx="181">
                  <c:v>343</c:v>
                </c:pt>
                <c:pt idx="182">
                  <c:v>343</c:v>
                </c:pt>
                <c:pt idx="183">
                  <c:v>345</c:v>
                </c:pt>
                <c:pt idx="184">
                  <c:v>345</c:v>
                </c:pt>
                <c:pt idx="185">
                  <c:v>346</c:v>
                </c:pt>
                <c:pt idx="186">
                  <c:v>346</c:v>
                </c:pt>
                <c:pt idx="187">
                  <c:v>350</c:v>
                </c:pt>
                <c:pt idx="188">
                  <c:v>350</c:v>
                </c:pt>
                <c:pt idx="189">
                  <c:v>353</c:v>
                </c:pt>
                <c:pt idx="190">
                  <c:v>353</c:v>
                </c:pt>
                <c:pt idx="191">
                  <c:v>354</c:v>
                </c:pt>
                <c:pt idx="192">
                  <c:v>354</c:v>
                </c:pt>
                <c:pt idx="193">
                  <c:v>360</c:v>
                </c:pt>
                <c:pt idx="194">
                  <c:v>360</c:v>
                </c:pt>
                <c:pt idx="195">
                  <c:v>363</c:v>
                </c:pt>
                <c:pt idx="196">
                  <c:v>366</c:v>
                </c:pt>
                <c:pt idx="197">
                  <c:v>366</c:v>
                </c:pt>
                <c:pt idx="198">
                  <c:v>370</c:v>
                </c:pt>
                <c:pt idx="199">
                  <c:v>370</c:v>
                </c:pt>
                <c:pt idx="200">
                  <c:v>380</c:v>
                </c:pt>
                <c:pt idx="201">
                  <c:v>380</c:v>
                </c:pt>
                <c:pt idx="202">
                  <c:v>382</c:v>
                </c:pt>
                <c:pt idx="203">
                  <c:v>382</c:v>
                </c:pt>
                <c:pt idx="204">
                  <c:v>400</c:v>
                </c:pt>
                <c:pt idx="205">
                  <c:v>400</c:v>
                </c:pt>
                <c:pt idx="206">
                  <c:v>405</c:v>
                </c:pt>
                <c:pt idx="207">
                  <c:v>405</c:v>
                </c:pt>
                <c:pt idx="208">
                  <c:v>409</c:v>
                </c:pt>
                <c:pt idx="209">
                  <c:v>409</c:v>
                </c:pt>
                <c:pt idx="210">
                  <c:v>413</c:v>
                </c:pt>
                <c:pt idx="211">
                  <c:v>415</c:v>
                </c:pt>
                <c:pt idx="212">
                  <c:v>415</c:v>
                </c:pt>
                <c:pt idx="213">
                  <c:v>419</c:v>
                </c:pt>
                <c:pt idx="214">
                  <c:v>425</c:v>
                </c:pt>
                <c:pt idx="215">
                  <c:v>425</c:v>
                </c:pt>
                <c:pt idx="216">
                  <c:v>429</c:v>
                </c:pt>
                <c:pt idx="217">
                  <c:v>433</c:v>
                </c:pt>
                <c:pt idx="218">
                  <c:v>433</c:v>
                </c:pt>
                <c:pt idx="219">
                  <c:v>438</c:v>
                </c:pt>
                <c:pt idx="220">
                  <c:v>438</c:v>
                </c:pt>
                <c:pt idx="221">
                  <c:v>439</c:v>
                </c:pt>
                <c:pt idx="222">
                  <c:v>456</c:v>
                </c:pt>
                <c:pt idx="223">
                  <c:v>456</c:v>
                </c:pt>
                <c:pt idx="224">
                  <c:v>472</c:v>
                </c:pt>
                <c:pt idx="225">
                  <c:v>472</c:v>
                </c:pt>
                <c:pt idx="226">
                  <c:v>476</c:v>
                </c:pt>
                <c:pt idx="227">
                  <c:v>478</c:v>
                </c:pt>
                <c:pt idx="228">
                  <c:v>483</c:v>
                </c:pt>
                <c:pt idx="229">
                  <c:v>489</c:v>
                </c:pt>
                <c:pt idx="230">
                  <c:v>490</c:v>
                </c:pt>
                <c:pt idx="231">
                  <c:v>490</c:v>
                </c:pt>
                <c:pt idx="232">
                  <c:v>499</c:v>
                </c:pt>
                <c:pt idx="233">
                  <c:v>499</c:v>
                </c:pt>
                <c:pt idx="234">
                  <c:v>503</c:v>
                </c:pt>
                <c:pt idx="235">
                  <c:v>509</c:v>
                </c:pt>
                <c:pt idx="236">
                  <c:v>509</c:v>
                </c:pt>
                <c:pt idx="237">
                  <c:v>512</c:v>
                </c:pt>
                <c:pt idx="238">
                  <c:v>518</c:v>
                </c:pt>
                <c:pt idx="239">
                  <c:v>521</c:v>
                </c:pt>
                <c:pt idx="240">
                  <c:v>521</c:v>
                </c:pt>
                <c:pt idx="241">
                  <c:v>522</c:v>
                </c:pt>
                <c:pt idx="242">
                  <c:v>522</c:v>
                </c:pt>
                <c:pt idx="243">
                  <c:v>527</c:v>
                </c:pt>
                <c:pt idx="244">
                  <c:v>527</c:v>
                </c:pt>
                <c:pt idx="245">
                  <c:v>534</c:v>
                </c:pt>
                <c:pt idx="246">
                  <c:v>534</c:v>
                </c:pt>
                <c:pt idx="247">
                  <c:v>541</c:v>
                </c:pt>
                <c:pt idx="248">
                  <c:v>553</c:v>
                </c:pt>
                <c:pt idx="249">
                  <c:v>553</c:v>
                </c:pt>
                <c:pt idx="250">
                  <c:v>556</c:v>
                </c:pt>
                <c:pt idx="251">
                  <c:v>556</c:v>
                </c:pt>
                <c:pt idx="252">
                  <c:v>577</c:v>
                </c:pt>
                <c:pt idx="253">
                  <c:v>577</c:v>
                </c:pt>
                <c:pt idx="254">
                  <c:v>578</c:v>
                </c:pt>
                <c:pt idx="255">
                  <c:v>578</c:v>
                </c:pt>
                <c:pt idx="256">
                  <c:v>600</c:v>
                </c:pt>
                <c:pt idx="257">
                  <c:v>600</c:v>
                </c:pt>
                <c:pt idx="258">
                  <c:v>608</c:v>
                </c:pt>
                <c:pt idx="259">
                  <c:v>608</c:v>
                </c:pt>
                <c:pt idx="260">
                  <c:v>609</c:v>
                </c:pt>
                <c:pt idx="261">
                  <c:v>609</c:v>
                </c:pt>
                <c:pt idx="262">
                  <c:v>610</c:v>
                </c:pt>
                <c:pt idx="263">
                  <c:v>610</c:v>
                </c:pt>
                <c:pt idx="264">
                  <c:v>612</c:v>
                </c:pt>
                <c:pt idx="265">
                  <c:v>612</c:v>
                </c:pt>
                <c:pt idx="266">
                  <c:v>613</c:v>
                </c:pt>
                <c:pt idx="267">
                  <c:v>613</c:v>
                </c:pt>
                <c:pt idx="268">
                  <c:v>616</c:v>
                </c:pt>
                <c:pt idx="269">
                  <c:v>616</c:v>
                </c:pt>
                <c:pt idx="270">
                  <c:v>618</c:v>
                </c:pt>
                <c:pt idx="271">
                  <c:v>618</c:v>
                </c:pt>
                <c:pt idx="272">
                  <c:v>622</c:v>
                </c:pt>
                <c:pt idx="273">
                  <c:v>622</c:v>
                </c:pt>
                <c:pt idx="274">
                  <c:v>623</c:v>
                </c:pt>
                <c:pt idx="275">
                  <c:v>623</c:v>
                </c:pt>
                <c:pt idx="276">
                  <c:v>628</c:v>
                </c:pt>
                <c:pt idx="277">
                  <c:v>629</c:v>
                </c:pt>
                <c:pt idx="278">
                  <c:v>632</c:v>
                </c:pt>
                <c:pt idx="279">
                  <c:v>636</c:v>
                </c:pt>
                <c:pt idx="280">
                  <c:v>636</c:v>
                </c:pt>
                <c:pt idx="281">
                  <c:v>640.70269490740611</c:v>
                </c:pt>
                <c:pt idx="282">
                  <c:v>644</c:v>
                </c:pt>
                <c:pt idx="283">
                  <c:v>644</c:v>
                </c:pt>
                <c:pt idx="284">
                  <c:v>645</c:v>
                </c:pt>
                <c:pt idx="285">
                  <c:v>645</c:v>
                </c:pt>
                <c:pt idx="286">
                  <c:v>650</c:v>
                </c:pt>
                <c:pt idx="287">
                  <c:v>650</c:v>
                </c:pt>
                <c:pt idx="288">
                  <c:v>655</c:v>
                </c:pt>
                <c:pt idx="289">
                  <c:v>655</c:v>
                </c:pt>
                <c:pt idx="290">
                  <c:v>657</c:v>
                </c:pt>
                <c:pt idx="291">
                  <c:v>681</c:v>
                </c:pt>
                <c:pt idx="292">
                  <c:v>693</c:v>
                </c:pt>
                <c:pt idx="293">
                  <c:v>693</c:v>
                </c:pt>
                <c:pt idx="294">
                  <c:v>700</c:v>
                </c:pt>
                <c:pt idx="295">
                  <c:v>700</c:v>
                </c:pt>
                <c:pt idx="296">
                  <c:v>709</c:v>
                </c:pt>
                <c:pt idx="297">
                  <c:v>709</c:v>
                </c:pt>
                <c:pt idx="298">
                  <c:v>710</c:v>
                </c:pt>
                <c:pt idx="299">
                  <c:v>710</c:v>
                </c:pt>
                <c:pt idx="300">
                  <c:v>711</c:v>
                </c:pt>
                <c:pt idx="301">
                  <c:v>711</c:v>
                </c:pt>
                <c:pt idx="302">
                  <c:v>714</c:v>
                </c:pt>
                <c:pt idx="303">
                  <c:v>717</c:v>
                </c:pt>
                <c:pt idx="304">
                  <c:v>719</c:v>
                </c:pt>
                <c:pt idx="305">
                  <c:v>719</c:v>
                </c:pt>
                <c:pt idx="306">
                  <c:v>728</c:v>
                </c:pt>
                <c:pt idx="307">
                  <c:v>728</c:v>
                </c:pt>
                <c:pt idx="308">
                  <c:v>736</c:v>
                </c:pt>
                <c:pt idx="309">
                  <c:v>736</c:v>
                </c:pt>
                <c:pt idx="310">
                  <c:v>739</c:v>
                </c:pt>
                <c:pt idx="311">
                  <c:v>739</c:v>
                </c:pt>
                <c:pt idx="312">
                  <c:v>740</c:v>
                </c:pt>
                <c:pt idx="313">
                  <c:v>740</c:v>
                </c:pt>
                <c:pt idx="314">
                  <c:v>749</c:v>
                </c:pt>
                <c:pt idx="315">
                  <c:v>749</c:v>
                </c:pt>
                <c:pt idx="316">
                  <c:v>758</c:v>
                </c:pt>
                <c:pt idx="317">
                  <c:v>763</c:v>
                </c:pt>
                <c:pt idx="318">
                  <c:v>763</c:v>
                </c:pt>
                <c:pt idx="319">
                  <c:v>772</c:v>
                </c:pt>
                <c:pt idx="320">
                  <c:v>772</c:v>
                </c:pt>
                <c:pt idx="321">
                  <c:v>778.70269490740611</c:v>
                </c:pt>
                <c:pt idx="322">
                  <c:v>783</c:v>
                </c:pt>
                <c:pt idx="323">
                  <c:v>784</c:v>
                </c:pt>
                <c:pt idx="324">
                  <c:v>786</c:v>
                </c:pt>
                <c:pt idx="325">
                  <c:v>786</c:v>
                </c:pt>
                <c:pt idx="326">
                  <c:v>794</c:v>
                </c:pt>
                <c:pt idx="327">
                  <c:v>794</c:v>
                </c:pt>
                <c:pt idx="328">
                  <c:v>795</c:v>
                </c:pt>
                <c:pt idx="329">
                  <c:v>795</c:v>
                </c:pt>
                <c:pt idx="330">
                  <c:v>803</c:v>
                </c:pt>
                <c:pt idx="331">
                  <c:v>803</c:v>
                </c:pt>
                <c:pt idx="332">
                  <c:v>808</c:v>
                </c:pt>
                <c:pt idx="333">
                  <c:v>808</c:v>
                </c:pt>
                <c:pt idx="334">
                  <c:v>817</c:v>
                </c:pt>
                <c:pt idx="335">
                  <c:v>817</c:v>
                </c:pt>
                <c:pt idx="336">
                  <c:v>820</c:v>
                </c:pt>
                <c:pt idx="337">
                  <c:v>820</c:v>
                </c:pt>
                <c:pt idx="338">
                  <c:v>822</c:v>
                </c:pt>
                <c:pt idx="339">
                  <c:v>822</c:v>
                </c:pt>
                <c:pt idx="340">
                  <c:v>837</c:v>
                </c:pt>
                <c:pt idx="341">
                  <c:v>848</c:v>
                </c:pt>
                <c:pt idx="342">
                  <c:v>848</c:v>
                </c:pt>
                <c:pt idx="343">
                  <c:v>875</c:v>
                </c:pt>
                <c:pt idx="344">
                  <c:v>875</c:v>
                </c:pt>
                <c:pt idx="345">
                  <c:v>877</c:v>
                </c:pt>
                <c:pt idx="346">
                  <c:v>877</c:v>
                </c:pt>
                <c:pt idx="347">
                  <c:v>878</c:v>
                </c:pt>
                <c:pt idx="348">
                  <c:v>878</c:v>
                </c:pt>
                <c:pt idx="349">
                  <c:v>881</c:v>
                </c:pt>
                <c:pt idx="350">
                  <c:v>881</c:v>
                </c:pt>
                <c:pt idx="351">
                  <c:v>882</c:v>
                </c:pt>
                <c:pt idx="352">
                  <c:v>882</c:v>
                </c:pt>
                <c:pt idx="353">
                  <c:v>887</c:v>
                </c:pt>
                <c:pt idx="354">
                  <c:v>887</c:v>
                </c:pt>
                <c:pt idx="355">
                  <c:v>888</c:v>
                </c:pt>
                <c:pt idx="356">
                  <c:v>888</c:v>
                </c:pt>
                <c:pt idx="357">
                  <c:v>897</c:v>
                </c:pt>
                <c:pt idx="358">
                  <c:v>897</c:v>
                </c:pt>
                <c:pt idx="359">
                  <c:v>906</c:v>
                </c:pt>
                <c:pt idx="360">
                  <c:v>906</c:v>
                </c:pt>
                <c:pt idx="361">
                  <c:v>913</c:v>
                </c:pt>
                <c:pt idx="362">
                  <c:v>913</c:v>
                </c:pt>
                <c:pt idx="363">
                  <c:v>932</c:v>
                </c:pt>
                <c:pt idx="364">
                  <c:v>942</c:v>
                </c:pt>
                <c:pt idx="365">
                  <c:v>942</c:v>
                </c:pt>
                <c:pt idx="366">
                  <c:v>952</c:v>
                </c:pt>
                <c:pt idx="367">
                  <c:v>952</c:v>
                </c:pt>
                <c:pt idx="368">
                  <c:v>957</c:v>
                </c:pt>
                <c:pt idx="369">
                  <c:v>957</c:v>
                </c:pt>
                <c:pt idx="370">
                  <c:v>958</c:v>
                </c:pt>
                <c:pt idx="371">
                  <c:v>958</c:v>
                </c:pt>
                <c:pt idx="372">
                  <c:v>960</c:v>
                </c:pt>
                <c:pt idx="373">
                  <c:v>960</c:v>
                </c:pt>
                <c:pt idx="374">
                  <c:v>963</c:v>
                </c:pt>
                <c:pt idx="375">
                  <c:v>963</c:v>
                </c:pt>
                <c:pt idx="376">
                  <c:v>965</c:v>
                </c:pt>
                <c:pt idx="377">
                  <c:v>965</c:v>
                </c:pt>
                <c:pt idx="378">
                  <c:v>978</c:v>
                </c:pt>
                <c:pt idx="379">
                  <c:v>978</c:v>
                </c:pt>
                <c:pt idx="380">
                  <c:v>980</c:v>
                </c:pt>
                <c:pt idx="381">
                  <c:v>980</c:v>
                </c:pt>
                <c:pt idx="382">
                  <c:v>985</c:v>
                </c:pt>
                <c:pt idx="383">
                  <c:v>985</c:v>
                </c:pt>
                <c:pt idx="384">
                  <c:v>997</c:v>
                </c:pt>
                <c:pt idx="385">
                  <c:v>997</c:v>
                </c:pt>
                <c:pt idx="386">
                  <c:v>1008</c:v>
                </c:pt>
                <c:pt idx="387">
                  <c:v>1008</c:v>
                </c:pt>
                <c:pt idx="388">
                  <c:v>1020</c:v>
                </c:pt>
                <c:pt idx="389">
                  <c:v>1020</c:v>
                </c:pt>
                <c:pt idx="390">
                  <c:v>1024</c:v>
                </c:pt>
                <c:pt idx="391">
                  <c:v>1024</c:v>
                </c:pt>
                <c:pt idx="392">
                  <c:v>1055</c:v>
                </c:pt>
                <c:pt idx="393">
                  <c:v>1055</c:v>
                </c:pt>
                <c:pt idx="394">
                  <c:v>1062</c:v>
                </c:pt>
                <c:pt idx="395">
                  <c:v>1062</c:v>
                </c:pt>
                <c:pt idx="396">
                  <c:v>1086</c:v>
                </c:pt>
                <c:pt idx="397">
                  <c:v>1086</c:v>
                </c:pt>
                <c:pt idx="398">
                  <c:v>1096</c:v>
                </c:pt>
                <c:pt idx="399">
                  <c:v>1096</c:v>
                </c:pt>
                <c:pt idx="400">
                  <c:v>1102</c:v>
                </c:pt>
                <c:pt idx="401">
                  <c:v>1102</c:v>
                </c:pt>
                <c:pt idx="402">
                  <c:v>1103</c:v>
                </c:pt>
                <c:pt idx="403">
                  <c:v>1108</c:v>
                </c:pt>
                <c:pt idx="404">
                  <c:v>1108</c:v>
                </c:pt>
                <c:pt idx="405">
                  <c:v>1149</c:v>
                </c:pt>
                <c:pt idx="406">
                  <c:v>1149</c:v>
                </c:pt>
                <c:pt idx="407">
                  <c:v>1151</c:v>
                </c:pt>
                <c:pt idx="408">
                  <c:v>1151</c:v>
                </c:pt>
                <c:pt idx="409">
                  <c:v>1152</c:v>
                </c:pt>
                <c:pt idx="410">
                  <c:v>1152</c:v>
                </c:pt>
                <c:pt idx="411">
                  <c:v>1161</c:v>
                </c:pt>
                <c:pt idx="412">
                  <c:v>1161</c:v>
                </c:pt>
                <c:pt idx="413">
                  <c:v>1169</c:v>
                </c:pt>
                <c:pt idx="414">
                  <c:v>1169</c:v>
                </c:pt>
                <c:pt idx="415">
                  <c:v>1175</c:v>
                </c:pt>
                <c:pt idx="416">
                  <c:v>1175</c:v>
                </c:pt>
                <c:pt idx="417">
                  <c:v>1183</c:v>
                </c:pt>
                <c:pt idx="418">
                  <c:v>1183</c:v>
                </c:pt>
                <c:pt idx="419">
                  <c:v>1192</c:v>
                </c:pt>
                <c:pt idx="420">
                  <c:v>1192</c:v>
                </c:pt>
                <c:pt idx="421">
                  <c:v>1205.7026949074061</c:v>
                </c:pt>
                <c:pt idx="422">
                  <c:v>1213</c:v>
                </c:pt>
                <c:pt idx="423">
                  <c:v>1213</c:v>
                </c:pt>
                <c:pt idx="424">
                  <c:v>1214</c:v>
                </c:pt>
                <c:pt idx="425">
                  <c:v>1214</c:v>
                </c:pt>
                <c:pt idx="426">
                  <c:v>1216</c:v>
                </c:pt>
                <c:pt idx="427">
                  <c:v>1216</c:v>
                </c:pt>
                <c:pt idx="428">
                  <c:v>1219</c:v>
                </c:pt>
                <c:pt idx="429">
                  <c:v>1219</c:v>
                </c:pt>
                <c:pt idx="430">
                  <c:v>1255</c:v>
                </c:pt>
                <c:pt idx="431">
                  <c:v>1264</c:v>
                </c:pt>
                <c:pt idx="432">
                  <c:v>1264</c:v>
                </c:pt>
                <c:pt idx="433">
                  <c:v>1265</c:v>
                </c:pt>
                <c:pt idx="434">
                  <c:v>1265</c:v>
                </c:pt>
                <c:pt idx="435">
                  <c:v>1275</c:v>
                </c:pt>
                <c:pt idx="436">
                  <c:v>1275</c:v>
                </c:pt>
                <c:pt idx="437">
                  <c:v>1282</c:v>
                </c:pt>
                <c:pt idx="438">
                  <c:v>1282</c:v>
                </c:pt>
                <c:pt idx="439">
                  <c:v>1285</c:v>
                </c:pt>
                <c:pt idx="440">
                  <c:v>1285</c:v>
                </c:pt>
                <c:pt idx="441">
                  <c:v>1302</c:v>
                </c:pt>
                <c:pt idx="442">
                  <c:v>1302</c:v>
                </c:pt>
                <c:pt idx="443">
                  <c:v>1302.7026949074061</c:v>
                </c:pt>
                <c:pt idx="444">
                  <c:v>1322</c:v>
                </c:pt>
                <c:pt idx="445">
                  <c:v>1322</c:v>
                </c:pt>
                <c:pt idx="446">
                  <c:v>1334</c:v>
                </c:pt>
                <c:pt idx="447">
                  <c:v>1334</c:v>
                </c:pt>
                <c:pt idx="448">
                  <c:v>1352</c:v>
                </c:pt>
                <c:pt idx="449">
                  <c:v>1352</c:v>
                </c:pt>
                <c:pt idx="450">
                  <c:v>1359</c:v>
                </c:pt>
                <c:pt idx="451">
                  <c:v>1363</c:v>
                </c:pt>
                <c:pt idx="452">
                  <c:v>1363</c:v>
                </c:pt>
                <c:pt idx="453">
                  <c:v>1377</c:v>
                </c:pt>
                <c:pt idx="454">
                  <c:v>1377</c:v>
                </c:pt>
                <c:pt idx="455">
                  <c:v>1384</c:v>
                </c:pt>
                <c:pt idx="456">
                  <c:v>1384</c:v>
                </c:pt>
                <c:pt idx="457">
                  <c:v>1390</c:v>
                </c:pt>
                <c:pt idx="458">
                  <c:v>1390</c:v>
                </c:pt>
                <c:pt idx="459">
                  <c:v>1414</c:v>
                </c:pt>
                <c:pt idx="460">
                  <c:v>1414</c:v>
                </c:pt>
                <c:pt idx="461">
                  <c:v>1421</c:v>
                </c:pt>
                <c:pt idx="462">
                  <c:v>1421</c:v>
                </c:pt>
                <c:pt idx="463">
                  <c:v>1429</c:v>
                </c:pt>
                <c:pt idx="464">
                  <c:v>1429</c:v>
                </c:pt>
                <c:pt idx="465">
                  <c:v>1433</c:v>
                </c:pt>
                <c:pt idx="466">
                  <c:v>1433</c:v>
                </c:pt>
                <c:pt idx="467">
                  <c:v>1442</c:v>
                </c:pt>
                <c:pt idx="468">
                  <c:v>1442</c:v>
                </c:pt>
                <c:pt idx="469">
                  <c:v>1462</c:v>
                </c:pt>
                <c:pt idx="470">
                  <c:v>1462</c:v>
                </c:pt>
                <c:pt idx="471">
                  <c:v>1471</c:v>
                </c:pt>
                <c:pt idx="472">
                  <c:v>1471</c:v>
                </c:pt>
                <c:pt idx="473">
                  <c:v>1479</c:v>
                </c:pt>
                <c:pt idx="474">
                  <c:v>1479</c:v>
                </c:pt>
                <c:pt idx="475">
                  <c:v>1481</c:v>
                </c:pt>
                <c:pt idx="476">
                  <c:v>1481</c:v>
                </c:pt>
                <c:pt idx="477">
                  <c:v>1484</c:v>
                </c:pt>
                <c:pt idx="478">
                  <c:v>1484</c:v>
                </c:pt>
                <c:pt idx="479">
                  <c:v>1490</c:v>
                </c:pt>
                <c:pt idx="480">
                  <c:v>1491</c:v>
                </c:pt>
                <c:pt idx="481">
                  <c:v>1491</c:v>
                </c:pt>
                <c:pt idx="482">
                  <c:v>1538</c:v>
                </c:pt>
                <c:pt idx="483">
                  <c:v>1538</c:v>
                </c:pt>
                <c:pt idx="484">
                  <c:v>1554</c:v>
                </c:pt>
                <c:pt idx="485">
                  <c:v>1554</c:v>
                </c:pt>
                <c:pt idx="486">
                  <c:v>1558</c:v>
                </c:pt>
                <c:pt idx="487">
                  <c:v>1558</c:v>
                </c:pt>
                <c:pt idx="488">
                  <c:v>1575</c:v>
                </c:pt>
                <c:pt idx="489">
                  <c:v>1575</c:v>
                </c:pt>
                <c:pt idx="490">
                  <c:v>1581</c:v>
                </c:pt>
                <c:pt idx="491">
                  <c:v>1581</c:v>
                </c:pt>
                <c:pt idx="492">
                  <c:v>1584</c:v>
                </c:pt>
                <c:pt idx="493">
                  <c:v>1584</c:v>
                </c:pt>
                <c:pt idx="494">
                  <c:v>1593</c:v>
                </c:pt>
                <c:pt idx="495">
                  <c:v>1593</c:v>
                </c:pt>
                <c:pt idx="496">
                  <c:v>1594</c:v>
                </c:pt>
                <c:pt idx="497">
                  <c:v>1594</c:v>
                </c:pt>
                <c:pt idx="498">
                  <c:v>1607</c:v>
                </c:pt>
                <c:pt idx="499">
                  <c:v>1607</c:v>
                </c:pt>
                <c:pt idx="500">
                  <c:v>1617</c:v>
                </c:pt>
                <c:pt idx="501">
                  <c:v>1617</c:v>
                </c:pt>
                <c:pt idx="502">
                  <c:v>1630</c:v>
                </c:pt>
                <c:pt idx="503">
                  <c:v>1630</c:v>
                </c:pt>
                <c:pt idx="504">
                  <c:v>1638</c:v>
                </c:pt>
                <c:pt idx="505">
                  <c:v>1638</c:v>
                </c:pt>
                <c:pt idx="506">
                  <c:v>1659</c:v>
                </c:pt>
                <c:pt idx="507">
                  <c:v>1659</c:v>
                </c:pt>
                <c:pt idx="508">
                  <c:v>1676</c:v>
                </c:pt>
                <c:pt idx="509">
                  <c:v>1676</c:v>
                </c:pt>
                <c:pt idx="510">
                  <c:v>1692.7026949074061</c:v>
                </c:pt>
                <c:pt idx="511">
                  <c:v>1719</c:v>
                </c:pt>
                <c:pt idx="512">
                  <c:v>1719</c:v>
                </c:pt>
                <c:pt idx="513">
                  <c:v>1726</c:v>
                </c:pt>
                <c:pt idx="514">
                  <c:v>1726</c:v>
                </c:pt>
                <c:pt idx="515">
                  <c:v>1740</c:v>
                </c:pt>
                <c:pt idx="516">
                  <c:v>1783</c:v>
                </c:pt>
                <c:pt idx="517">
                  <c:v>1783</c:v>
                </c:pt>
                <c:pt idx="518">
                  <c:v>1785</c:v>
                </c:pt>
                <c:pt idx="519">
                  <c:v>1785</c:v>
                </c:pt>
                <c:pt idx="520">
                  <c:v>1792</c:v>
                </c:pt>
                <c:pt idx="521">
                  <c:v>1792</c:v>
                </c:pt>
                <c:pt idx="522">
                  <c:v>1826</c:v>
                </c:pt>
                <c:pt idx="523">
                  <c:v>1826</c:v>
                </c:pt>
                <c:pt idx="524">
                  <c:v>1826.7026949074061</c:v>
                </c:pt>
                <c:pt idx="525">
                  <c:v>1827</c:v>
                </c:pt>
                <c:pt idx="526">
                  <c:v>1827</c:v>
                </c:pt>
                <c:pt idx="527">
                  <c:v>1832.7026949074061</c:v>
                </c:pt>
                <c:pt idx="528">
                  <c:v>1835.7026949074061</c:v>
                </c:pt>
                <c:pt idx="529">
                  <c:v>1844</c:v>
                </c:pt>
                <c:pt idx="530">
                  <c:v>1844</c:v>
                </c:pt>
                <c:pt idx="531">
                  <c:v>1852</c:v>
                </c:pt>
                <c:pt idx="532">
                  <c:v>1852</c:v>
                </c:pt>
                <c:pt idx="533">
                  <c:v>1857</c:v>
                </c:pt>
                <c:pt idx="534">
                  <c:v>1857</c:v>
                </c:pt>
                <c:pt idx="535">
                  <c:v>1858</c:v>
                </c:pt>
                <c:pt idx="536">
                  <c:v>1858</c:v>
                </c:pt>
                <c:pt idx="537">
                  <c:v>1860</c:v>
                </c:pt>
                <c:pt idx="538">
                  <c:v>1879</c:v>
                </c:pt>
                <c:pt idx="539">
                  <c:v>1879</c:v>
                </c:pt>
                <c:pt idx="540">
                  <c:v>1887</c:v>
                </c:pt>
                <c:pt idx="541">
                  <c:v>1887</c:v>
                </c:pt>
                <c:pt idx="542">
                  <c:v>1904.7026949074061</c:v>
                </c:pt>
                <c:pt idx="543">
                  <c:v>1926</c:v>
                </c:pt>
                <c:pt idx="544">
                  <c:v>1926</c:v>
                </c:pt>
                <c:pt idx="545">
                  <c:v>1930.7026949074061</c:v>
                </c:pt>
                <c:pt idx="546">
                  <c:v>1940</c:v>
                </c:pt>
                <c:pt idx="547">
                  <c:v>1989.7026949074061</c:v>
                </c:pt>
                <c:pt idx="548">
                  <c:v>1995</c:v>
                </c:pt>
                <c:pt idx="549">
                  <c:v>1995</c:v>
                </c:pt>
                <c:pt idx="550">
                  <c:v>2006</c:v>
                </c:pt>
                <c:pt idx="551">
                  <c:v>2006</c:v>
                </c:pt>
                <c:pt idx="552">
                  <c:v>2016</c:v>
                </c:pt>
                <c:pt idx="553">
                  <c:v>2016</c:v>
                </c:pt>
                <c:pt idx="554">
                  <c:v>2021</c:v>
                </c:pt>
                <c:pt idx="555">
                  <c:v>2021</c:v>
                </c:pt>
                <c:pt idx="556">
                  <c:v>2062</c:v>
                </c:pt>
                <c:pt idx="557">
                  <c:v>2065</c:v>
                </c:pt>
                <c:pt idx="558">
                  <c:v>2065</c:v>
                </c:pt>
                <c:pt idx="559">
                  <c:v>2071.7026949074061</c:v>
                </c:pt>
                <c:pt idx="560">
                  <c:v>2077</c:v>
                </c:pt>
                <c:pt idx="561">
                  <c:v>2077</c:v>
                </c:pt>
                <c:pt idx="562">
                  <c:v>2093.7026949074061</c:v>
                </c:pt>
                <c:pt idx="563">
                  <c:v>2105</c:v>
                </c:pt>
                <c:pt idx="564">
                  <c:v>2105</c:v>
                </c:pt>
                <c:pt idx="565">
                  <c:v>2153</c:v>
                </c:pt>
                <c:pt idx="566">
                  <c:v>2153</c:v>
                </c:pt>
                <c:pt idx="567">
                  <c:v>2188</c:v>
                </c:pt>
                <c:pt idx="568">
                  <c:v>2188</c:v>
                </c:pt>
                <c:pt idx="569">
                  <c:v>2194</c:v>
                </c:pt>
                <c:pt idx="570">
                  <c:v>2224</c:v>
                </c:pt>
                <c:pt idx="571">
                  <c:v>2224</c:v>
                </c:pt>
                <c:pt idx="572">
                  <c:v>2226.7026949074061</c:v>
                </c:pt>
                <c:pt idx="573">
                  <c:v>2259.7026949074061</c:v>
                </c:pt>
                <c:pt idx="574">
                  <c:v>2263</c:v>
                </c:pt>
                <c:pt idx="575">
                  <c:v>2284</c:v>
                </c:pt>
                <c:pt idx="576">
                  <c:v>2284</c:v>
                </c:pt>
                <c:pt idx="577">
                  <c:v>2322</c:v>
                </c:pt>
                <c:pt idx="578">
                  <c:v>2322</c:v>
                </c:pt>
                <c:pt idx="579">
                  <c:v>2342.7026949074061</c:v>
                </c:pt>
                <c:pt idx="580">
                  <c:v>2345</c:v>
                </c:pt>
                <c:pt idx="581">
                  <c:v>2345</c:v>
                </c:pt>
                <c:pt idx="582">
                  <c:v>2348</c:v>
                </c:pt>
                <c:pt idx="583">
                  <c:v>2348</c:v>
                </c:pt>
                <c:pt idx="584">
                  <c:v>2405</c:v>
                </c:pt>
                <c:pt idx="585">
                  <c:v>2405</c:v>
                </c:pt>
                <c:pt idx="586">
                  <c:v>2408</c:v>
                </c:pt>
                <c:pt idx="587">
                  <c:v>2408</c:v>
                </c:pt>
                <c:pt idx="588">
                  <c:v>2476.7026949074061</c:v>
                </c:pt>
                <c:pt idx="589">
                  <c:v>2477</c:v>
                </c:pt>
                <c:pt idx="590">
                  <c:v>2477</c:v>
                </c:pt>
                <c:pt idx="591">
                  <c:v>2491</c:v>
                </c:pt>
                <c:pt idx="592">
                  <c:v>2491</c:v>
                </c:pt>
                <c:pt idx="593">
                  <c:v>2513</c:v>
                </c:pt>
                <c:pt idx="594">
                  <c:v>2513</c:v>
                </c:pt>
                <c:pt idx="595">
                  <c:v>2541</c:v>
                </c:pt>
                <c:pt idx="596">
                  <c:v>2541</c:v>
                </c:pt>
                <c:pt idx="597">
                  <c:v>2569</c:v>
                </c:pt>
                <c:pt idx="598">
                  <c:v>2618.7026949074061</c:v>
                </c:pt>
                <c:pt idx="599">
                  <c:v>2632.7026949074061</c:v>
                </c:pt>
                <c:pt idx="600">
                  <c:v>2644</c:v>
                </c:pt>
                <c:pt idx="601">
                  <c:v>2644</c:v>
                </c:pt>
                <c:pt idx="602">
                  <c:v>2705</c:v>
                </c:pt>
                <c:pt idx="603">
                  <c:v>2705</c:v>
                </c:pt>
                <c:pt idx="604">
                  <c:v>2713</c:v>
                </c:pt>
                <c:pt idx="605">
                  <c:v>2713</c:v>
                </c:pt>
                <c:pt idx="606">
                  <c:v>2729</c:v>
                </c:pt>
                <c:pt idx="607">
                  <c:v>2772</c:v>
                </c:pt>
                <c:pt idx="608">
                  <c:v>2772</c:v>
                </c:pt>
                <c:pt idx="609">
                  <c:v>2800.7026949074061</c:v>
                </c:pt>
                <c:pt idx="610">
                  <c:v>2804</c:v>
                </c:pt>
                <c:pt idx="611">
                  <c:v>2804</c:v>
                </c:pt>
                <c:pt idx="612">
                  <c:v>2815</c:v>
                </c:pt>
                <c:pt idx="613">
                  <c:v>2815</c:v>
                </c:pt>
                <c:pt idx="614">
                  <c:v>2820</c:v>
                </c:pt>
                <c:pt idx="615">
                  <c:v>2820</c:v>
                </c:pt>
                <c:pt idx="616">
                  <c:v>2837</c:v>
                </c:pt>
                <c:pt idx="617">
                  <c:v>2837</c:v>
                </c:pt>
                <c:pt idx="618">
                  <c:v>2884</c:v>
                </c:pt>
                <c:pt idx="619">
                  <c:v>2884</c:v>
                </c:pt>
                <c:pt idx="620">
                  <c:v>2933</c:v>
                </c:pt>
                <c:pt idx="621">
                  <c:v>2933</c:v>
                </c:pt>
                <c:pt idx="622">
                  <c:v>2966.7026949074061</c:v>
                </c:pt>
                <c:pt idx="623">
                  <c:v>2988</c:v>
                </c:pt>
                <c:pt idx="624">
                  <c:v>2988</c:v>
                </c:pt>
                <c:pt idx="625">
                  <c:v>3029</c:v>
                </c:pt>
                <c:pt idx="626">
                  <c:v>3043.7026949074061</c:v>
                </c:pt>
                <c:pt idx="627">
                  <c:v>3101.7026949074061</c:v>
                </c:pt>
                <c:pt idx="628">
                  <c:v>3113</c:v>
                </c:pt>
                <c:pt idx="629">
                  <c:v>3113</c:v>
                </c:pt>
                <c:pt idx="630">
                  <c:v>3161</c:v>
                </c:pt>
                <c:pt idx="631">
                  <c:v>3161</c:v>
                </c:pt>
                <c:pt idx="632">
                  <c:v>3175.7026949074061</c:v>
                </c:pt>
                <c:pt idx="633">
                  <c:v>3175.7026949074061</c:v>
                </c:pt>
                <c:pt idx="634">
                  <c:v>3178.7026949074061</c:v>
                </c:pt>
                <c:pt idx="635">
                  <c:v>3266.7026949074061</c:v>
                </c:pt>
                <c:pt idx="636">
                  <c:v>3276.7026949074061</c:v>
                </c:pt>
                <c:pt idx="637">
                  <c:v>3343</c:v>
                </c:pt>
                <c:pt idx="638">
                  <c:v>3343</c:v>
                </c:pt>
                <c:pt idx="639">
                  <c:v>3360.7026949074061</c:v>
                </c:pt>
                <c:pt idx="640">
                  <c:v>3366.7026949074061</c:v>
                </c:pt>
                <c:pt idx="641">
                  <c:v>3428</c:v>
                </c:pt>
                <c:pt idx="642">
                  <c:v>3428</c:v>
                </c:pt>
                <c:pt idx="643">
                  <c:v>3437.7026949074061</c:v>
                </c:pt>
                <c:pt idx="644">
                  <c:v>3480.7026949074061</c:v>
                </c:pt>
                <c:pt idx="645">
                  <c:v>3541.7026949074061</c:v>
                </c:pt>
                <c:pt idx="646">
                  <c:v>3575.7026949074061</c:v>
                </c:pt>
                <c:pt idx="647">
                  <c:v>3580</c:v>
                </c:pt>
                <c:pt idx="648">
                  <c:v>3580</c:v>
                </c:pt>
                <c:pt idx="649">
                  <c:v>3581.7026949074061</c:v>
                </c:pt>
                <c:pt idx="650">
                  <c:v>3654</c:v>
                </c:pt>
                <c:pt idx="651">
                  <c:v>3747</c:v>
                </c:pt>
                <c:pt idx="652">
                  <c:v>3747</c:v>
                </c:pt>
                <c:pt idx="653">
                  <c:v>3758</c:v>
                </c:pt>
                <c:pt idx="654">
                  <c:v>3758</c:v>
                </c:pt>
                <c:pt idx="655">
                  <c:v>3865.7026949074061</c:v>
                </c:pt>
                <c:pt idx="656">
                  <c:v>3893</c:v>
                </c:pt>
                <c:pt idx="657">
                  <c:v>3893</c:v>
                </c:pt>
                <c:pt idx="658">
                  <c:v>3915</c:v>
                </c:pt>
                <c:pt idx="659">
                  <c:v>3969.7026949074061</c:v>
                </c:pt>
                <c:pt idx="660">
                  <c:v>3975</c:v>
                </c:pt>
                <c:pt idx="661">
                  <c:v>3975</c:v>
                </c:pt>
                <c:pt idx="662">
                  <c:v>3995.7026949074061</c:v>
                </c:pt>
                <c:pt idx="663">
                  <c:v>4253.7026949074061</c:v>
                </c:pt>
                <c:pt idx="664">
                  <c:v>4271.7026949074061</c:v>
                </c:pt>
                <c:pt idx="665">
                  <c:v>4399</c:v>
                </c:pt>
                <c:pt idx="666">
                  <c:v>4399</c:v>
                </c:pt>
                <c:pt idx="667">
                  <c:v>4684.7026949074061</c:v>
                </c:pt>
                <c:pt idx="668">
                  <c:v>4760</c:v>
                </c:pt>
                <c:pt idx="669">
                  <c:v>5109.7026949074061</c:v>
                </c:pt>
                <c:pt idx="670">
                  <c:v>5405.7026949074061</c:v>
                </c:pt>
              </c:numCache>
            </c:numRef>
          </c:xVal>
          <c:yVal>
            <c:numRef>
              <c:f>Sheet3!$B$906:$B$1576</c:f>
              <c:numCache>
                <c:formatCode>General</c:formatCode>
                <c:ptCount val="671"/>
                <c:pt idx="0" formatCode="0.0000">
                  <c:v>1</c:v>
                </c:pt>
                <c:pt idx="1">
                  <c:v>1</c:v>
                </c:pt>
                <c:pt idx="2" formatCode="0.0000">
                  <c:v>0.99763033175355453</c:v>
                </c:pt>
                <c:pt idx="3" formatCode="0.0000">
                  <c:v>0.99763033175355453</c:v>
                </c:pt>
                <c:pt idx="4">
                  <c:v>0.99763033175355453</c:v>
                </c:pt>
                <c:pt idx="5" formatCode="0.0000">
                  <c:v>0.99525502143985556</c:v>
                </c:pt>
                <c:pt idx="6">
                  <c:v>0.99525502143985556</c:v>
                </c:pt>
                <c:pt idx="7" formatCode="0.0000">
                  <c:v>0.99287971112615658</c:v>
                </c:pt>
                <c:pt idx="8">
                  <c:v>0.99287971112615658</c:v>
                </c:pt>
                <c:pt idx="9" formatCode="0.0000">
                  <c:v>0.99050440081245772</c:v>
                </c:pt>
                <c:pt idx="10">
                  <c:v>0.99050440081245772</c:v>
                </c:pt>
                <c:pt idx="11" formatCode="0.0000">
                  <c:v>0.98812909049875874</c:v>
                </c:pt>
                <c:pt idx="12" formatCode="0.0000">
                  <c:v>0.98812909049875874</c:v>
                </c:pt>
                <c:pt idx="13">
                  <c:v>0.98812909049875874</c:v>
                </c:pt>
                <c:pt idx="14" formatCode="0.0000">
                  <c:v>0.98574805654574971</c:v>
                </c:pt>
                <c:pt idx="15">
                  <c:v>0.98574805654574971</c:v>
                </c:pt>
                <c:pt idx="16" formatCode="0.0000">
                  <c:v>0.98336702259274067</c:v>
                </c:pt>
                <c:pt idx="17">
                  <c:v>0.98336702259274067</c:v>
                </c:pt>
                <c:pt idx="18" formatCode="0.0000">
                  <c:v>0.98098598863973163</c:v>
                </c:pt>
                <c:pt idx="19">
                  <c:v>0.98098598863973163</c:v>
                </c:pt>
                <c:pt idx="20" formatCode="0.0000">
                  <c:v>0.97622392073371356</c:v>
                </c:pt>
                <c:pt idx="21">
                  <c:v>0.97622392073371356</c:v>
                </c:pt>
                <c:pt idx="22" formatCode="0.0000">
                  <c:v>0.97146185282769548</c:v>
                </c:pt>
                <c:pt idx="23">
                  <c:v>0.97146185282769548</c:v>
                </c:pt>
                <c:pt idx="24" formatCode="0.0000">
                  <c:v>0.96669978492167741</c:v>
                </c:pt>
                <c:pt idx="25">
                  <c:v>0.96669978492167741</c:v>
                </c:pt>
                <c:pt idx="26" formatCode="0.0000">
                  <c:v>0.96431875096866826</c:v>
                </c:pt>
                <c:pt idx="27">
                  <c:v>0.96431875096866826</c:v>
                </c:pt>
                <c:pt idx="28" formatCode="0.0000">
                  <c:v>0.96193182336726069</c:v>
                </c:pt>
                <c:pt idx="29">
                  <c:v>0.96193182336726069</c:v>
                </c:pt>
                <c:pt idx="30" formatCode="0.0000">
                  <c:v>0.95954489576585311</c:v>
                </c:pt>
                <c:pt idx="31" formatCode="0.0000">
                  <c:v>0.95954489576585311</c:v>
                </c:pt>
                <c:pt idx="32">
                  <c:v>0.95954489576585311</c:v>
                </c:pt>
                <c:pt idx="33" formatCode="0.0000">
                  <c:v>0.95715201572653685</c:v>
                </c:pt>
                <c:pt idx="34" formatCode="0.0000">
                  <c:v>0.95715201572653685</c:v>
                </c:pt>
                <c:pt idx="35">
                  <c:v>0.95715201572653685</c:v>
                </c:pt>
                <c:pt idx="36" formatCode="0.0000">
                  <c:v>0.95475313849413945</c:v>
                </c:pt>
                <c:pt idx="37">
                  <c:v>0.95475313849413945</c:v>
                </c:pt>
                <c:pt idx="38" formatCode="0.0000">
                  <c:v>0.95235426126174216</c:v>
                </c:pt>
                <c:pt idx="39">
                  <c:v>0.95235426126174216</c:v>
                </c:pt>
                <c:pt idx="40" formatCode="0.0000">
                  <c:v>0.94755650679694747</c:v>
                </c:pt>
                <c:pt idx="41">
                  <c:v>0.94755650679694747</c:v>
                </c:pt>
                <c:pt idx="42" formatCode="0.0000">
                  <c:v>0.94515762956455007</c:v>
                </c:pt>
                <c:pt idx="43">
                  <c:v>0.94515762956455007</c:v>
                </c:pt>
                <c:pt idx="44" formatCode="0.0000">
                  <c:v>0.94275875233215278</c:v>
                </c:pt>
                <c:pt idx="45">
                  <c:v>0.94275875233215278</c:v>
                </c:pt>
                <c:pt idx="46" formatCode="0.0000">
                  <c:v>0.93796099786735809</c:v>
                </c:pt>
                <c:pt idx="47">
                  <c:v>0.93796099786735809</c:v>
                </c:pt>
                <c:pt idx="48" formatCode="0.0000">
                  <c:v>0.93556212063496069</c:v>
                </c:pt>
                <c:pt idx="49">
                  <c:v>0.93556212063496069</c:v>
                </c:pt>
                <c:pt idx="50" formatCode="0.0000">
                  <c:v>0.93315707662304559</c:v>
                </c:pt>
                <c:pt idx="51">
                  <c:v>0.93315707662304559</c:v>
                </c:pt>
                <c:pt idx="52" formatCode="0.0000">
                  <c:v>0.93075203261113049</c:v>
                </c:pt>
                <c:pt idx="53">
                  <c:v>0.93075203261113049</c:v>
                </c:pt>
                <c:pt idx="54" formatCode="0.0000">
                  <c:v>0.92834698859921549</c:v>
                </c:pt>
                <c:pt idx="55">
                  <c:v>0.92834698859921549</c:v>
                </c:pt>
                <c:pt idx="56" formatCode="0.0000">
                  <c:v>0.92594194458730039</c:v>
                </c:pt>
                <c:pt idx="57">
                  <c:v>0.92594194458730039</c:v>
                </c:pt>
                <c:pt idx="58" formatCode="0.0000">
                  <c:v>0.92353690057538529</c:v>
                </c:pt>
                <c:pt idx="59">
                  <c:v>0.92353690057538529</c:v>
                </c:pt>
                <c:pt idx="60" formatCode="0.0000">
                  <c:v>0.91872681255155508</c:v>
                </c:pt>
                <c:pt idx="61">
                  <c:v>0.91872681255155508</c:v>
                </c:pt>
                <c:pt idx="62" formatCode="0.0000">
                  <c:v>0.91390409962477526</c:v>
                </c:pt>
                <c:pt idx="63">
                  <c:v>0.91390409962477526</c:v>
                </c:pt>
                <c:pt idx="64" formatCode="0.0000">
                  <c:v>0.90908138669799543</c:v>
                </c:pt>
                <c:pt idx="65">
                  <c:v>0.90908138669799543</c:v>
                </c:pt>
                <c:pt idx="66" formatCode="0.0000">
                  <c:v>0.90667003023460546</c:v>
                </c:pt>
                <c:pt idx="67">
                  <c:v>0.90667003023460546</c:v>
                </c:pt>
                <c:pt idx="68" formatCode="0.0000">
                  <c:v>0.9042586737712156</c:v>
                </c:pt>
                <c:pt idx="69" formatCode="0.0000">
                  <c:v>0.9042586737712156</c:v>
                </c:pt>
                <c:pt idx="70">
                  <c:v>0.9042586737712156</c:v>
                </c:pt>
                <c:pt idx="71" formatCode="0.0000">
                  <c:v>0.90184086983065082</c:v>
                </c:pt>
                <c:pt idx="72">
                  <c:v>0.90184086983065082</c:v>
                </c:pt>
                <c:pt idx="73" formatCode="0.0000">
                  <c:v>0.89942306589008603</c:v>
                </c:pt>
                <c:pt idx="74">
                  <c:v>0.89942306589008603</c:v>
                </c:pt>
                <c:pt idx="75" formatCode="0.0000">
                  <c:v>0.89700526194952124</c:v>
                </c:pt>
                <c:pt idx="76">
                  <c:v>0.89700526194952124</c:v>
                </c:pt>
                <c:pt idx="77" formatCode="0.0000">
                  <c:v>0.89458745800895645</c:v>
                </c:pt>
                <c:pt idx="78">
                  <c:v>0.89458745800895645</c:v>
                </c:pt>
                <c:pt idx="79" formatCode="0.0000">
                  <c:v>0.89216965406839177</c:v>
                </c:pt>
                <c:pt idx="80">
                  <c:v>0.89216965406839177</c:v>
                </c:pt>
                <c:pt idx="81" formatCode="0.0000">
                  <c:v>0.8873340461872623</c:v>
                </c:pt>
                <c:pt idx="82">
                  <c:v>0.8873340461872623</c:v>
                </c:pt>
                <c:pt idx="83" formatCode="0.0000">
                  <c:v>0.88491624224669752</c:v>
                </c:pt>
                <c:pt idx="84">
                  <c:v>0.88491624224669752</c:v>
                </c:pt>
                <c:pt idx="85" formatCode="0.0000">
                  <c:v>0.88249181418574763</c:v>
                </c:pt>
                <c:pt idx="86">
                  <c:v>0.88249181418574763</c:v>
                </c:pt>
                <c:pt idx="87" formatCode="0.0000">
                  <c:v>0.88006738612479773</c:v>
                </c:pt>
                <c:pt idx="88">
                  <c:v>0.88006738612479773</c:v>
                </c:pt>
                <c:pt idx="89" formatCode="0.0000">
                  <c:v>0.87763626074876233</c:v>
                </c:pt>
                <c:pt idx="90">
                  <c:v>0.87763626074876233</c:v>
                </c:pt>
                <c:pt idx="91" formatCode="0.0000">
                  <c:v>0.87520513537272704</c:v>
                </c:pt>
                <c:pt idx="92">
                  <c:v>0.87520513537272704</c:v>
                </c:pt>
                <c:pt idx="93" formatCode="0.0000">
                  <c:v>0.87277400999669175</c:v>
                </c:pt>
                <c:pt idx="94">
                  <c:v>0.87277400999669175</c:v>
                </c:pt>
                <c:pt idx="95" formatCode="0.0000">
                  <c:v>0.86791175924462105</c:v>
                </c:pt>
                <c:pt idx="96">
                  <c:v>0.86791175924462105</c:v>
                </c:pt>
                <c:pt idx="97" formatCode="0.0000">
                  <c:v>0.86548063386858576</c:v>
                </c:pt>
                <c:pt idx="98">
                  <c:v>0.86548063386858576</c:v>
                </c:pt>
                <c:pt idx="99" formatCode="0.0000">
                  <c:v>0.86304950849255047</c:v>
                </c:pt>
                <c:pt idx="100">
                  <c:v>0.86304950849255047</c:v>
                </c:pt>
                <c:pt idx="101" formatCode="0.0000">
                  <c:v>0.86061838311651506</c:v>
                </c:pt>
                <c:pt idx="102">
                  <c:v>0.86061838311651506</c:v>
                </c:pt>
                <c:pt idx="103" formatCode="0.0000">
                  <c:v>0.85818725774047966</c:v>
                </c:pt>
                <c:pt idx="104">
                  <c:v>0.85818725774047966</c:v>
                </c:pt>
                <c:pt idx="105" formatCode="0.0000">
                  <c:v>0.85575613236444426</c:v>
                </c:pt>
                <c:pt idx="106">
                  <c:v>0.85575613236444426</c:v>
                </c:pt>
                <c:pt idx="107" formatCode="0.0000">
                  <c:v>0.85089388161237356</c:v>
                </c:pt>
                <c:pt idx="108">
                  <c:v>0.85089388161237356</c:v>
                </c:pt>
                <c:pt idx="109" formatCode="0.0000">
                  <c:v>0.84846275623633816</c:v>
                </c:pt>
                <c:pt idx="110" formatCode="0.0000">
                  <c:v>0.84846275623633816</c:v>
                </c:pt>
                <c:pt idx="111">
                  <c:v>0.84846275623633816</c:v>
                </c:pt>
                <c:pt idx="112" formatCode="0.0000">
                  <c:v>0.8460246448678429</c:v>
                </c:pt>
                <c:pt idx="113">
                  <c:v>0.8460246448678429</c:v>
                </c:pt>
                <c:pt idx="114" formatCode="0.0000">
                  <c:v>0.84358653349934765</c:v>
                </c:pt>
                <c:pt idx="115">
                  <c:v>0.84358653349934765</c:v>
                </c:pt>
                <c:pt idx="116" formatCode="0.0000">
                  <c:v>0.84114842213085239</c:v>
                </c:pt>
                <c:pt idx="117" formatCode="0.0000">
                  <c:v>0.84114842213085239</c:v>
                </c:pt>
                <c:pt idx="118">
                  <c:v>0.84114842213085239</c:v>
                </c:pt>
                <c:pt idx="119" formatCode="0.0000">
                  <c:v>0.83870322322930924</c:v>
                </c:pt>
                <c:pt idx="120" formatCode="0.0000">
                  <c:v>0.83870322322930924</c:v>
                </c:pt>
                <c:pt idx="121">
                  <c:v>0.83870322322930924</c:v>
                </c:pt>
                <c:pt idx="122" formatCode="0.0000">
                  <c:v>0.83625087462337566</c:v>
                </c:pt>
                <c:pt idx="123">
                  <c:v>0.83625087462337566</c:v>
                </c:pt>
                <c:pt idx="124" formatCode="0.0000">
                  <c:v>0.83379131322742461</c:v>
                </c:pt>
                <c:pt idx="125">
                  <c:v>0.83379131322742461</c:v>
                </c:pt>
                <c:pt idx="126" formatCode="0.0000">
                  <c:v>0.83133175183147345</c:v>
                </c:pt>
                <c:pt idx="127">
                  <c:v>0.83133175183147345</c:v>
                </c:pt>
                <c:pt idx="128" formatCode="0.0000">
                  <c:v>0.82887219043552229</c:v>
                </c:pt>
                <c:pt idx="129">
                  <c:v>0.82887219043552229</c:v>
                </c:pt>
                <c:pt idx="130" formatCode="0.0000">
                  <c:v>0.82640530891636899</c:v>
                </c:pt>
                <c:pt idx="131">
                  <c:v>0.82640530891636899</c:v>
                </c:pt>
                <c:pt idx="132" formatCode="0.0000">
                  <c:v>0.82393842739721557</c:v>
                </c:pt>
                <c:pt idx="133" formatCode="0.0000">
                  <c:v>0.82393842739721557</c:v>
                </c:pt>
                <c:pt idx="134" formatCode="0.0000">
                  <c:v>0.82393842739721557</c:v>
                </c:pt>
                <c:pt idx="135">
                  <c:v>0.82393842739721557</c:v>
                </c:pt>
                <c:pt idx="136" formatCode="0.0000">
                  <c:v>0.82145668514601911</c:v>
                </c:pt>
                <c:pt idx="137" formatCode="0.0000">
                  <c:v>0.82145668514601911</c:v>
                </c:pt>
                <c:pt idx="138">
                  <c:v>0.82145668514601911</c:v>
                </c:pt>
                <c:pt idx="139" formatCode="0.0000">
                  <c:v>0.81647815978149774</c:v>
                </c:pt>
                <c:pt idx="140">
                  <c:v>0.81647815978149774</c:v>
                </c:pt>
                <c:pt idx="141" formatCode="0.0000">
                  <c:v>0.81398889709923705</c:v>
                </c:pt>
                <c:pt idx="142">
                  <c:v>0.81398889709923705</c:v>
                </c:pt>
                <c:pt idx="143" formatCode="0.0000">
                  <c:v>0.80901037173471568</c:v>
                </c:pt>
                <c:pt idx="144">
                  <c:v>0.80901037173471568</c:v>
                </c:pt>
                <c:pt idx="145" formatCode="0.0000">
                  <c:v>0.806521109052455</c:v>
                </c:pt>
                <c:pt idx="146">
                  <c:v>0.806521109052455</c:v>
                </c:pt>
                <c:pt idx="147" formatCode="0.0000">
                  <c:v>0.80403184637019431</c:v>
                </c:pt>
                <c:pt idx="148" formatCode="0.0000">
                  <c:v>0.80403184637019431</c:v>
                </c:pt>
                <c:pt idx="149" formatCode="0.0000">
                  <c:v>0.80403184637019431</c:v>
                </c:pt>
                <c:pt idx="150" formatCode="0.0000">
                  <c:v>0.80403184637019431</c:v>
                </c:pt>
                <c:pt idx="151" formatCode="0.0000">
                  <c:v>0.80403184637019431</c:v>
                </c:pt>
                <c:pt idx="152">
                  <c:v>0.80403184637019431</c:v>
                </c:pt>
                <c:pt idx="153" formatCode="0.0000">
                  <c:v>0.80151137036276421</c:v>
                </c:pt>
                <c:pt idx="154">
                  <c:v>0.80151137036276421</c:v>
                </c:pt>
                <c:pt idx="155" formatCode="0.0000">
                  <c:v>0.7989908943553341</c:v>
                </c:pt>
                <c:pt idx="156">
                  <c:v>0.7989908943553341</c:v>
                </c:pt>
                <c:pt idx="157" formatCode="0.0000">
                  <c:v>0.7964624421580071</c:v>
                </c:pt>
                <c:pt idx="158" formatCode="0.0000">
                  <c:v>0.7964624421580071</c:v>
                </c:pt>
                <c:pt idx="159">
                  <c:v>0.7964624421580071</c:v>
                </c:pt>
                <c:pt idx="160" formatCode="0.0000">
                  <c:v>0.79392593756514718</c:v>
                </c:pt>
                <c:pt idx="161">
                  <c:v>0.79392593756514718</c:v>
                </c:pt>
                <c:pt idx="162" formatCode="0.0000">
                  <c:v>0.78885292837942744</c:v>
                </c:pt>
                <c:pt idx="163">
                  <c:v>0.78885292837942744</c:v>
                </c:pt>
                <c:pt idx="164" formatCode="0.0000">
                  <c:v>0.78631642378656752</c:v>
                </c:pt>
                <c:pt idx="165">
                  <c:v>0.78631642378656752</c:v>
                </c:pt>
                <c:pt idx="166" formatCode="0.0000">
                  <c:v>0.78377991919370771</c:v>
                </c:pt>
                <c:pt idx="167">
                  <c:v>0.78377991919370771</c:v>
                </c:pt>
                <c:pt idx="168" formatCode="0.0000">
                  <c:v>0.7812434146008479</c:v>
                </c:pt>
                <c:pt idx="169">
                  <c:v>0.7812434146008479</c:v>
                </c:pt>
                <c:pt idx="170" formatCode="0.0000">
                  <c:v>0.77869864777804387</c:v>
                </c:pt>
                <c:pt idx="171">
                  <c:v>0.77869864777804387</c:v>
                </c:pt>
                <c:pt idx="172" formatCode="0.0000">
                  <c:v>0.77615388095523985</c:v>
                </c:pt>
                <c:pt idx="173" formatCode="0.0000">
                  <c:v>0.77615388095523985</c:v>
                </c:pt>
                <c:pt idx="174">
                  <c:v>0.77615388095523985</c:v>
                </c:pt>
                <c:pt idx="175" formatCode="0.0000">
                  <c:v>0.77360074318893979</c:v>
                </c:pt>
                <c:pt idx="176">
                  <c:v>0.77360074318893979</c:v>
                </c:pt>
                <c:pt idx="177" formatCode="0.0000">
                  <c:v>0.77104760542263961</c:v>
                </c:pt>
                <c:pt idx="178">
                  <c:v>0.77104760542263961</c:v>
                </c:pt>
                <c:pt idx="179" formatCode="0.0000">
                  <c:v>0.76849446765633944</c:v>
                </c:pt>
                <c:pt idx="180" formatCode="0.0000">
                  <c:v>0.76849446765633944</c:v>
                </c:pt>
                <c:pt idx="181">
                  <c:v>0.76849446765633944</c:v>
                </c:pt>
                <c:pt idx="182" formatCode="0.0000">
                  <c:v>0.76593281943081837</c:v>
                </c:pt>
                <c:pt idx="183">
                  <c:v>0.76593281943081837</c:v>
                </c:pt>
                <c:pt idx="184" formatCode="0.0000">
                  <c:v>0.76337117120529718</c:v>
                </c:pt>
                <c:pt idx="185">
                  <c:v>0.76337117120529718</c:v>
                </c:pt>
                <c:pt idx="186" formatCode="0.0000">
                  <c:v>0.760809522979776</c:v>
                </c:pt>
                <c:pt idx="187">
                  <c:v>0.760809522979776</c:v>
                </c:pt>
                <c:pt idx="188" formatCode="0.0000">
                  <c:v>0.75824787475425492</c:v>
                </c:pt>
                <c:pt idx="189">
                  <c:v>0.75824787475425492</c:v>
                </c:pt>
                <c:pt idx="190" formatCode="0.0000">
                  <c:v>0.75568622652873374</c:v>
                </c:pt>
                <c:pt idx="191">
                  <c:v>0.75568622652873374</c:v>
                </c:pt>
                <c:pt idx="192" formatCode="0.0000">
                  <c:v>0.75312457830321267</c:v>
                </c:pt>
                <c:pt idx="193">
                  <c:v>0.75312457830321267</c:v>
                </c:pt>
                <c:pt idx="194" formatCode="0.0000">
                  <c:v>0.75056293007769148</c:v>
                </c:pt>
                <c:pt idx="195" formatCode="0.0000">
                  <c:v>0.75056293007769148</c:v>
                </c:pt>
                <c:pt idx="196">
                  <c:v>0.75056293007769148</c:v>
                </c:pt>
                <c:pt idx="197" formatCode="0.0000">
                  <c:v>0.74799250908427473</c:v>
                </c:pt>
                <c:pt idx="198">
                  <c:v>0.74799250908427473</c:v>
                </c:pt>
                <c:pt idx="199" formatCode="0.0000">
                  <c:v>0.74285166709744122</c:v>
                </c:pt>
                <c:pt idx="200">
                  <c:v>0.74285166709744122</c:v>
                </c:pt>
                <c:pt idx="201" formatCode="0.0000">
                  <c:v>0.74028124610402446</c:v>
                </c:pt>
                <c:pt idx="202">
                  <c:v>0.74028124610402446</c:v>
                </c:pt>
                <c:pt idx="203" formatCode="0.0000">
                  <c:v>0.73514040411719095</c:v>
                </c:pt>
                <c:pt idx="204">
                  <c:v>0.73514040411719095</c:v>
                </c:pt>
                <c:pt idx="205" formatCode="0.0000">
                  <c:v>0.73256998312377419</c:v>
                </c:pt>
                <c:pt idx="206">
                  <c:v>0.73256998312377419</c:v>
                </c:pt>
                <c:pt idx="207" formatCode="0.0000">
                  <c:v>0.72742914113694068</c:v>
                </c:pt>
                <c:pt idx="208">
                  <c:v>0.72742914113694068</c:v>
                </c:pt>
                <c:pt idx="209" formatCode="0.0000">
                  <c:v>0.72484960517546215</c:v>
                </c:pt>
                <c:pt idx="210" formatCode="0.0000">
                  <c:v>0.72484960517546215</c:v>
                </c:pt>
                <c:pt idx="211">
                  <c:v>0.72484960517546215</c:v>
                </c:pt>
                <c:pt idx="212" formatCode="0.0000">
                  <c:v>0.72226085658554984</c:v>
                </c:pt>
                <c:pt idx="213" formatCode="0.0000">
                  <c:v>0.72226085658554984</c:v>
                </c:pt>
                <c:pt idx="214">
                  <c:v>0.72226085658554984</c:v>
                </c:pt>
                <c:pt idx="215" formatCode="0.0000">
                  <c:v>0.71966279595034999</c:v>
                </c:pt>
                <c:pt idx="216" formatCode="0.0000">
                  <c:v>0.71966279595034999</c:v>
                </c:pt>
                <c:pt idx="217">
                  <c:v>0.71966279595034999</c:v>
                </c:pt>
                <c:pt idx="218" formatCode="0.0000">
                  <c:v>0.71705532205197919</c:v>
                </c:pt>
                <c:pt idx="219">
                  <c:v>0.71705532205197919</c:v>
                </c:pt>
                <c:pt idx="220" formatCode="0.0000">
                  <c:v>0.71444784815360829</c:v>
                </c:pt>
                <c:pt idx="221" formatCode="0.0000">
                  <c:v>0.71444784815360829</c:v>
                </c:pt>
                <c:pt idx="222">
                  <c:v>0.71444784815360829</c:v>
                </c:pt>
                <c:pt idx="223" formatCode="0.0000">
                  <c:v>0.71183082306879653</c:v>
                </c:pt>
                <c:pt idx="224">
                  <c:v>0.71183082306879653</c:v>
                </c:pt>
                <c:pt idx="225" formatCode="0.0000">
                  <c:v>0.70921379798398476</c:v>
                </c:pt>
                <c:pt idx="226" formatCode="0.0000">
                  <c:v>0.70921379798398476</c:v>
                </c:pt>
                <c:pt idx="227" formatCode="0.0000">
                  <c:v>0.70921379798398476</c:v>
                </c:pt>
                <c:pt idx="228" formatCode="0.0000">
                  <c:v>0.70921379798398476</c:v>
                </c:pt>
                <c:pt idx="229" formatCode="0.0000">
                  <c:v>0.70921379798398476</c:v>
                </c:pt>
                <c:pt idx="230">
                  <c:v>0.70921379798398476</c:v>
                </c:pt>
                <c:pt idx="231" formatCode="0.0000">
                  <c:v>0.70390133507773767</c:v>
                </c:pt>
                <c:pt idx="232">
                  <c:v>0.70390133507773767</c:v>
                </c:pt>
                <c:pt idx="233" formatCode="0.0000">
                  <c:v>0.70124510362461412</c:v>
                </c:pt>
                <c:pt idx="234" formatCode="0.0000">
                  <c:v>0.70124510362461412</c:v>
                </c:pt>
                <c:pt idx="235">
                  <c:v>0.70124510362461412</c:v>
                </c:pt>
                <c:pt idx="236" formatCode="0.0000">
                  <c:v>0.69857877243212507</c:v>
                </c:pt>
                <c:pt idx="237" formatCode="0.0000">
                  <c:v>0.69857877243212507</c:v>
                </c:pt>
                <c:pt idx="238" formatCode="0.0000">
                  <c:v>0.69857877243212507</c:v>
                </c:pt>
                <c:pt idx="239">
                  <c:v>0.69857877243212507</c:v>
                </c:pt>
                <c:pt idx="240" formatCode="0.0000">
                  <c:v>0.69589193099969382</c:v>
                </c:pt>
                <c:pt idx="241">
                  <c:v>0.69589193099969382</c:v>
                </c:pt>
                <c:pt idx="242" formatCode="0.0000">
                  <c:v>0.69320508956726257</c:v>
                </c:pt>
                <c:pt idx="243">
                  <c:v>0.69320508956726257</c:v>
                </c:pt>
                <c:pt idx="244" formatCode="0.0000">
                  <c:v>0.69051824813483131</c:v>
                </c:pt>
                <c:pt idx="245">
                  <c:v>0.69051824813483131</c:v>
                </c:pt>
                <c:pt idx="246" formatCode="0.0000">
                  <c:v>0.68783140670240006</c:v>
                </c:pt>
                <c:pt idx="247" formatCode="0.0000">
                  <c:v>0.68783140670240006</c:v>
                </c:pt>
                <c:pt idx="248">
                  <c:v>0.68783140670240006</c:v>
                </c:pt>
                <c:pt idx="249" formatCode="0.0000">
                  <c:v>0.68513402863690043</c:v>
                </c:pt>
                <c:pt idx="250">
                  <c:v>0.68513402863690043</c:v>
                </c:pt>
                <c:pt idx="251" formatCode="0.0000">
                  <c:v>0.68243665057140079</c:v>
                </c:pt>
                <c:pt idx="252">
                  <c:v>0.68243665057140079</c:v>
                </c:pt>
                <c:pt idx="253" formatCode="0.0000">
                  <c:v>0.67973927250590116</c:v>
                </c:pt>
                <c:pt idx="254">
                  <c:v>0.67973927250590116</c:v>
                </c:pt>
                <c:pt idx="255" formatCode="0.0000">
                  <c:v>0.67704189444040153</c:v>
                </c:pt>
                <c:pt idx="256">
                  <c:v>0.67704189444040153</c:v>
                </c:pt>
                <c:pt idx="257" formatCode="0.0000">
                  <c:v>0.67434451637490189</c:v>
                </c:pt>
                <c:pt idx="258">
                  <c:v>0.67434451637490189</c:v>
                </c:pt>
                <c:pt idx="259" formatCode="0.0000">
                  <c:v>0.67164713830940226</c:v>
                </c:pt>
                <c:pt idx="260">
                  <c:v>0.67164713830940226</c:v>
                </c:pt>
                <c:pt idx="261" formatCode="0.0000">
                  <c:v>0.66894976024390262</c:v>
                </c:pt>
                <c:pt idx="262">
                  <c:v>0.66894976024390262</c:v>
                </c:pt>
                <c:pt idx="263" formatCode="0.0000">
                  <c:v>0.66625238217840299</c:v>
                </c:pt>
                <c:pt idx="264">
                  <c:v>0.66625238217840299</c:v>
                </c:pt>
                <c:pt idx="265" formatCode="0.0000">
                  <c:v>0.66355500411290336</c:v>
                </c:pt>
                <c:pt idx="266">
                  <c:v>0.66355500411290336</c:v>
                </c:pt>
                <c:pt idx="267" formatCode="0.0000">
                  <c:v>0.66085762604740372</c:v>
                </c:pt>
                <c:pt idx="268">
                  <c:v>0.66085762604740372</c:v>
                </c:pt>
                <c:pt idx="269" formatCode="0.0000">
                  <c:v>0.65816024798190409</c:v>
                </c:pt>
                <c:pt idx="270">
                  <c:v>0.65816024798190409</c:v>
                </c:pt>
                <c:pt idx="271" formatCode="0.0000">
                  <c:v>0.65545176959514728</c:v>
                </c:pt>
                <c:pt idx="272">
                  <c:v>0.65545176959514728</c:v>
                </c:pt>
                <c:pt idx="273" formatCode="0.0000">
                  <c:v>0.65274329120839047</c:v>
                </c:pt>
                <c:pt idx="274">
                  <c:v>0.65274329120839047</c:v>
                </c:pt>
                <c:pt idx="275" formatCode="0.0000">
                  <c:v>0.65003481282163367</c:v>
                </c:pt>
                <c:pt idx="276" formatCode="0.0000">
                  <c:v>0.65003481282163367</c:v>
                </c:pt>
                <c:pt idx="277" formatCode="0.0000">
                  <c:v>0.65003481282163367</c:v>
                </c:pt>
                <c:pt idx="278" formatCode="0.0000">
                  <c:v>0.65003481282163367</c:v>
                </c:pt>
                <c:pt idx="279">
                  <c:v>0.65003481282163367</c:v>
                </c:pt>
                <c:pt idx="280" formatCode="0.0000">
                  <c:v>0.64729204989833566</c:v>
                </c:pt>
                <c:pt idx="281" formatCode="0.0000">
                  <c:v>0.64729204989833566</c:v>
                </c:pt>
                <c:pt idx="282">
                  <c:v>0.64729204989833566</c:v>
                </c:pt>
                <c:pt idx="283" formatCode="0.0000">
                  <c:v>0.64453761564344914</c:v>
                </c:pt>
                <c:pt idx="284">
                  <c:v>0.64453761564344914</c:v>
                </c:pt>
                <c:pt idx="285" formatCode="0.0000">
                  <c:v>0.63902874713367608</c:v>
                </c:pt>
                <c:pt idx="286">
                  <c:v>0.63902874713367608</c:v>
                </c:pt>
                <c:pt idx="287" formatCode="0.0000">
                  <c:v>0.63627431287878955</c:v>
                </c:pt>
                <c:pt idx="288">
                  <c:v>0.63627431287878955</c:v>
                </c:pt>
                <c:pt idx="289" formatCode="0.0000">
                  <c:v>0.63351987862390302</c:v>
                </c:pt>
                <c:pt idx="290" formatCode="0.0000">
                  <c:v>0.63351987862390302</c:v>
                </c:pt>
                <c:pt idx="291" formatCode="0.0000">
                  <c:v>0.63351987862390302</c:v>
                </c:pt>
                <c:pt idx="292">
                  <c:v>0.63351987862390302</c:v>
                </c:pt>
                <c:pt idx="293" formatCode="0.0000">
                  <c:v>0.63074128266502627</c:v>
                </c:pt>
                <c:pt idx="294">
                  <c:v>0.63074128266502627</c:v>
                </c:pt>
                <c:pt idx="295" formatCode="0.0000">
                  <c:v>0.62796268670614952</c:v>
                </c:pt>
                <c:pt idx="296">
                  <c:v>0.62796268670614952</c:v>
                </c:pt>
                <c:pt idx="297" formatCode="0.0000">
                  <c:v>0.62518409074727277</c:v>
                </c:pt>
                <c:pt idx="298">
                  <c:v>0.62518409074727277</c:v>
                </c:pt>
                <c:pt idx="299" formatCode="0.0000">
                  <c:v>0.62240549478839602</c:v>
                </c:pt>
                <c:pt idx="300">
                  <c:v>0.62240549478839602</c:v>
                </c:pt>
                <c:pt idx="301" formatCode="0.0000">
                  <c:v>0.61962689882951927</c:v>
                </c:pt>
                <c:pt idx="302" formatCode="0.0000">
                  <c:v>0.61962689882951927</c:v>
                </c:pt>
                <c:pt idx="303" formatCode="0.0000">
                  <c:v>0.61962689882951927</c:v>
                </c:pt>
                <c:pt idx="304">
                  <c:v>0.61962689882951927</c:v>
                </c:pt>
                <c:pt idx="305" formatCode="0.0000">
                  <c:v>0.61682315720585634</c:v>
                </c:pt>
                <c:pt idx="306">
                  <c:v>0.61682315720585634</c:v>
                </c:pt>
                <c:pt idx="307" formatCode="0.0000">
                  <c:v>0.61401941558219342</c:v>
                </c:pt>
                <c:pt idx="308">
                  <c:v>0.61401941558219342</c:v>
                </c:pt>
                <c:pt idx="309" formatCode="0.0000">
                  <c:v>0.61121567395853038</c:v>
                </c:pt>
                <c:pt idx="310">
                  <c:v>0.61121567395853038</c:v>
                </c:pt>
                <c:pt idx="311" formatCode="0.0000">
                  <c:v>0.60841193233486746</c:v>
                </c:pt>
                <c:pt idx="312">
                  <c:v>0.60841193233486746</c:v>
                </c:pt>
                <c:pt idx="313" formatCode="0.0000">
                  <c:v>0.60560819071120453</c:v>
                </c:pt>
                <c:pt idx="314">
                  <c:v>0.60560819071120453</c:v>
                </c:pt>
                <c:pt idx="315" formatCode="0.0000">
                  <c:v>0.60280444908754149</c:v>
                </c:pt>
                <c:pt idx="316" formatCode="0.0000">
                  <c:v>0.60280444908754149</c:v>
                </c:pt>
                <c:pt idx="317">
                  <c:v>0.60280444908754149</c:v>
                </c:pt>
                <c:pt idx="318" formatCode="0.0000">
                  <c:v>0.59998760586750632</c:v>
                </c:pt>
                <c:pt idx="319">
                  <c:v>0.59998760586750632</c:v>
                </c:pt>
                <c:pt idx="320" formatCode="0.0000">
                  <c:v>0.59717076264747115</c:v>
                </c:pt>
                <c:pt idx="321" formatCode="0.0000">
                  <c:v>0.59717076264747115</c:v>
                </c:pt>
                <c:pt idx="322" formatCode="0.0000">
                  <c:v>0.59717076264747115</c:v>
                </c:pt>
                <c:pt idx="323" formatCode="0.0000">
                  <c:v>0.59717076264747115</c:v>
                </c:pt>
                <c:pt idx="324">
                  <c:v>0.59717076264747115</c:v>
                </c:pt>
                <c:pt idx="325" formatCode="0.0000">
                  <c:v>0.59431348627116742</c:v>
                </c:pt>
                <c:pt idx="326">
                  <c:v>0.59431348627116742</c:v>
                </c:pt>
                <c:pt idx="327" formatCode="0.0000">
                  <c:v>0.59145620989486369</c:v>
                </c:pt>
                <c:pt idx="328">
                  <c:v>0.59145620989486369</c:v>
                </c:pt>
                <c:pt idx="329" formatCode="0.0000">
                  <c:v>0.58859893351855996</c:v>
                </c:pt>
                <c:pt idx="330">
                  <c:v>0.58859893351855996</c:v>
                </c:pt>
                <c:pt idx="331" formatCode="0.0000">
                  <c:v>0.58574165714225623</c:v>
                </c:pt>
                <c:pt idx="332">
                  <c:v>0.58574165714225623</c:v>
                </c:pt>
                <c:pt idx="333" formatCode="0.0000">
                  <c:v>0.5828843807659525</c:v>
                </c:pt>
                <c:pt idx="334">
                  <c:v>0.5828843807659525</c:v>
                </c:pt>
                <c:pt idx="335" formatCode="0.0000">
                  <c:v>0.58002710438964877</c:v>
                </c:pt>
                <c:pt idx="336">
                  <c:v>0.58002710438964877</c:v>
                </c:pt>
                <c:pt idx="337" formatCode="0.0000">
                  <c:v>0.57716982801334504</c:v>
                </c:pt>
                <c:pt idx="338">
                  <c:v>0.57716982801334504</c:v>
                </c:pt>
                <c:pt idx="339" formatCode="0.0000">
                  <c:v>0.57431255163704131</c:v>
                </c:pt>
                <c:pt idx="340" formatCode="0.0000">
                  <c:v>0.57431255163704131</c:v>
                </c:pt>
                <c:pt idx="341" formatCode="0.0000">
                  <c:v>0.57431255163704131</c:v>
                </c:pt>
                <c:pt idx="342" formatCode="0.0000">
                  <c:v>0.57431255163704131</c:v>
                </c:pt>
                <c:pt idx="343">
                  <c:v>0.57431255163704131</c:v>
                </c:pt>
                <c:pt idx="344" formatCode="0.0000">
                  <c:v>0.57141198319442998</c:v>
                </c:pt>
                <c:pt idx="345">
                  <c:v>0.57141198319442998</c:v>
                </c:pt>
                <c:pt idx="346" formatCode="0.0000">
                  <c:v>0.56851141475181866</c:v>
                </c:pt>
                <c:pt idx="347">
                  <c:v>0.56851141475181866</c:v>
                </c:pt>
                <c:pt idx="348" formatCode="0.0000">
                  <c:v>0.56561084630920733</c:v>
                </c:pt>
                <c:pt idx="349">
                  <c:v>0.56561084630920733</c:v>
                </c:pt>
                <c:pt idx="350" formatCode="0.0000">
                  <c:v>0.562710277866596</c:v>
                </c:pt>
                <c:pt idx="351">
                  <c:v>0.562710277866596</c:v>
                </c:pt>
                <c:pt idx="352" formatCode="0.0000">
                  <c:v>0.55980970942398467</c:v>
                </c:pt>
                <c:pt idx="353">
                  <c:v>0.55980970942398467</c:v>
                </c:pt>
                <c:pt idx="354" formatCode="0.0000">
                  <c:v>0.55690914098137334</c:v>
                </c:pt>
                <c:pt idx="355">
                  <c:v>0.55690914098137334</c:v>
                </c:pt>
                <c:pt idx="356" formatCode="0.0000">
                  <c:v>0.55110800409615068</c:v>
                </c:pt>
                <c:pt idx="357">
                  <c:v>0.55110800409615068</c:v>
                </c:pt>
                <c:pt idx="358" formatCode="0.0000">
                  <c:v>0.54820743565353935</c:v>
                </c:pt>
                <c:pt idx="359">
                  <c:v>0.54820743565353935</c:v>
                </c:pt>
                <c:pt idx="360" formatCode="0.0000">
                  <c:v>0.54530686721092803</c:v>
                </c:pt>
                <c:pt idx="361">
                  <c:v>0.54530686721092803</c:v>
                </c:pt>
                <c:pt idx="362" formatCode="0.0000">
                  <c:v>0.53950573032570537</c:v>
                </c:pt>
                <c:pt idx="363" formatCode="0.0000">
                  <c:v>0.53950573032570537</c:v>
                </c:pt>
                <c:pt idx="364">
                  <c:v>0.53950573032570537</c:v>
                </c:pt>
                <c:pt idx="365" formatCode="0.0000">
                  <c:v>0.53658948313475563</c:v>
                </c:pt>
                <c:pt idx="366">
                  <c:v>0.53658948313475563</c:v>
                </c:pt>
                <c:pt idx="367" formatCode="0.0000">
                  <c:v>0.53367323594380589</c:v>
                </c:pt>
                <c:pt idx="368">
                  <c:v>0.53367323594380589</c:v>
                </c:pt>
                <c:pt idx="369" formatCode="0.0000">
                  <c:v>0.53075698875285615</c:v>
                </c:pt>
                <c:pt idx="370">
                  <c:v>0.53075698875285615</c:v>
                </c:pt>
                <c:pt idx="371" formatCode="0.0000">
                  <c:v>0.52784074156190641</c:v>
                </c:pt>
                <c:pt idx="372">
                  <c:v>0.52784074156190641</c:v>
                </c:pt>
                <c:pt idx="373" formatCode="0.0000">
                  <c:v>0.52492449437095667</c:v>
                </c:pt>
                <c:pt idx="374">
                  <c:v>0.52492449437095667</c:v>
                </c:pt>
                <c:pt idx="375" formatCode="0.0000">
                  <c:v>0.52200824718000693</c:v>
                </c:pt>
                <c:pt idx="376">
                  <c:v>0.52200824718000693</c:v>
                </c:pt>
                <c:pt idx="377" formatCode="0.0000">
                  <c:v>0.5190919999890572</c:v>
                </c:pt>
                <c:pt idx="378">
                  <c:v>0.5190919999890572</c:v>
                </c:pt>
                <c:pt idx="379" formatCode="0.0000">
                  <c:v>0.51617575279810746</c:v>
                </c:pt>
                <c:pt idx="380">
                  <c:v>0.51617575279810746</c:v>
                </c:pt>
                <c:pt idx="381" formatCode="0.0000">
                  <c:v>0.51325950560715772</c:v>
                </c:pt>
                <c:pt idx="382">
                  <c:v>0.51325950560715772</c:v>
                </c:pt>
                <c:pt idx="383" formatCode="0.0000">
                  <c:v>0.51034325841620798</c:v>
                </c:pt>
                <c:pt idx="384">
                  <c:v>0.51034325841620798</c:v>
                </c:pt>
                <c:pt idx="385" formatCode="0.0000">
                  <c:v>0.50742701122525824</c:v>
                </c:pt>
                <c:pt idx="386">
                  <c:v>0.50742701122525824</c:v>
                </c:pt>
                <c:pt idx="387" formatCode="0.0000">
                  <c:v>0.5045107640343085</c:v>
                </c:pt>
                <c:pt idx="388">
                  <c:v>0.5045107640343085</c:v>
                </c:pt>
                <c:pt idx="389" formatCode="0.0000">
                  <c:v>0.50159451684335876</c:v>
                </c:pt>
                <c:pt idx="390">
                  <c:v>0.50159451684335876</c:v>
                </c:pt>
                <c:pt idx="391" formatCode="0.0000">
                  <c:v>0.49867826965240902</c:v>
                </c:pt>
                <c:pt idx="392">
                  <c:v>0.49867826965240902</c:v>
                </c:pt>
                <c:pt idx="393" formatCode="0.0000">
                  <c:v>0.49576202246145923</c:v>
                </c:pt>
                <c:pt idx="394">
                  <c:v>0.49576202246145923</c:v>
                </c:pt>
                <c:pt idx="395" formatCode="0.0000">
                  <c:v>0.49284577527050949</c:v>
                </c:pt>
                <c:pt idx="396">
                  <c:v>0.49284577527050949</c:v>
                </c:pt>
                <c:pt idx="397" formatCode="0.0000">
                  <c:v>0.48701328088861001</c:v>
                </c:pt>
                <c:pt idx="398">
                  <c:v>0.48701328088861001</c:v>
                </c:pt>
                <c:pt idx="399" formatCode="0.0000">
                  <c:v>0.48409703369766022</c:v>
                </c:pt>
                <c:pt idx="400">
                  <c:v>0.48409703369766022</c:v>
                </c:pt>
                <c:pt idx="401" formatCode="0.0000">
                  <c:v>0.48118078650671048</c:v>
                </c:pt>
                <c:pt idx="402" formatCode="0.0000">
                  <c:v>0.48118078650671048</c:v>
                </c:pt>
                <c:pt idx="403">
                  <c:v>0.48118078650671048</c:v>
                </c:pt>
                <c:pt idx="404" formatCode="0.0000">
                  <c:v>0.47824675732069394</c:v>
                </c:pt>
                <c:pt idx="405">
                  <c:v>0.47824675732069394</c:v>
                </c:pt>
                <c:pt idx="406" formatCode="0.0000">
                  <c:v>0.47531272813467745</c:v>
                </c:pt>
                <c:pt idx="407">
                  <c:v>0.47531272813467745</c:v>
                </c:pt>
                <c:pt idx="408" formatCode="0.0000">
                  <c:v>0.47237869894866091</c:v>
                </c:pt>
                <c:pt idx="409">
                  <c:v>0.47237869894866091</c:v>
                </c:pt>
                <c:pt idx="410" formatCode="0.0000">
                  <c:v>0.46944466976264437</c:v>
                </c:pt>
                <c:pt idx="411">
                  <c:v>0.46944466976264437</c:v>
                </c:pt>
                <c:pt idx="412" formatCode="0.0000">
                  <c:v>0.46651064057662783</c:v>
                </c:pt>
                <c:pt idx="413">
                  <c:v>0.46651064057662783</c:v>
                </c:pt>
                <c:pt idx="414" formatCode="0.0000">
                  <c:v>0.46357661139061129</c:v>
                </c:pt>
                <c:pt idx="415">
                  <c:v>0.46357661139061129</c:v>
                </c:pt>
                <c:pt idx="416" formatCode="0.0000">
                  <c:v>0.46064258220459475</c:v>
                </c:pt>
                <c:pt idx="417">
                  <c:v>0.46064258220459475</c:v>
                </c:pt>
                <c:pt idx="418" formatCode="0.0000">
                  <c:v>0.45770855301857821</c:v>
                </c:pt>
                <c:pt idx="419">
                  <c:v>0.45770855301857821</c:v>
                </c:pt>
                <c:pt idx="420" formatCode="0.0000">
                  <c:v>0.45477452383256167</c:v>
                </c:pt>
                <c:pt idx="421" formatCode="0.0000">
                  <c:v>0.45477452383256167</c:v>
                </c:pt>
                <c:pt idx="422">
                  <c:v>0.45477452383256167</c:v>
                </c:pt>
                <c:pt idx="423" formatCode="0.0000">
                  <c:v>0.45182144250897366</c:v>
                </c:pt>
                <c:pt idx="424">
                  <c:v>0.45182144250897366</c:v>
                </c:pt>
                <c:pt idx="425" formatCode="0.0000">
                  <c:v>0.44886836118538559</c:v>
                </c:pt>
                <c:pt idx="426">
                  <c:v>0.44886836118538559</c:v>
                </c:pt>
                <c:pt idx="427" formatCode="0.0000">
                  <c:v>0.44591527986179752</c:v>
                </c:pt>
                <c:pt idx="428">
                  <c:v>0.44591527986179752</c:v>
                </c:pt>
                <c:pt idx="429" formatCode="0.0000">
                  <c:v>0.44296219853820945</c:v>
                </c:pt>
                <c:pt idx="430" formatCode="0.0000">
                  <c:v>0.44296219853820945</c:v>
                </c:pt>
                <c:pt idx="431">
                  <c:v>0.44296219853820945</c:v>
                </c:pt>
                <c:pt idx="432" formatCode="0.0000">
                  <c:v>0.43998929787687918</c:v>
                </c:pt>
                <c:pt idx="433">
                  <c:v>0.43998929787687918</c:v>
                </c:pt>
                <c:pt idx="434" formatCode="0.0000">
                  <c:v>0.43701639721554891</c:v>
                </c:pt>
                <c:pt idx="435">
                  <c:v>0.43701639721554891</c:v>
                </c:pt>
                <c:pt idx="436" formatCode="0.0000">
                  <c:v>0.43404349655421864</c:v>
                </c:pt>
                <c:pt idx="437">
                  <c:v>0.43404349655421864</c:v>
                </c:pt>
                <c:pt idx="438" formatCode="0.0000">
                  <c:v>0.43107059589288838</c:v>
                </c:pt>
                <c:pt idx="439">
                  <c:v>0.43107059589288838</c:v>
                </c:pt>
                <c:pt idx="440" formatCode="0.0000">
                  <c:v>0.42809769523155811</c:v>
                </c:pt>
                <c:pt idx="441">
                  <c:v>0.42809769523155811</c:v>
                </c:pt>
                <c:pt idx="442" formatCode="0.0000">
                  <c:v>0.42512479457022784</c:v>
                </c:pt>
                <c:pt idx="443" formatCode="0.0000">
                  <c:v>0.42512479457022784</c:v>
                </c:pt>
                <c:pt idx="444">
                  <c:v>0.42512479457022784</c:v>
                </c:pt>
                <c:pt idx="445" formatCode="0.0000">
                  <c:v>0.42213095798874739</c:v>
                </c:pt>
                <c:pt idx="446">
                  <c:v>0.42213095798874739</c:v>
                </c:pt>
                <c:pt idx="447" formatCode="0.0000">
                  <c:v>0.41913712140726689</c:v>
                </c:pt>
                <c:pt idx="448">
                  <c:v>0.41913712140726689</c:v>
                </c:pt>
                <c:pt idx="449" formatCode="0.0000">
                  <c:v>0.41614328482578644</c:v>
                </c:pt>
                <c:pt idx="450" formatCode="0.0000">
                  <c:v>0.41614328482578644</c:v>
                </c:pt>
                <c:pt idx="451">
                  <c:v>0.41614328482578644</c:v>
                </c:pt>
                <c:pt idx="452" formatCode="0.0000">
                  <c:v>0.41312775377632421</c:v>
                </c:pt>
                <c:pt idx="453">
                  <c:v>0.41312775377632421</c:v>
                </c:pt>
                <c:pt idx="454" formatCode="0.0000">
                  <c:v>0.41011222272686199</c:v>
                </c:pt>
                <c:pt idx="455">
                  <c:v>0.41011222272686199</c:v>
                </c:pt>
                <c:pt idx="456" formatCode="0.0000">
                  <c:v>0.40709669167739976</c:v>
                </c:pt>
                <c:pt idx="457">
                  <c:v>0.40709669167739976</c:v>
                </c:pt>
                <c:pt idx="458" formatCode="0.0000">
                  <c:v>0.40408116062793753</c:v>
                </c:pt>
                <c:pt idx="459">
                  <c:v>0.40408116062793753</c:v>
                </c:pt>
                <c:pt idx="460" formatCode="0.0000">
                  <c:v>0.4010656295784753</c:v>
                </c:pt>
                <c:pt idx="461">
                  <c:v>0.4010656295784753</c:v>
                </c:pt>
                <c:pt idx="462" formatCode="0.0000">
                  <c:v>0.39805009852901307</c:v>
                </c:pt>
                <c:pt idx="463">
                  <c:v>0.39805009852901307</c:v>
                </c:pt>
                <c:pt idx="464" formatCode="0.0000">
                  <c:v>0.39503456747955085</c:v>
                </c:pt>
                <c:pt idx="465">
                  <c:v>0.39503456747955085</c:v>
                </c:pt>
                <c:pt idx="466" formatCode="0.0000">
                  <c:v>0.39201903643008862</c:v>
                </c:pt>
                <c:pt idx="467">
                  <c:v>0.39201903643008862</c:v>
                </c:pt>
                <c:pt idx="468" formatCode="0.0000">
                  <c:v>0.38900350538062639</c:v>
                </c:pt>
                <c:pt idx="469">
                  <c:v>0.38900350538062639</c:v>
                </c:pt>
                <c:pt idx="470" formatCode="0.0000">
                  <c:v>0.38598797433116416</c:v>
                </c:pt>
                <c:pt idx="471">
                  <c:v>0.38598797433116416</c:v>
                </c:pt>
                <c:pt idx="472" formatCode="0.0000">
                  <c:v>0.38297244328170194</c:v>
                </c:pt>
                <c:pt idx="473">
                  <c:v>0.38297244328170194</c:v>
                </c:pt>
                <c:pt idx="474" formatCode="0.0000">
                  <c:v>0.37995691223223971</c:v>
                </c:pt>
                <c:pt idx="475">
                  <c:v>0.37995691223223971</c:v>
                </c:pt>
                <c:pt idx="476" formatCode="0.0000">
                  <c:v>0.37694138118277748</c:v>
                </c:pt>
                <c:pt idx="477">
                  <c:v>0.37694138118277748</c:v>
                </c:pt>
                <c:pt idx="478" formatCode="0.0000">
                  <c:v>0.37392585013331525</c:v>
                </c:pt>
                <c:pt idx="479" formatCode="0.0000">
                  <c:v>0.37392585013331525</c:v>
                </c:pt>
                <c:pt idx="480">
                  <c:v>0.37392585013331525</c:v>
                </c:pt>
                <c:pt idx="481" formatCode="0.0000">
                  <c:v>0.37088580257125575</c:v>
                </c:pt>
                <c:pt idx="482">
                  <c:v>0.37088580257125575</c:v>
                </c:pt>
                <c:pt idx="483" formatCode="0.0000">
                  <c:v>0.36784575500919625</c:v>
                </c:pt>
                <c:pt idx="484">
                  <c:v>0.36784575500919625</c:v>
                </c:pt>
                <c:pt idx="485" formatCode="0.0000">
                  <c:v>0.36480570744713681</c:v>
                </c:pt>
                <c:pt idx="486">
                  <c:v>0.36480570744713681</c:v>
                </c:pt>
                <c:pt idx="487" formatCode="0.0000">
                  <c:v>0.36176565988507736</c:v>
                </c:pt>
                <c:pt idx="488">
                  <c:v>0.36176565988507736</c:v>
                </c:pt>
                <c:pt idx="489" formatCode="0.0000">
                  <c:v>0.35872561232301792</c:v>
                </c:pt>
                <c:pt idx="490">
                  <c:v>0.35872561232301792</c:v>
                </c:pt>
                <c:pt idx="491" formatCode="0.0000">
                  <c:v>0.35264551719889897</c:v>
                </c:pt>
                <c:pt idx="492">
                  <c:v>0.35264551719889897</c:v>
                </c:pt>
                <c:pt idx="493" formatCode="0.0000">
                  <c:v>0.34960546963683953</c:v>
                </c:pt>
                <c:pt idx="494">
                  <c:v>0.34960546963683953</c:v>
                </c:pt>
                <c:pt idx="495" formatCode="0.0000">
                  <c:v>0.34656542207478008</c:v>
                </c:pt>
                <c:pt idx="496">
                  <c:v>0.34656542207478008</c:v>
                </c:pt>
                <c:pt idx="497" formatCode="0.0000">
                  <c:v>0.34352537451272058</c:v>
                </c:pt>
                <c:pt idx="498">
                  <c:v>0.34352537451272058</c:v>
                </c:pt>
                <c:pt idx="499" formatCode="0.0000">
                  <c:v>0.34048532695066108</c:v>
                </c:pt>
                <c:pt idx="500">
                  <c:v>0.34048532695066108</c:v>
                </c:pt>
                <c:pt idx="501" formatCode="0.0000">
                  <c:v>0.33744527938860164</c:v>
                </c:pt>
                <c:pt idx="502">
                  <c:v>0.33744527938860164</c:v>
                </c:pt>
                <c:pt idx="503" formatCode="0.0000">
                  <c:v>0.33440523182654214</c:v>
                </c:pt>
                <c:pt idx="504">
                  <c:v>0.33440523182654214</c:v>
                </c:pt>
                <c:pt idx="505" formatCode="0.0000">
                  <c:v>0.33136518426448269</c:v>
                </c:pt>
                <c:pt idx="506">
                  <c:v>0.33136518426448269</c:v>
                </c:pt>
                <c:pt idx="507" formatCode="0.0000">
                  <c:v>0.32832513670242325</c:v>
                </c:pt>
                <c:pt idx="508">
                  <c:v>0.32832513670242325</c:v>
                </c:pt>
                <c:pt idx="509" formatCode="0.0000">
                  <c:v>0.32528508914036375</c:v>
                </c:pt>
                <c:pt idx="510" formatCode="0.0000">
                  <c:v>0.32528508914036375</c:v>
                </c:pt>
                <c:pt idx="511">
                  <c:v>0.32528508914036375</c:v>
                </c:pt>
                <c:pt idx="512" formatCode="0.0000">
                  <c:v>0.32221636188432257</c:v>
                </c:pt>
                <c:pt idx="513">
                  <c:v>0.32221636188432257</c:v>
                </c:pt>
                <c:pt idx="514" formatCode="0.0000">
                  <c:v>0.31914763462828138</c:v>
                </c:pt>
                <c:pt idx="515" formatCode="0.0000">
                  <c:v>0.31914763462828138</c:v>
                </c:pt>
                <c:pt idx="516">
                  <c:v>0.31914763462828138</c:v>
                </c:pt>
                <c:pt idx="517" formatCode="0.0000">
                  <c:v>0.31604911390373497</c:v>
                </c:pt>
                <c:pt idx="518">
                  <c:v>0.31604911390373497</c:v>
                </c:pt>
                <c:pt idx="519" formatCode="0.0000">
                  <c:v>0.31295059317918855</c:v>
                </c:pt>
                <c:pt idx="520">
                  <c:v>0.31295059317918855</c:v>
                </c:pt>
                <c:pt idx="521" formatCode="0.0000">
                  <c:v>0.30985207245464214</c:v>
                </c:pt>
                <c:pt idx="522">
                  <c:v>0.30985207245464214</c:v>
                </c:pt>
                <c:pt idx="523" formatCode="0.0000">
                  <c:v>0.30675355173009572</c:v>
                </c:pt>
                <c:pt idx="524" formatCode="0.0000">
                  <c:v>0.30675355173009572</c:v>
                </c:pt>
                <c:pt idx="525">
                  <c:v>0.30675355173009572</c:v>
                </c:pt>
                <c:pt idx="526" formatCode="0.0000">
                  <c:v>0.30362341344713556</c:v>
                </c:pt>
                <c:pt idx="527" formatCode="0.0000">
                  <c:v>0.30362341344713556</c:v>
                </c:pt>
                <c:pt idx="528" formatCode="0.0000">
                  <c:v>0.30362341344713556</c:v>
                </c:pt>
                <c:pt idx="529">
                  <c:v>0.30362341344713556</c:v>
                </c:pt>
                <c:pt idx="530" formatCode="0.0000">
                  <c:v>0.30042737751611309</c:v>
                </c:pt>
                <c:pt idx="531">
                  <c:v>0.30042737751611309</c:v>
                </c:pt>
                <c:pt idx="532" formatCode="0.0000">
                  <c:v>0.29723134158509062</c:v>
                </c:pt>
                <c:pt idx="533">
                  <c:v>0.29723134158509062</c:v>
                </c:pt>
                <c:pt idx="534" formatCode="0.0000">
                  <c:v>0.29403530565406816</c:v>
                </c:pt>
                <c:pt idx="535">
                  <c:v>0.29403530565406816</c:v>
                </c:pt>
                <c:pt idx="536" formatCode="0.0000">
                  <c:v>0.29083926972304569</c:v>
                </c:pt>
                <c:pt idx="537" formatCode="0.0000">
                  <c:v>0.29083926972304569</c:v>
                </c:pt>
                <c:pt idx="538">
                  <c:v>0.29083926972304569</c:v>
                </c:pt>
                <c:pt idx="539" formatCode="0.0000">
                  <c:v>0.28760772228167852</c:v>
                </c:pt>
                <c:pt idx="540">
                  <c:v>0.28760772228167852</c:v>
                </c:pt>
                <c:pt idx="541" formatCode="0.0000">
                  <c:v>0.28437617484031136</c:v>
                </c:pt>
                <c:pt idx="542" formatCode="0.0000">
                  <c:v>0.28437617484031136</c:v>
                </c:pt>
                <c:pt idx="543">
                  <c:v>0.28437617484031136</c:v>
                </c:pt>
                <c:pt idx="544" formatCode="0.0000">
                  <c:v>0.28110748317548018</c:v>
                </c:pt>
                <c:pt idx="545" formatCode="0.0000">
                  <c:v>0.28110748317548018</c:v>
                </c:pt>
                <c:pt idx="546" formatCode="0.0000">
                  <c:v>0.28110748317548018</c:v>
                </c:pt>
                <c:pt idx="547" formatCode="0.0000">
                  <c:v>0.28110748317548018</c:v>
                </c:pt>
                <c:pt idx="548">
                  <c:v>0.28110748317548018</c:v>
                </c:pt>
                <c:pt idx="549" formatCode="0.0000">
                  <c:v>0.27772064602878765</c:v>
                </c:pt>
                <c:pt idx="550">
                  <c:v>0.27772064602878765</c:v>
                </c:pt>
                <c:pt idx="551" formatCode="0.0000">
                  <c:v>0.27433380888209513</c:v>
                </c:pt>
                <c:pt idx="552">
                  <c:v>0.27433380888209513</c:v>
                </c:pt>
                <c:pt idx="553" formatCode="0.0000">
                  <c:v>0.27094697173540261</c:v>
                </c:pt>
                <c:pt idx="554">
                  <c:v>0.27094697173540261</c:v>
                </c:pt>
                <c:pt idx="555" formatCode="0.0000">
                  <c:v>0.26756013458871009</c:v>
                </c:pt>
                <c:pt idx="556" formatCode="0.0000">
                  <c:v>0.26756013458871009</c:v>
                </c:pt>
                <c:pt idx="557">
                  <c:v>0.26756013458871009</c:v>
                </c:pt>
                <c:pt idx="558" formatCode="0.0000">
                  <c:v>0.26412987645295738</c:v>
                </c:pt>
                <c:pt idx="559" formatCode="0.0000">
                  <c:v>0.26412987645295738</c:v>
                </c:pt>
                <c:pt idx="560">
                  <c:v>0.26412987645295738</c:v>
                </c:pt>
                <c:pt idx="561" formatCode="0.0000">
                  <c:v>0.26065448334173424</c:v>
                </c:pt>
                <c:pt idx="562" formatCode="0.0000">
                  <c:v>0.26065448334173424</c:v>
                </c:pt>
                <c:pt idx="563">
                  <c:v>0.26065448334173424</c:v>
                </c:pt>
                <c:pt idx="564" formatCode="0.0000">
                  <c:v>0.25713212545873787</c:v>
                </c:pt>
                <c:pt idx="565">
                  <c:v>0.25713212545873787</c:v>
                </c:pt>
                <c:pt idx="566" formatCode="0.0000">
                  <c:v>0.25360976757574144</c:v>
                </c:pt>
                <c:pt idx="567">
                  <c:v>0.25360976757574144</c:v>
                </c:pt>
                <c:pt idx="568" formatCode="0.0000">
                  <c:v>0.25008740969274507</c:v>
                </c:pt>
                <c:pt idx="569" formatCode="0.0000">
                  <c:v>0.25008740969274507</c:v>
                </c:pt>
                <c:pt idx="570">
                  <c:v>0.25008740969274507</c:v>
                </c:pt>
                <c:pt idx="571" formatCode="0.0000">
                  <c:v>0.24651473241142016</c:v>
                </c:pt>
                <c:pt idx="572" formatCode="0.0000">
                  <c:v>0.24651473241142016</c:v>
                </c:pt>
                <c:pt idx="573" formatCode="0.0000">
                  <c:v>0.24651473241142016</c:v>
                </c:pt>
                <c:pt idx="574" formatCode="0.0000">
                  <c:v>0.24651473241142016</c:v>
                </c:pt>
                <c:pt idx="575">
                  <c:v>0.24651473241142016</c:v>
                </c:pt>
                <c:pt idx="576" formatCode="0.0000">
                  <c:v>0.24277966070821683</c:v>
                </c:pt>
                <c:pt idx="577">
                  <c:v>0.24277966070821683</c:v>
                </c:pt>
                <c:pt idx="578" formatCode="0.0000">
                  <c:v>0.23904458900501349</c:v>
                </c:pt>
                <c:pt idx="579" formatCode="0.0000">
                  <c:v>0.23904458900501349</c:v>
                </c:pt>
                <c:pt idx="580">
                  <c:v>0.23904458900501349</c:v>
                </c:pt>
                <c:pt idx="581" formatCode="0.0000">
                  <c:v>0.23525023044937834</c:v>
                </c:pt>
                <c:pt idx="582">
                  <c:v>0.23525023044937834</c:v>
                </c:pt>
                <c:pt idx="583" formatCode="0.0000">
                  <c:v>0.23145587189374323</c:v>
                </c:pt>
                <c:pt idx="584">
                  <c:v>0.23145587189374323</c:v>
                </c:pt>
                <c:pt idx="585" formatCode="0.0000">
                  <c:v>0.22766151333810808</c:v>
                </c:pt>
                <c:pt idx="586">
                  <c:v>0.22766151333810808</c:v>
                </c:pt>
                <c:pt idx="587" formatCode="0.0000">
                  <c:v>0.22007279622683781</c:v>
                </c:pt>
                <c:pt idx="588" formatCode="0.0000">
                  <c:v>0.22007279622683781</c:v>
                </c:pt>
                <c:pt idx="589">
                  <c:v>0.22007279622683781</c:v>
                </c:pt>
                <c:pt idx="590" formatCode="0.0000">
                  <c:v>0.21621186997724415</c:v>
                </c:pt>
                <c:pt idx="591">
                  <c:v>0.21621186997724415</c:v>
                </c:pt>
                <c:pt idx="592" formatCode="0.0000">
                  <c:v>0.21235094372765048</c:v>
                </c:pt>
                <c:pt idx="593">
                  <c:v>0.21235094372765048</c:v>
                </c:pt>
                <c:pt idx="594" formatCode="0.0000">
                  <c:v>0.20849001747805684</c:v>
                </c:pt>
                <c:pt idx="595">
                  <c:v>0.20849001747805684</c:v>
                </c:pt>
                <c:pt idx="596" formatCode="0.0000">
                  <c:v>0.20462909122846321</c:v>
                </c:pt>
                <c:pt idx="597" formatCode="0.0000">
                  <c:v>0.20462909122846321</c:v>
                </c:pt>
                <c:pt idx="598" formatCode="0.0000">
                  <c:v>0.20462909122846321</c:v>
                </c:pt>
                <c:pt idx="599" formatCode="0.0000">
                  <c:v>0.20462909122846321</c:v>
                </c:pt>
                <c:pt idx="600">
                  <c:v>0.20462909122846321</c:v>
                </c:pt>
                <c:pt idx="601" formatCode="0.0000">
                  <c:v>0.20053650940389395</c:v>
                </c:pt>
                <c:pt idx="602">
                  <c:v>0.20053650940389395</c:v>
                </c:pt>
                <c:pt idx="603" formatCode="0.0000">
                  <c:v>0.19644392757932469</c:v>
                </c:pt>
                <c:pt idx="604">
                  <c:v>0.19644392757932469</c:v>
                </c:pt>
                <c:pt idx="605" formatCode="0.0000">
                  <c:v>0.19235134575475543</c:v>
                </c:pt>
                <c:pt idx="606" formatCode="0.0000">
                  <c:v>0.19235134575475543</c:v>
                </c:pt>
                <c:pt idx="607">
                  <c:v>0.19235134575475543</c:v>
                </c:pt>
                <c:pt idx="608" formatCode="0.0000">
                  <c:v>0.18816979476008683</c:v>
                </c:pt>
                <c:pt idx="609" formatCode="0.0000">
                  <c:v>0.18816979476008683</c:v>
                </c:pt>
                <c:pt idx="610">
                  <c:v>0.18816979476008683</c:v>
                </c:pt>
                <c:pt idx="611" formatCode="0.0000">
                  <c:v>0.18389320851553939</c:v>
                </c:pt>
                <c:pt idx="612">
                  <c:v>0.18389320851553939</c:v>
                </c:pt>
                <c:pt idx="613" formatCode="0.0000">
                  <c:v>0.17961662227099195</c:v>
                </c:pt>
                <c:pt idx="614">
                  <c:v>0.17961662227099195</c:v>
                </c:pt>
                <c:pt idx="615" formatCode="0.0000">
                  <c:v>0.17534003602644452</c:v>
                </c:pt>
                <c:pt idx="616">
                  <c:v>0.17534003602644452</c:v>
                </c:pt>
                <c:pt idx="617" formatCode="0.0000">
                  <c:v>0.17106344978189708</c:v>
                </c:pt>
                <c:pt idx="618">
                  <c:v>0.17106344978189708</c:v>
                </c:pt>
                <c:pt idx="619" formatCode="0.0000">
                  <c:v>0.16678686353734964</c:v>
                </c:pt>
                <c:pt idx="620">
                  <c:v>0.16678686353734964</c:v>
                </c:pt>
                <c:pt idx="621" formatCode="0.0000">
                  <c:v>0.16251027729280221</c:v>
                </c:pt>
                <c:pt idx="622" formatCode="0.0000">
                  <c:v>0.16251027729280221</c:v>
                </c:pt>
                <c:pt idx="623">
                  <c:v>0.16251027729280221</c:v>
                </c:pt>
                <c:pt idx="624" formatCode="0.0000">
                  <c:v>0.15372593797967776</c:v>
                </c:pt>
                <c:pt idx="625" formatCode="0.0000">
                  <c:v>0.15372593797967776</c:v>
                </c:pt>
                <c:pt idx="626" formatCode="0.0000">
                  <c:v>0.15372593797967776</c:v>
                </c:pt>
                <c:pt idx="627" formatCode="0.0000">
                  <c:v>0.15372593797967776</c:v>
                </c:pt>
                <c:pt idx="628">
                  <c:v>0.15372593797967776</c:v>
                </c:pt>
                <c:pt idx="629" formatCode="0.0000">
                  <c:v>0.14892200241781284</c:v>
                </c:pt>
                <c:pt idx="630">
                  <c:v>0.14892200241781284</c:v>
                </c:pt>
                <c:pt idx="631" formatCode="0.0000">
                  <c:v>0.14411806685594791</c:v>
                </c:pt>
                <c:pt idx="632">
                  <c:v>0.14411806685594791</c:v>
                </c:pt>
                <c:pt idx="633" formatCode="0.0000">
                  <c:v>0.13931413129408299</c:v>
                </c:pt>
                <c:pt idx="634" formatCode="0.0000">
                  <c:v>0.13931413129408299</c:v>
                </c:pt>
                <c:pt idx="635" formatCode="0.0000">
                  <c:v>0.13931413129408299</c:v>
                </c:pt>
                <c:pt idx="636" formatCode="0.0000">
                  <c:v>0.13931413129408299</c:v>
                </c:pt>
                <c:pt idx="637">
                  <c:v>0.13931413129408299</c:v>
                </c:pt>
                <c:pt idx="638" formatCode="0.0000">
                  <c:v>0.1339558954750798</c:v>
                </c:pt>
                <c:pt idx="639" formatCode="0.0000">
                  <c:v>0.1339558954750798</c:v>
                </c:pt>
                <c:pt idx="640" formatCode="0.0000">
                  <c:v>0.1339558954750798</c:v>
                </c:pt>
                <c:pt idx="641">
                  <c:v>0.1339558954750798</c:v>
                </c:pt>
                <c:pt idx="642" formatCode="0.0000">
                  <c:v>0.12813172610659807</c:v>
                </c:pt>
                <c:pt idx="643" formatCode="0.0000">
                  <c:v>0.12813172610659807</c:v>
                </c:pt>
                <c:pt idx="644" formatCode="0.0000">
                  <c:v>0.12813172610659807</c:v>
                </c:pt>
                <c:pt idx="645" formatCode="0.0000">
                  <c:v>0.12813172610659807</c:v>
                </c:pt>
                <c:pt idx="646" formatCode="0.0000">
                  <c:v>0.12813172610659807</c:v>
                </c:pt>
                <c:pt idx="647">
                  <c:v>0.12813172610659807</c:v>
                </c:pt>
                <c:pt idx="648" formatCode="0.0000">
                  <c:v>0.12101329687845372</c:v>
                </c:pt>
                <c:pt idx="649" formatCode="0.0000">
                  <c:v>0.12101329687845372</c:v>
                </c:pt>
                <c:pt idx="650" formatCode="0.0000">
                  <c:v>0.12101329687845372</c:v>
                </c:pt>
                <c:pt idx="651">
                  <c:v>0.12101329687845372</c:v>
                </c:pt>
                <c:pt idx="652" formatCode="0.0000">
                  <c:v>0.11294574375322347</c:v>
                </c:pt>
                <c:pt idx="653">
                  <c:v>0.11294574375322347</c:v>
                </c:pt>
                <c:pt idx="654" formatCode="0.0000">
                  <c:v>0.10487819062799322</c:v>
                </c:pt>
                <c:pt idx="655" formatCode="0.0000">
                  <c:v>0.10487819062799322</c:v>
                </c:pt>
                <c:pt idx="656">
                  <c:v>0.10487819062799322</c:v>
                </c:pt>
                <c:pt idx="657" formatCode="0.0000">
                  <c:v>9.6138341408993785E-2</c:v>
                </c:pt>
                <c:pt idx="658" formatCode="0.0000">
                  <c:v>9.6138341408993785E-2</c:v>
                </c:pt>
                <c:pt idx="659" formatCode="0.0000">
                  <c:v>9.6138341408993785E-2</c:v>
                </c:pt>
                <c:pt idx="660">
                  <c:v>9.6138341408993785E-2</c:v>
                </c:pt>
                <c:pt idx="661" formatCode="0.0000">
                  <c:v>8.5456303474661141E-2</c:v>
                </c:pt>
                <c:pt idx="662" formatCode="0.0000">
                  <c:v>8.5456303474661141E-2</c:v>
                </c:pt>
                <c:pt idx="663" formatCode="0.0000">
                  <c:v>8.5456303474661141E-2</c:v>
                </c:pt>
                <c:pt idx="664" formatCode="0.0000">
                  <c:v>8.5456303474661141E-2</c:v>
                </c:pt>
                <c:pt idx="665">
                  <c:v>8.5456303474661141E-2</c:v>
                </c:pt>
                <c:pt idx="666" formatCode="0.0000">
                  <c:v>6.8365042779728921E-2</c:v>
                </c:pt>
                <c:pt idx="667" formatCode="0.0000">
                  <c:v>6.8365042779728921E-2</c:v>
                </c:pt>
                <c:pt idx="668" formatCode="0.0000">
                  <c:v>6.8365042779728921E-2</c:v>
                </c:pt>
                <c:pt idx="669" formatCode="0.0000">
                  <c:v>6.8365042779728921E-2</c:v>
                </c:pt>
                <c:pt idx="670" formatCode="0.0000">
                  <c:v>6.8365042779728921E-2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0-8CE5-40BD-A312-9BF3B083AF1E}"/>
            </c:ext>
          </c:extLst>
        </c:ser>
        <c:ser>
          <c:idx val="1"/>
          <c:order val="1"/>
          <c:tx>
            <c:strRef>
              <c:f>Sheet3!$E$905</c:f>
              <c:strCache>
                <c:ptCount val="1"/>
                <c:pt idx="0">
                  <c:v>MELD score ≧7</c:v>
                </c:pt>
              </c:strCache>
            </c:strRef>
          </c:tx>
          <c:spPr>
            <a:ln w="28575">
              <a:solidFill>
                <a:schemeClr val="tx1"/>
              </a:solidFill>
              <a:prstDash val="sysDot"/>
            </a:ln>
          </c:spPr>
          <c:marker>
            <c:symbol val="none"/>
          </c:marker>
          <c:xVal>
            <c:numRef>
              <c:f>Sheet3!$D$906:$D$1737</c:f>
              <c:numCache>
                <c:formatCode>General</c:formatCode>
                <c:ptCount val="832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5</c:v>
                </c:pt>
                <c:pt idx="4">
                  <c:v>5</c:v>
                </c:pt>
                <c:pt idx="5">
                  <c:v>6</c:v>
                </c:pt>
                <c:pt idx="6">
                  <c:v>8</c:v>
                </c:pt>
                <c:pt idx="7">
                  <c:v>8</c:v>
                </c:pt>
                <c:pt idx="8">
                  <c:v>10</c:v>
                </c:pt>
                <c:pt idx="9">
                  <c:v>10</c:v>
                </c:pt>
                <c:pt idx="10">
                  <c:v>11</c:v>
                </c:pt>
                <c:pt idx="11">
                  <c:v>11</c:v>
                </c:pt>
                <c:pt idx="12">
                  <c:v>12</c:v>
                </c:pt>
                <c:pt idx="13">
                  <c:v>12</c:v>
                </c:pt>
                <c:pt idx="14">
                  <c:v>13</c:v>
                </c:pt>
                <c:pt idx="15">
                  <c:v>13</c:v>
                </c:pt>
                <c:pt idx="16">
                  <c:v>14</c:v>
                </c:pt>
                <c:pt idx="17">
                  <c:v>14</c:v>
                </c:pt>
                <c:pt idx="18">
                  <c:v>15</c:v>
                </c:pt>
                <c:pt idx="19">
                  <c:v>15</c:v>
                </c:pt>
                <c:pt idx="20">
                  <c:v>18</c:v>
                </c:pt>
                <c:pt idx="21">
                  <c:v>23</c:v>
                </c:pt>
                <c:pt idx="22">
                  <c:v>23</c:v>
                </c:pt>
                <c:pt idx="23">
                  <c:v>25</c:v>
                </c:pt>
                <c:pt idx="24">
                  <c:v>25</c:v>
                </c:pt>
                <c:pt idx="25">
                  <c:v>27</c:v>
                </c:pt>
                <c:pt idx="26">
                  <c:v>27</c:v>
                </c:pt>
                <c:pt idx="27">
                  <c:v>28</c:v>
                </c:pt>
                <c:pt idx="28">
                  <c:v>29</c:v>
                </c:pt>
                <c:pt idx="29">
                  <c:v>29</c:v>
                </c:pt>
                <c:pt idx="30">
                  <c:v>29</c:v>
                </c:pt>
                <c:pt idx="31">
                  <c:v>31</c:v>
                </c:pt>
                <c:pt idx="32">
                  <c:v>31</c:v>
                </c:pt>
                <c:pt idx="33">
                  <c:v>32</c:v>
                </c:pt>
                <c:pt idx="34">
                  <c:v>32</c:v>
                </c:pt>
                <c:pt idx="35">
                  <c:v>33</c:v>
                </c:pt>
                <c:pt idx="36">
                  <c:v>34</c:v>
                </c:pt>
                <c:pt idx="37">
                  <c:v>34</c:v>
                </c:pt>
                <c:pt idx="38">
                  <c:v>37</c:v>
                </c:pt>
                <c:pt idx="39">
                  <c:v>37</c:v>
                </c:pt>
                <c:pt idx="40">
                  <c:v>42</c:v>
                </c:pt>
                <c:pt idx="41">
                  <c:v>42</c:v>
                </c:pt>
                <c:pt idx="42">
                  <c:v>42</c:v>
                </c:pt>
                <c:pt idx="43">
                  <c:v>43</c:v>
                </c:pt>
                <c:pt idx="44">
                  <c:v>43</c:v>
                </c:pt>
                <c:pt idx="45">
                  <c:v>44</c:v>
                </c:pt>
                <c:pt idx="46">
                  <c:v>44</c:v>
                </c:pt>
                <c:pt idx="47">
                  <c:v>45</c:v>
                </c:pt>
                <c:pt idx="48">
                  <c:v>45</c:v>
                </c:pt>
                <c:pt idx="49">
                  <c:v>46</c:v>
                </c:pt>
                <c:pt idx="50">
                  <c:v>46</c:v>
                </c:pt>
                <c:pt idx="51">
                  <c:v>47</c:v>
                </c:pt>
                <c:pt idx="52">
                  <c:v>47</c:v>
                </c:pt>
                <c:pt idx="53">
                  <c:v>49</c:v>
                </c:pt>
                <c:pt idx="54">
                  <c:v>49</c:v>
                </c:pt>
                <c:pt idx="55">
                  <c:v>50</c:v>
                </c:pt>
                <c:pt idx="56">
                  <c:v>50</c:v>
                </c:pt>
                <c:pt idx="57">
                  <c:v>51</c:v>
                </c:pt>
                <c:pt idx="58">
                  <c:v>51</c:v>
                </c:pt>
                <c:pt idx="59">
                  <c:v>52</c:v>
                </c:pt>
                <c:pt idx="60">
                  <c:v>52</c:v>
                </c:pt>
                <c:pt idx="61">
                  <c:v>53</c:v>
                </c:pt>
                <c:pt idx="62">
                  <c:v>53</c:v>
                </c:pt>
                <c:pt idx="63">
                  <c:v>55</c:v>
                </c:pt>
                <c:pt idx="64">
                  <c:v>55</c:v>
                </c:pt>
                <c:pt idx="65">
                  <c:v>56</c:v>
                </c:pt>
                <c:pt idx="66">
                  <c:v>56</c:v>
                </c:pt>
                <c:pt idx="67">
                  <c:v>57</c:v>
                </c:pt>
                <c:pt idx="68">
                  <c:v>57</c:v>
                </c:pt>
                <c:pt idx="69">
                  <c:v>58</c:v>
                </c:pt>
                <c:pt idx="70">
                  <c:v>60</c:v>
                </c:pt>
                <c:pt idx="71">
                  <c:v>60</c:v>
                </c:pt>
                <c:pt idx="72">
                  <c:v>62</c:v>
                </c:pt>
                <c:pt idx="73">
                  <c:v>63</c:v>
                </c:pt>
                <c:pt idx="74">
                  <c:v>63</c:v>
                </c:pt>
                <c:pt idx="75">
                  <c:v>64</c:v>
                </c:pt>
                <c:pt idx="76">
                  <c:v>64</c:v>
                </c:pt>
                <c:pt idx="77">
                  <c:v>65</c:v>
                </c:pt>
                <c:pt idx="78">
                  <c:v>65</c:v>
                </c:pt>
                <c:pt idx="79">
                  <c:v>67</c:v>
                </c:pt>
                <c:pt idx="80">
                  <c:v>67</c:v>
                </c:pt>
                <c:pt idx="81">
                  <c:v>68</c:v>
                </c:pt>
                <c:pt idx="82">
                  <c:v>68</c:v>
                </c:pt>
                <c:pt idx="83">
                  <c:v>69</c:v>
                </c:pt>
                <c:pt idx="84">
                  <c:v>69</c:v>
                </c:pt>
                <c:pt idx="85">
                  <c:v>70</c:v>
                </c:pt>
                <c:pt idx="86">
                  <c:v>70</c:v>
                </c:pt>
                <c:pt idx="87">
                  <c:v>71</c:v>
                </c:pt>
                <c:pt idx="88">
                  <c:v>74</c:v>
                </c:pt>
                <c:pt idx="89">
                  <c:v>74</c:v>
                </c:pt>
                <c:pt idx="90">
                  <c:v>78</c:v>
                </c:pt>
                <c:pt idx="91">
                  <c:v>78</c:v>
                </c:pt>
                <c:pt idx="92">
                  <c:v>79</c:v>
                </c:pt>
                <c:pt idx="93">
                  <c:v>79</c:v>
                </c:pt>
                <c:pt idx="94">
                  <c:v>82</c:v>
                </c:pt>
                <c:pt idx="95">
                  <c:v>82</c:v>
                </c:pt>
                <c:pt idx="96">
                  <c:v>85</c:v>
                </c:pt>
                <c:pt idx="97">
                  <c:v>85</c:v>
                </c:pt>
                <c:pt idx="98">
                  <c:v>89</c:v>
                </c:pt>
                <c:pt idx="99">
                  <c:v>89</c:v>
                </c:pt>
                <c:pt idx="100">
                  <c:v>90</c:v>
                </c:pt>
                <c:pt idx="101">
                  <c:v>90</c:v>
                </c:pt>
                <c:pt idx="102">
                  <c:v>91</c:v>
                </c:pt>
                <c:pt idx="103">
                  <c:v>91</c:v>
                </c:pt>
                <c:pt idx="104">
                  <c:v>92</c:v>
                </c:pt>
                <c:pt idx="105">
                  <c:v>92</c:v>
                </c:pt>
                <c:pt idx="106">
                  <c:v>96</c:v>
                </c:pt>
                <c:pt idx="107">
                  <c:v>96</c:v>
                </c:pt>
                <c:pt idx="108">
                  <c:v>97</c:v>
                </c:pt>
                <c:pt idx="109">
                  <c:v>97</c:v>
                </c:pt>
                <c:pt idx="110">
                  <c:v>99</c:v>
                </c:pt>
                <c:pt idx="111">
                  <c:v>99</c:v>
                </c:pt>
                <c:pt idx="112">
                  <c:v>100</c:v>
                </c:pt>
                <c:pt idx="113">
                  <c:v>100</c:v>
                </c:pt>
                <c:pt idx="114">
                  <c:v>101</c:v>
                </c:pt>
                <c:pt idx="115">
                  <c:v>101</c:v>
                </c:pt>
                <c:pt idx="116">
                  <c:v>103</c:v>
                </c:pt>
                <c:pt idx="117">
                  <c:v>103</c:v>
                </c:pt>
                <c:pt idx="118">
                  <c:v>104</c:v>
                </c:pt>
                <c:pt idx="119">
                  <c:v>104</c:v>
                </c:pt>
                <c:pt idx="120">
                  <c:v>105</c:v>
                </c:pt>
                <c:pt idx="121">
                  <c:v>105</c:v>
                </c:pt>
                <c:pt idx="122">
                  <c:v>106</c:v>
                </c:pt>
                <c:pt idx="123">
                  <c:v>106</c:v>
                </c:pt>
                <c:pt idx="124">
                  <c:v>108</c:v>
                </c:pt>
                <c:pt idx="125">
                  <c:v>108</c:v>
                </c:pt>
                <c:pt idx="126">
                  <c:v>110</c:v>
                </c:pt>
                <c:pt idx="127">
                  <c:v>110</c:v>
                </c:pt>
                <c:pt idx="128">
                  <c:v>111</c:v>
                </c:pt>
                <c:pt idx="129">
                  <c:v>111</c:v>
                </c:pt>
                <c:pt idx="130">
                  <c:v>113</c:v>
                </c:pt>
                <c:pt idx="131">
                  <c:v>113</c:v>
                </c:pt>
                <c:pt idx="132">
                  <c:v>114</c:v>
                </c:pt>
                <c:pt idx="133">
                  <c:v>114</c:v>
                </c:pt>
                <c:pt idx="134">
                  <c:v>118</c:v>
                </c:pt>
                <c:pt idx="135">
                  <c:v>118</c:v>
                </c:pt>
                <c:pt idx="136">
                  <c:v>121</c:v>
                </c:pt>
                <c:pt idx="137">
                  <c:v>121</c:v>
                </c:pt>
                <c:pt idx="138">
                  <c:v>126</c:v>
                </c:pt>
                <c:pt idx="139">
                  <c:v>126</c:v>
                </c:pt>
                <c:pt idx="140">
                  <c:v>128</c:v>
                </c:pt>
                <c:pt idx="141">
                  <c:v>128</c:v>
                </c:pt>
                <c:pt idx="142">
                  <c:v>129</c:v>
                </c:pt>
                <c:pt idx="143">
                  <c:v>129</c:v>
                </c:pt>
                <c:pt idx="144">
                  <c:v>130</c:v>
                </c:pt>
                <c:pt idx="145">
                  <c:v>130</c:v>
                </c:pt>
                <c:pt idx="146">
                  <c:v>131</c:v>
                </c:pt>
                <c:pt idx="147">
                  <c:v>131</c:v>
                </c:pt>
                <c:pt idx="148">
                  <c:v>133</c:v>
                </c:pt>
                <c:pt idx="149">
                  <c:v>133</c:v>
                </c:pt>
                <c:pt idx="150">
                  <c:v>135</c:v>
                </c:pt>
                <c:pt idx="151">
                  <c:v>135</c:v>
                </c:pt>
                <c:pt idx="152">
                  <c:v>138</c:v>
                </c:pt>
                <c:pt idx="153">
                  <c:v>138</c:v>
                </c:pt>
                <c:pt idx="154">
                  <c:v>140</c:v>
                </c:pt>
                <c:pt idx="155">
                  <c:v>140</c:v>
                </c:pt>
                <c:pt idx="156">
                  <c:v>148</c:v>
                </c:pt>
                <c:pt idx="157">
                  <c:v>148</c:v>
                </c:pt>
                <c:pt idx="158">
                  <c:v>151</c:v>
                </c:pt>
                <c:pt idx="159">
                  <c:v>151</c:v>
                </c:pt>
                <c:pt idx="160">
                  <c:v>154</c:v>
                </c:pt>
                <c:pt idx="161">
                  <c:v>154</c:v>
                </c:pt>
                <c:pt idx="162">
                  <c:v>155</c:v>
                </c:pt>
                <c:pt idx="163">
                  <c:v>155</c:v>
                </c:pt>
                <c:pt idx="164">
                  <c:v>159</c:v>
                </c:pt>
                <c:pt idx="165">
                  <c:v>159</c:v>
                </c:pt>
                <c:pt idx="166">
                  <c:v>161</c:v>
                </c:pt>
                <c:pt idx="167">
                  <c:v>163</c:v>
                </c:pt>
                <c:pt idx="168">
                  <c:v>163</c:v>
                </c:pt>
                <c:pt idx="169">
                  <c:v>167</c:v>
                </c:pt>
                <c:pt idx="170">
                  <c:v>167</c:v>
                </c:pt>
                <c:pt idx="171">
                  <c:v>169</c:v>
                </c:pt>
                <c:pt idx="172">
                  <c:v>169</c:v>
                </c:pt>
                <c:pt idx="173">
                  <c:v>170</c:v>
                </c:pt>
                <c:pt idx="174">
                  <c:v>170</c:v>
                </c:pt>
                <c:pt idx="175">
                  <c:v>172</c:v>
                </c:pt>
                <c:pt idx="176">
                  <c:v>174</c:v>
                </c:pt>
                <c:pt idx="177">
                  <c:v>174</c:v>
                </c:pt>
                <c:pt idx="178">
                  <c:v>175</c:v>
                </c:pt>
                <c:pt idx="179">
                  <c:v>177</c:v>
                </c:pt>
                <c:pt idx="180">
                  <c:v>177</c:v>
                </c:pt>
                <c:pt idx="181">
                  <c:v>178</c:v>
                </c:pt>
                <c:pt idx="182">
                  <c:v>178</c:v>
                </c:pt>
                <c:pt idx="183">
                  <c:v>180</c:v>
                </c:pt>
                <c:pt idx="184">
                  <c:v>180</c:v>
                </c:pt>
                <c:pt idx="185">
                  <c:v>185</c:v>
                </c:pt>
                <c:pt idx="186">
                  <c:v>185</c:v>
                </c:pt>
                <c:pt idx="187">
                  <c:v>188</c:v>
                </c:pt>
                <c:pt idx="188">
                  <c:v>189</c:v>
                </c:pt>
                <c:pt idx="189">
                  <c:v>189</c:v>
                </c:pt>
                <c:pt idx="190">
                  <c:v>191</c:v>
                </c:pt>
                <c:pt idx="191">
                  <c:v>191</c:v>
                </c:pt>
                <c:pt idx="192">
                  <c:v>193</c:v>
                </c:pt>
                <c:pt idx="193">
                  <c:v>193</c:v>
                </c:pt>
                <c:pt idx="194">
                  <c:v>195</c:v>
                </c:pt>
                <c:pt idx="195">
                  <c:v>195</c:v>
                </c:pt>
                <c:pt idx="196">
                  <c:v>196</c:v>
                </c:pt>
                <c:pt idx="197">
                  <c:v>196</c:v>
                </c:pt>
                <c:pt idx="198">
                  <c:v>199</c:v>
                </c:pt>
                <c:pt idx="199">
                  <c:v>199</c:v>
                </c:pt>
                <c:pt idx="200">
                  <c:v>203</c:v>
                </c:pt>
                <c:pt idx="201">
                  <c:v>203</c:v>
                </c:pt>
                <c:pt idx="202">
                  <c:v>205</c:v>
                </c:pt>
                <c:pt idx="203">
                  <c:v>205</c:v>
                </c:pt>
                <c:pt idx="204">
                  <c:v>209</c:v>
                </c:pt>
                <c:pt idx="205">
                  <c:v>209</c:v>
                </c:pt>
                <c:pt idx="206">
                  <c:v>210</c:v>
                </c:pt>
                <c:pt idx="207">
                  <c:v>210</c:v>
                </c:pt>
                <c:pt idx="208">
                  <c:v>226</c:v>
                </c:pt>
                <c:pt idx="209">
                  <c:v>226</c:v>
                </c:pt>
                <c:pt idx="210">
                  <c:v>228</c:v>
                </c:pt>
                <c:pt idx="211">
                  <c:v>228</c:v>
                </c:pt>
                <c:pt idx="212">
                  <c:v>236</c:v>
                </c:pt>
                <c:pt idx="213">
                  <c:v>236</c:v>
                </c:pt>
                <c:pt idx="214">
                  <c:v>237</c:v>
                </c:pt>
                <c:pt idx="215">
                  <c:v>237</c:v>
                </c:pt>
                <c:pt idx="216">
                  <c:v>241</c:v>
                </c:pt>
                <c:pt idx="217">
                  <c:v>241</c:v>
                </c:pt>
                <c:pt idx="218">
                  <c:v>243</c:v>
                </c:pt>
                <c:pt idx="219">
                  <c:v>243</c:v>
                </c:pt>
                <c:pt idx="220">
                  <c:v>245</c:v>
                </c:pt>
                <c:pt idx="221">
                  <c:v>245</c:v>
                </c:pt>
                <c:pt idx="222">
                  <c:v>246</c:v>
                </c:pt>
                <c:pt idx="223">
                  <c:v>246</c:v>
                </c:pt>
                <c:pt idx="224">
                  <c:v>249</c:v>
                </c:pt>
                <c:pt idx="225">
                  <c:v>249</c:v>
                </c:pt>
                <c:pt idx="226">
                  <c:v>252</c:v>
                </c:pt>
                <c:pt idx="227">
                  <c:v>252</c:v>
                </c:pt>
                <c:pt idx="228">
                  <c:v>253</c:v>
                </c:pt>
                <c:pt idx="229">
                  <c:v>253</c:v>
                </c:pt>
                <c:pt idx="230">
                  <c:v>254</c:v>
                </c:pt>
                <c:pt idx="231">
                  <c:v>258</c:v>
                </c:pt>
                <c:pt idx="232">
                  <c:v>258</c:v>
                </c:pt>
                <c:pt idx="233">
                  <c:v>259</c:v>
                </c:pt>
                <c:pt idx="234">
                  <c:v>259</c:v>
                </c:pt>
                <c:pt idx="235">
                  <c:v>261</c:v>
                </c:pt>
                <c:pt idx="236">
                  <c:v>261</c:v>
                </c:pt>
                <c:pt idx="237">
                  <c:v>263</c:v>
                </c:pt>
                <c:pt idx="238">
                  <c:v>263</c:v>
                </c:pt>
                <c:pt idx="239">
                  <c:v>264</c:v>
                </c:pt>
                <c:pt idx="240">
                  <c:v>265</c:v>
                </c:pt>
                <c:pt idx="241">
                  <c:v>265</c:v>
                </c:pt>
                <c:pt idx="242">
                  <c:v>266</c:v>
                </c:pt>
                <c:pt idx="243">
                  <c:v>268</c:v>
                </c:pt>
                <c:pt idx="244">
                  <c:v>268</c:v>
                </c:pt>
                <c:pt idx="245">
                  <c:v>274</c:v>
                </c:pt>
                <c:pt idx="246">
                  <c:v>274</c:v>
                </c:pt>
                <c:pt idx="247">
                  <c:v>275</c:v>
                </c:pt>
                <c:pt idx="248">
                  <c:v>275</c:v>
                </c:pt>
                <c:pt idx="249">
                  <c:v>276</c:v>
                </c:pt>
                <c:pt idx="250">
                  <c:v>276</c:v>
                </c:pt>
                <c:pt idx="251">
                  <c:v>277</c:v>
                </c:pt>
                <c:pt idx="252">
                  <c:v>277</c:v>
                </c:pt>
                <c:pt idx="253">
                  <c:v>278</c:v>
                </c:pt>
                <c:pt idx="254">
                  <c:v>278</c:v>
                </c:pt>
                <c:pt idx="255">
                  <c:v>279</c:v>
                </c:pt>
                <c:pt idx="256">
                  <c:v>279</c:v>
                </c:pt>
                <c:pt idx="257">
                  <c:v>283</c:v>
                </c:pt>
                <c:pt idx="258">
                  <c:v>283</c:v>
                </c:pt>
                <c:pt idx="259">
                  <c:v>286</c:v>
                </c:pt>
                <c:pt idx="260">
                  <c:v>287</c:v>
                </c:pt>
                <c:pt idx="261">
                  <c:v>287</c:v>
                </c:pt>
                <c:pt idx="262">
                  <c:v>289</c:v>
                </c:pt>
                <c:pt idx="263">
                  <c:v>289</c:v>
                </c:pt>
                <c:pt idx="264">
                  <c:v>291</c:v>
                </c:pt>
                <c:pt idx="265">
                  <c:v>291</c:v>
                </c:pt>
                <c:pt idx="266">
                  <c:v>292</c:v>
                </c:pt>
                <c:pt idx="267">
                  <c:v>292</c:v>
                </c:pt>
                <c:pt idx="268">
                  <c:v>294</c:v>
                </c:pt>
                <c:pt idx="269">
                  <c:v>294</c:v>
                </c:pt>
                <c:pt idx="270">
                  <c:v>295</c:v>
                </c:pt>
                <c:pt idx="271">
                  <c:v>295</c:v>
                </c:pt>
                <c:pt idx="272">
                  <c:v>296</c:v>
                </c:pt>
                <c:pt idx="273">
                  <c:v>296</c:v>
                </c:pt>
                <c:pt idx="274">
                  <c:v>297</c:v>
                </c:pt>
                <c:pt idx="275">
                  <c:v>297</c:v>
                </c:pt>
                <c:pt idx="276">
                  <c:v>308</c:v>
                </c:pt>
                <c:pt idx="277">
                  <c:v>315</c:v>
                </c:pt>
                <c:pt idx="278">
                  <c:v>319</c:v>
                </c:pt>
                <c:pt idx="279">
                  <c:v>325</c:v>
                </c:pt>
                <c:pt idx="280">
                  <c:v>325</c:v>
                </c:pt>
                <c:pt idx="281">
                  <c:v>328</c:v>
                </c:pt>
                <c:pt idx="282">
                  <c:v>328</c:v>
                </c:pt>
                <c:pt idx="283">
                  <c:v>330</c:v>
                </c:pt>
                <c:pt idx="284">
                  <c:v>330</c:v>
                </c:pt>
                <c:pt idx="285">
                  <c:v>335</c:v>
                </c:pt>
                <c:pt idx="286">
                  <c:v>336</c:v>
                </c:pt>
                <c:pt idx="287">
                  <c:v>336</c:v>
                </c:pt>
                <c:pt idx="288">
                  <c:v>339</c:v>
                </c:pt>
                <c:pt idx="289">
                  <c:v>339</c:v>
                </c:pt>
                <c:pt idx="290">
                  <c:v>346</c:v>
                </c:pt>
                <c:pt idx="291">
                  <c:v>346</c:v>
                </c:pt>
                <c:pt idx="292">
                  <c:v>350</c:v>
                </c:pt>
                <c:pt idx="293">
                  <c:v>357</c:v>
                </c:pt>
                <c:pt idx="294">
                  <c:v>357</c:v>
                </c:pt>
                <c:pt idx="295">
                  <c:v>359</c:v>
                </c:pt>
                <c:pt idx="296">
                  <c:v>359</c:v>
                </c:pt>
                <c:pt idx="297">
                  <c:v>360</c:v>
                </c:pt>
                <c:pt idx="298">
                  <c:v>360</c:v>
                </c:pt>
                <c:pt idx="299">
                  <c:v>362</c:v>
                </c:pt>
                <c:pt idx="300">
                  <c:v>362</c:v>
                </c:pt>
                <c:pt idx="301">
                  <c:v>366</c:v>
                </c:pt>
                <c:pt idx="302">
                  <c:v>366</c:v>
                </c:pt>
                <c:pt idx="303">
                  <c:v>367</c:v>
                </c:pt>
                <c:pt idx="304">
                  <c:v>367</c:v>
                </c:pt>
                <c:pt idx="305">
                  <c:v>368</c:v>
                </c:pt>
                <c:pt idx="306">
                  <c:v>368</c:v>
                </c:pt>
                <c:pt idx="307">
                  <c:v>371</c:v>
                </c:pt>
                <c:pt idx="308">
                  <c:v>371</c:v>
                </c:pt>
                <c:pt idx="309">
                  <c:v>372</c:v>
                </c:pt>
                <c:pt idx="310">
                  <c:v>376</c:v>
                </c:pt>
                <c:pt idx="311">
                  <c:v>376</c:v>
                </c:pt>
                <c:pt idx="312">
                  <c:v>380</c:v>
                </c:pt>
                <c:pt idx="313">
                  <c:v>380</c:v>
                </c:pt>
                <c:pt idx="314">
                  <c:v>389</c:v>
                </c:pt>
                <c:pt idx="315">
                  <c:v>389</c:v>
                </c:pt>
                <c:pt idx="316">
                  <c:v>396</c:v>
                </c:pt>
                <c:pt idx="317">
                  <c:v>399</c:v>
                </c:pt>
                <c:pt idx="318">
                  <c:v>399</c:v>
                </c:pt>
                <c:pt idx="319">
                  <c:v>404</c:v>
                </c:pt>
                <c:pt idx="320">
                  <c:v>404</c:v>
                </c:pt>
                <c:pt idx="321">
                  <c:v>409</c:v>
                </c:pt>
                <c:pt idx="322">
                  <c:v>409</c:v>
                </c:pt>
                <c:pt idx="323">
                  <c:v>410</c:v>
                </c:pt>
                <c:pt idx="324">
                  <c:v>410</c:v>
                </c:pt>
                <c:pt idx="325">
                  <c:v>412</c:v>
                </c:pt>
                <c:pt idx="326">
                  <c:v>416</c:v>
                </c:pt>
                <c:pt idx="327">
                  <c:v>433</c:v>
                </c:pt>
                <c:pt idx="328">
                  <c:v>433</c:v>
                </c:pt>
                <c:pt idx="329">
                  <c:v>435</c:v>
                </c:pt>
                <c:pt idx="330">
                  <c:v>439</c:v>
                </c:pt>
                <c:pt idx="331">
                  <c:v>439</c:v>
                </c:pt>
                <c:pt idx="332">
                  <c:v>440</c:v>
                </c:pt>
                <c:pt idx="333">
                  <c:v>440</c:v>
                </c:pt>
                <c:pt idx="334">
                  <c:v>443</c:v>
                </c:pt>
                <c:pt idx="335">
                  <c:v>443</c:v>
                </c:pt>
                <c:pt idx="336">
                  <c:v>444</c:v>
                </c:pt>
                <c:pt idx="337">
                  <c:v>444</c:v>
                </c:pt>
                <c:pt idx="338">
                  <c:v>448</c:v>
                </c:pt>
                <c:pt idx="339">
                  <c:v>450</c:v>
                </c:pt>
                <c:pt idx="340">
                  <c:v>450</c:v>
                </c:pt>
                <c:pt idx="341">
                  <c:v>456</c:v>
                </c:pt>
                <c:pt idx="342">
                  <c:v>456</c:v>
                </c:pt>
                <c:pt idx="343">
                  <c:v>458</c:v>
                </c:pt>
                <c:pt idx="344">
                  <c:v>458</c:v>
                </c:pt>
                <c:pt idx="345">
                  <c:v>461</c:v>
                </c:pt>
                <c:pt idx="346">
                  <c:v>461</c:v>
                </c:pt>
                <c:pt idx="347">
                  <c:v>464</c:v>
                </c:pt>
                <c:pt idx="348">
                  <c:v>464</c:v>
                </c:pt>
                <c:pt idx="349">
                  <c:v>465</c:v>
                </c:pt>
                <c:pt idx="350">
                  <c:v>465</c:v>
                </c:pt>
                <c:pt idx="351">
                  <c:v>467</c:v>
                </c:pt>
                <c:pt idx="352">
                  <c:v>467</c:v>
                </c:pt>
                <c:pt idx="353">
                  <c:v>468</c:v>
                </c:pt>
                <c:pt idx="354">
                  <c:v>468</c:v>
                </c:pt>
                <c:pt idx="355">
                  <c:v>471</c:v>
                </c:pt>
                <c:pt idx="356">
                  <c:v>473</c:v>
                </c:pt>
                <c:pt idx="357">
                  <c:v>473</c:v>
                </c:pt>
                <c:pt idx="358">
                  <c:v>477</c:v>
                </c:pt>
                <c:pt idx="359">
                  <c:v>477</c:v>
                </c:pt>
                <c:pt idx="360">
                  <c:v>483</c:v>
                </c:pt>
                <c:pt idx="361">
                  <c:v>484</c:v>
                </c:pt>
                <c:pt idx="362">
                  <c:v>484</c:v>
                </c:pt>
                <c:pt idx="363">
                  <c:v>504</c:v>
                </c:pt>
                <c:pt idx="364">
                  <c:v>504</c:v>
                </c:pt>
                <c:pt idx="365">
                  <c:v>504</c:v>
                </c:pt>
                <c:pt idx="366">
                  <c:v>510</c:v>
                </c:pt>
                <c:pt idx="367">
                  <c:v>523</c:v>
                </c:pt>
                <c:pt idx="368">
                  <c:v>523</c:v>
                </c:pt>
                <c:pt idx="369">
                  <c:v>524</c:v>
                </c:pt>
                <c:pt idx="370">
                  <c:v>524</c:v>
                </c:pt>
                <c:pt idx="371">
                  <c:v>529</c:v>
                </c:pt>
                <c:pt idx="372">
                  <c:v>529</c:v>
                </c:pt>
                <c:pt idx="373">
                  <c:v>532</c:v>
                </c:pt>
                <c:pt idx="374">
                  <c:v>532</c:v>
                </c:pt>
                <c:pt idx="375">
                  <c:v>533</c:v>
                </c:pt>
                <c:pt idx="376">
                  <c:v>533</c:v>
                </c:pt>
                <c:pt idx="377">
                  <c:v>541</c:v>
                </c:pt>
                <c:pt idx="378">
                  <c:v>543</c:v>
                </c:pt>
                <c:pt idx="379">
                  <c:v>543</c:v>
                </c:pt>
                <c:pt idx="380">
                  <c:v>549</c:v>
                </c:pt>
                <c:pt idx="381">
                  <c:v>549</c:v>
                </c:pt>
                <c:pt idx="382">
                  <c:v>552</c:v>
                </c:pt>
                <c:pt idx="383">
                  <c:v>552</c:v>
                </c:pt>
                <c:pt idx="384">
                  <c:v>566</c:v>
                </c:pt>
                <c:pt idx="385">
                  <c:v>566</c:v>
                </c:pt>
                <c:pt idx="386">
                  <c:v>569</c:v>
                </c:pt>
                <c:pt idx="387">
                  <c:v>569</c:v>
                </c:pt>
                <c:pt idx="388">
                  <c:v>573</c:v>
                </c:pt>
                <c:pt idx="389">
                  <c:v>573</c:v>
                </c:pt>
                <c:pt idx="390">
                  <c:v>578</c:v>
                </c:pt>
                <c:pt idx="391">
                  <c:v>583</c:v>
                </c:pt>
                <c:pt idx="392">
                  <c:v>595</c:v>
                </c:pt>
                <c:pt idx="393">
                  <c:v>595</c:v>
                </c:pt>
                <c:pt idx="394">
                  <c:v>598</c:v>
                </c:pt>
                <c:pt idx="395">
                  <c:v>598</c:v>
                </c:pt>
                <c:pt idx="396">
                  <c:v>603</c:v>
                </c:pt>
                <c:pt idx="397">
                  <c:v>603</c:v>
                </c:pt>
                <c:pt idx="398">
                  <c:v>615</c:v>
                </c:pt>
                <c:pt idx="399">
                  <c:v>615</c:v>
                </c:pt>
                <c:pt idx="400">
                  <c:v>616.70269490740611</c:v>
                </c:pt>
                <c:pt idx="401">
                  <c:v>620</c:v>
                </c:pt>
                <c:pt idx="402">
                  <c:v>620</c:v>
                </c:pt>
                <c:pt idx="403">
                  <c:v>622</c:v>
                </c:pt>
                <c:pt idx="404">
                  <c:v>622</c:v>
                </c:pt>
                <c:pt idx="405">
                  <c:v>625</c:v>
                </c:pt>
                <c:pt idx="406">
                  <c:v>625</c:v>
                </c:pt>
                <c:pt idx="407">
                  <c:v>627</c:v>
                </c:pt>
                <c:pt idx="408">
                  <c:v>627</c:v>
                </c:pt>
                <c:pt idx="409">
                  <c:v>628</c:v>
                </c:pt>
                <c:pt idx="410">
                  <c:v>637</c:v>
                </c:pt>
                <c:pt idx="411">
                  <c:v>637</c:v>
                </c:pt>
                <c:pt idx="412">
                  <c:v>638</c:v>
                </c:pt>
                <c:pt idx="413">
                  <c:v>638</c:v>
                </c:pt>
                <c:pt idx="414">
                  <c:v>642</c:v>
                </c:pt>
                <c:pt idx="415">
                  <c:v>642</c:v>
                </c:pt>
                <c:pt idx="416">
                  <c:v>646</c:v>
                </c:pt>
                <c:pt idx="417">
                  <c:v>646</c:v>
                </c:pt>
                <c:pt idx="418">
                  <c:v>648</c:v>
                </c:pt>
                <c:pt idx="419">
                  <c:v>660</c:v>
                </c:pt>
                <c:pt idx="420">
                  <c:v>665</c:v>
                </c:pt>
                <c:pt idx="421">
                  <c:v>665</c:v>
                </c:pt>
                <c:pt idx="422">
                  <c:v>666</c:v>
                </c:pt>
                <c:pt idx="423">
                  <c:v>666</c:v>
                </c:pt>
                <c:pt idx="424">
                  <c:v>669</c:v>
                </c:pt>
                <c:pt idx="425">
                  <c:v>669</c:v>
                </c:pt>
                <c:pt idx="426">
                  <c:v>672</c:v>
                </c:pt>
                <c:pt idx="427">
                  <c:v>672</c:v>
                </c:pt>
                <c:pt idx="428">
                  <c:v>677</c:v>
                </c:pt>
                <c:pt idx="429">
                  <c:v>677</c:v>
                </c:pt>
                <c:pt idx="430">
                  <c:v>681</c:v>
                </c:pt>
                <c:pt idx="431">
                  <c:v>681</c:v>
                </c:pt>
                <c:pt idx="432">
                  <c:v>684</c:v>
                </c:pt>
                <c:pt idx="433">
                  <c:v>684</c:v>
                </c:pt>
                <c:pt idx="434">
                  <c:v>685</c:v>
                </c:pt>
                <c:pt idx="435">
                  <c:v>685</c:v>
                </c:pt>
                <c:pt idx="436">
                  <c:v>696</c:v>
                </c:pt>
                <c:pt idx="437">
                  <c:v>696</c:v>
                </c:pt>
                <c:pt idx="438">
                  <c:v>701</c:v>
                </c:pt>
                <c:pt idx="439">
                  <c:v>701</c:v>
                </c:pt>
                <c:pt idx="440">
                  <c:v>707</c:v>
                </c:pt>
                <c:pt idx="441">
                  <c:v>707</c:v>
                </c:pt>
                <c:pt idx="442">
                  <c:v>709</c:v>
                </c:pt>
                <c:pt idx="443">
                  <c:v>709</c:v>
                </c:pt>
                <c:pt idx="444">
                  <c:v>714</c:v>
                </c:pt>
                <c:pt idx="445">
                  <c:v>714</c:v>
                </c:pt>
                <c:pt idx="446">
                  <c:v>718</c:v>
                </c:pt>
                <c:pt idx="447">
                  <c:v>720.70269490740611</c:v>
                </c:pt>
                <c:pt idx="448">
                  <c:v>729</c:v>
                </c:pt>
                <c:pt idx="449">
                  <c:v>729</c:v>
                </c:pt>
                <c:pt idx="450">
                  <c:v>730</c:v>
                </c:pt>
                <c:pt idx="451">
                  <c:v>730</c:v>
                </c:pt>
                <c:pt idx="452">
                  <c:v>731</c:v>
                </c:pt>
                <c:pt idx="453">
                  <c:v>731</c:v>
                </c:pt>
                <c:pt idx="454">
                  <c:v>733</c:v>
                </c:pt>
                <c:pt idx="455">
                  <c:v>733</c:v>
                </c:pt>
                <c:pt idx="456">
                  <c:v>738</c:v>
                </c:pt>
                <c:pt idx="457">
                  <c:v>746</c:v>
                </c:pt>
                <c:pt idx="458">
                  <c:v>746</c:v>
                </c:pt>
                <c:pt idx="459">
                  <c:v>760</c:v>
                </c:pt>
                <c:pt idx="460">
                  <c:v>760</c:v>
                </c:pt>
                <c:pt idx="461">
                  <c:v>765</c:v>
                </c:pt>
                <c:pt idx="462">
                  <c:v>768</c:v>
                </c:pt>
                <c:pt idx="463">
                  <c:v>782</c:v>
                </c:pt>
                <c:pt idx="464">
                  <c:v>791</c:v>
                </c:pt>
                <c:pt idx="465">
                  <c:v>791</c:v>
                </c:pt>
                <c:pt idx="466">
                  <c:v>791.70269490740611</c:v>
                </c:pt>
                <c:pt idx="467">
                  <c:v>796</c:v>
                </c:pt>
                <c:pt idx="468">
                  <c:v>796</c:v>
                </c:pt>
                <c:pt idx="469">
                  <c:v>797</c:v>
                </c:pt>
                <c:pt idx="470">
                  <c:v>797</c:v>
                </c:pt>
                <c:pt idx="471">
                  <c:v>801</c:v>
                </c:pt>
                <c:pt idx="472">
                  <c:v>801</c:v>
                </c:pt>
                <c:pt idx="473">
                  <c:v>806</c:v>
                </c:pt>
                <c:pt idx="474">
                  <c:v>806</c:v>
                </c:pt>
                <c:pt idx="475">
                  <c:v>811</c:v>
                </c:pt>
                <c:pt idx="476">
                  <c:v>811</c:v>
                </c:pt>
                <c:pt idx="477">
                  <c:v>813</c:v>
                </c:pt>
                <c:pt idx="478">
                  <c:v>813</c:v>
                </c:pt>
                <c:pt idx="479">
                  <c:v>815</c:v>
                </c:pt>
                <c:pt idx="480">
                  <c:v>815</c:v>
                </c:pt>
                <c:pt idx="481">
                  <c:v>817</c:v>
                </c:pt>
                <c:pt idx="482">
                  <c:v>817</c:v>
                </c:pt>
                <c:pt idx="483">
                  <c:v>818</c:v>
                </c:pt>
                <c:pt idx="484">
                  <c:v>818</c:v>
                </c:pt>
                <c:pt idx="485">
                  <c:v>822</c:v>
                </c:pt>
                <c:pt idx="486">
                  <c:v>822</c:v>
                </c:pt>
                <c:pt idx="487">
                  <c:v>833</c:v>
                </c:pt>
                <c:pt idx="488">
                  <c:v>833</c:v>
                </c:pt>
                <c:pt idx="489">
                  <c:v>835</c:v>
                </c:pt>
                <c:pt idx="490">
                  <c:v>835</c:v>
                </c:pt>
                <c:pt idx="491">
                  <c:v>836</c:v>
                </c:pt>
                <c:pt idx="492">
                  <c:v>836</c:v>
                </c:pt>
                <c:pt idx="493">
                  <c:v>859</c:v>
                </c:pt>
                <c:pt idx="494">
                  <c:v>859</c:v>
                </c:pt>
                <c:pt idx="495">
                  <c:v>862</c:v>
                </c:pt>
                <c:pt idx="496">
                  <c:v>862</c:v>
                </c:pt>
                <c:pt idx="497">
                  <c:v>864</c:v>
                </c:pt>
                <c:pt idx="498">
                  <c:v>864</c:v>
                </c:pt>
                <c:pt idx="499">
                  <c:v>870</c:v>
                </c:pt>
                <c:pt idx="500">
                  <c:v>870</c:v>
                </c:pt>
                <c:pt idx="501">
                  <c:v>878</c:v>
                </c:pt>
                <c:pt idx="502">
                  <c:v>878</c:v>
                </c:pt>
                <c:pt idx="503">
                  <c:v>882</c:v>
                </c:pt>
                <c:pt idx="504">
                  <c:v>882</c:v>
                </c:pt>
                <c:pt idx="505">
                  <c:v>896</c:v>
                </c:pt>
                <c:pt idx="506">
                  <c:v>896</c:v>
                </c:pt>
                <c:pt idx="507">
                  <c:v>897</c:v>
                </c:pt>
                <c:pt idx="508">
                  <c:v>905</c:v>
                </c:pt>
                <c:pt idx="509">
                  <c:v>905</c:v>
                </c:pt>
                <c:pt idx="510">
                  <c:v>938</c:v>
                </c:pt>
                <c:pt idx="511">
                  <c:v>947</c:v>
                </c:pt>
                <c:pt idx="512">
                  <c:v>947</c:v>
                </c:pt>
                <c:pt idx="513">
                  <c:v>956</c:v>
                </c:pt>
                <c:pt idx="514">
                  <c:v>956</c:v>
                </c:pt>
                <c:pt idx="515">
                  <c:v>957</c:v>
                </c:pt>
                <c:pt idx="516">
                  <c:v>957</c:v>
                </c:pt>
                <c:pt idx="517">
                  <c:v>959</c:v>
                </c:pt>
                <c:pt idx="518">
                  <c:v>959</c:v>
                </c:pt>
                <c:pt idx="519">
                  <c:v>967</c:v>
                </c:pt>
                <c:pt idx="520">
                  <c:v>967</c:v>
                </c:pt>
                <c:pt idx="521">
                  <c:v>972</c:v>
                </c:pt>
                <c:pt idx="522">
                  <c:v>973</c:v>
                </c:pt>
                <c:pt idx="523">
                  <c:v>973</c:v>
                </c:pt>
                <c:pt idx="524">
                  <c:v>974</c:v>
                </c:pt>
                <c:pt idx="525">
                  <c:v>981</c:v>
                </c:pt>
                <c:pt idx="526">
                  <c:v>981</c:v>
                </c:pt>
                <c:pt idx="527">
                  <c:v>995</c:v>
                </c:pt>
                <c:pt idx="528">
                  <c:v>995</c:v>
                </c:pt>
                <c:pt idx="529">
                  <c:v>1006</c:v>
                </c:pt>
                <c:pt idx="530">
                  <c:v>1006</c:v>
                </c:pt>
                <c:pt idx="531">
                  <c:v>1007</c:v>
                </c:pt>
                <c:pt idx="532">
                  <c:v>1007</c:v>
                </c:pt>
                <c:pt idx="533">
                  <c:v>1008</c:v>
                </c:pt>
                <c:pt idx="534">
                  <c:v>1008</c:v>
                </c:pt>
                <c:pt idx="535">
                  <c:v>1016</c:v>
                </c:pt>
                <c:pt idx="536">
                  <c:v>1016</c:v>
                </c:pt>
                <c:pt idx="537">
                  <c:v>1023</c:v>
                </c:pt>
                <c:pt idx="538">
                  <c:v>1023</c:v>
                </c:pt>
                <c:pt idx="539">
                  <c:v>1026</c:v>
                </c:pt>
                <c:pt idx="540">
                  <c:v>1026</c:v>
                </c:pt>
                <c:pt idx="541">
                  <c:v>1029</c:v>
                </c:pt>
                <c:pt idx="542">
                  <c:v>1029</c:v>
                </c:pt>
                <c:pt idx="543">
                  <c:v>1034</c:v>
                </c:pt>
                <c:pt idx="544">
                  <c:v>1034</c:v>
                </c:pt>
                <c:pt idx="545">
                  <c:v>1044</c:v>
                </c:pt>
                <c:pt idx="546">
                  <c:v>1044</c:v>
                </c:pt>
                <c:pt idx="547">
                  <c:v>1045</c:v>
                </c:pt>
                <c:pt idx="548">
                  <c:v>1045</c:v>
                </c:pt>
                <c:pt idx="549">
                  <c:v>1052</c:v>
                </c:pt>
                <c:pt idx="550">
                  <c:v>1053</c:v>
                </c:pt>
                <c:pt idx="551">
                  <c:v>1053</c:v>
                </c:pt>
                <c:pt idx="552">
                  <c:v>1060</c:v>
                </c:pt>
                <c:pt idx="553">
                  <c:v>1060</c:v>
                </c:pt>
                <c:pt idx="554">
                  <c:v>1065</c:v>
                </c:pt>
                <c:pt idx="555">
                  <c:v>1065</c:v>
                </c:pt>
                <c:pt idx="556">
                  <c:v>1067</c:v>
                </c:pt>
                <c:pt idx="557">
                  <c:v>1069</c:v>
                </c:pt>
                <c:pt idx="558">
                  <c:v>1069</c:v>
                </c:pt>
                <c:pt idx="559">
                  <c:v>1080</c:v>
                </c:pt>
                <c:pt idx="560">
                  <c:v>1080</c:v>
                </c:pt>
                <c:pt idx="561">
                  <c:v>1083</c:v>
                </c:pt>
                <c:pt idx="562">
                  <c:v>1085.7026949074061</c:v>
                </c:pt>
                <c:pt idx="563">
                  <c:v>1096</c:v>
                </c:pt>
                <c:pt idx="564">
                  <c:v>1096</c:v>
                </c:pt>
                <c:pt idx="565">
                  <c:v>1099</c:v>
                </c:pt>
                <c:pt idx="566">
                  <c:v>1101</c:v>
                </c:pt>
                <c:pt idx="567">
                  <c:v>1101</c:v>
                </c:pt>
                <c:pt idx="568">
                  <c:v>1105</c:v>
                </c:pt>
                <c:pt idx="569">
                  <c:v>1116</c:v>
                </c:pt>
                <c:pt idx="570">
                  <c:v>1116</c:v>
                </c:pt>
                <c:pt idx="571">
                  <c:v>1125</c:v>
                </c:pt>
                <c:pt idx="572">
                  <c:v>1125</c:v>
                </c:pt>
                <c:pt idx="573">
                  <c:v>1127</c:v>
                </c:pt>
                <c:pt idx="574">
                  <c:v>1127</c:v>
                </c:pt>
                <c:pt idx="575">
                  <c:v>1128</c:v>
                </c:pt>
                <c:pt idx="576">
                  <c:v>1128</c:v>
                </c:pt>
                <c:pt idx="577">
                  <c:v>1138</c:v>
                </c:pt>
                <c:pt idx="578">
                  <c:v>1138</c:v>
                </c:pt>
                <c:pt idx="579">
                  <c:v>1139</c:v>
                </c:pt>
                <c:pt idx="580">
                  <c:v>1139</c:v>
                </c:pt>
                <c:pt idx="581">
                  <c:v>1140</c:v>
                </c:pt>
                <c:pt idx="582">
                  <c:v>1140</c:v>
                </c:pt>
                <c:pt idx="583">
                  <c:v>1144</c:v>
                </c:pt>
                <c:pt idx="584">
                  <c:v>1144</c:v>
                </c:pt>
                <c:pt idx="585">
                  <c:v>1148</c:v>
                </c:pt>
                <c:pt idx="586">
                  <c:v>1148</c:v>
                </c:pt>
                <c:pt idx="587">
                  <c:v>1164</c:v>
                </c:pt>
                <c:pt idx="588">
                  <c:v>1175</c:v>
                </c:pt>
                <c:pt idx="589">
                  <c:v>1175</c:v>
                </c:pt>
                <c:pt idx="590">
                  <c:v>1200</c:v>
                </c:pt>
                <c:pt idx="591">
                  <c:v>1200</c:v>
                </c:pt>
                <c:pt idx="592">
                  <c:v>1201</c:v>
                </c:pt>
                <c:pt idx="593">
                  <c:v>1201</c:v>
                </c:pt>
                <c:pt idx="594">
                  <c:v>1206</c:v>
                </c:pt>
                <c:pt idx="595">
                  <c:v>1206</c:v>
                </c:pt>
                <c:pt idx="596">
                  <c:v>1209</c:v>
                </c:pt>
                <c:pt idx="597">
                  <c:v>1209</c:v>
                </c:pt>
                <c:pt idx="598">
                  <c:v>1213</c:v>
                </c:pt>
                <c:pt idx="599">
                  <c:v>1213</c:v>
                </c:pt>
                <c:pt idx="600">
                  <c:v>1224</c:v>
                </c:pt>
                <c:pt idx="601">
                  <c:v>1224</c:v>
                </c:pt>
                <c:pt idx="602">
                  <c:v>1241</c:v>
                </c:pt>
                <c:pt idx="603">
                  <c:v>1241</c:v>
                </c:pt>
                <c:pt idx="604">
                  <c:v>1247</c:v>
                </c:pt>
                <c:pt idx="605">
                  <c:v>1249</c:v>
                </c:pt>
                <c:pt idx="606">
                  <c:v>1249</c:v>
                </c:pt>
                <c:pt idx="607">
                  <c:v>1250</c:v>
                </c:pt>
                <c:pt idx="608">
                  <c:v>1250</c:v>
                </c:pt>
                <c:pt idx="609">
                  <c:v>1263</c:v>
                </c:pt>
                <c:pt idx="610">
                  <c:v>1263</c:v>
                </c:pt>
                <c:pt idx="611">
                  <c:v>1269</c:v>
                </c:pt>
                <c:pt idx="612">
                  <c:v>1269</c:v>
                </c:pt>
                <c:pt idx="613">
                  <c:v>1274</c:v>
                </c:pt>
                <c:pt idx="614">
                  <c:v>1274</c:v>
                </c:pt>
                <c:pt idx="615">
                  <c:v>1276</c:v>
                </c:pt>
                <c:pt idx="616">
                  <c:v>1276</c:v>
                </c:pt>
                <c:pt idx="617">
                  <c:v>1279</c:v>
                </c:pt>
                <c:pt idx="618">
                  <c:v>1279</c:v>
                </c:pt>
                <c:pt idx="619">
                  <c:v>1280</c:v>
                </c:pt>
                <c:pt idx="620">
                  <c:v>1280</c:v>
                </c:pt>
                <c:pt idx="621">
                  <c:v>1286</c:v>
                </c:pt>
                <c:pt idx="622">
                  <c:v>1286</c:v>
                </c:pt>
                <c:pt idx="623">
                  <c:v>1290</c:v>
                </c:pt>
                <c:pt idx="624">
                  <c:v>1290</c:v>
                </c:pt>
                <c:pt idx="625">
                  <c:v>1294</c:v>
                </c:pt>
                <c:pt idx="626">
                  <c:v>1294</c:v>
                </c:pt>
                <c:pt idx="627">
                  <c:v>1318</c:v>
                </c:pt>
                <c:pt idx="628">
                  <c:v>1318</c:v>
                </c:pt>
                <c:pt idx="629">
                  <c:v>1324</c:v>
                </c:pt>
                <c:pt idx="630">
                  <c:v>1346</c:v>
                </c:pt>
                <c:pt idx="631">
                  <c:v>1346</c:v>
                </c:pt>
                <c:pt idx="632">
                  <c:v>1352</c:v>
                </c:pt>
                <c:pt idx="633">
                  <c:v>1352</c:v>
                </c:pt>
                <c:pt idx="634">
                  <c:v>1360</c:v>
                </c:pt>
                <c:pt idx="635">
                  <c:v>1360</c:v>
                </c:pt>
                <c:pt idx="636">
                  <c:v>1394.7026949074061</c:v>
                </c:pt>
                <c:pt idx="637">
                  <c:v>1406</c:v>
                </c:pt>
                <c:pt idx="638">
                  <c:v>1408</c:v>
                </c:pt>
                <c:pt idx="639">
                  <c:v>1408</c:v>
                </c:pt>
                <c:pt idx="640">
                  <c:v>1415</c:v>
                </c:pt>
                <c:pt idx="641">
                  <c:v>1415</c:v>
                </c:pt>
                <c:pt idx="642">
                  <c:v>1416</c:v>
                </c:pt>
                <c:pt idx="643">
                  <c:v>1416</c:v>
                </c:pt>
                <c:pt idx="644">
                  <c:v>1428</c:v>
                </c:pt>
                <c:pt idx="645">
                  <c:v>1428</c:v>
                </c:pt>
                <c:pt idx="646">
                  <c:v>1441</c:v>
                </c:pt>
                <c:pt idx="647">
                  <c:v>1441</c:v>
                </c:pt>
                <c:pt idx="648">
                  <c:v>1454</c:v>
                </c:pt>
                <c:pt idx="649">
                  <c:v>1454</c:v>
                </c:pt>
                <c:pt idx="650">
                  <c:v>1455</c:v>
                </c:pt>
                <c:pt idx="651">
                  <c:v>1455</c:v>
                </c:pt>
                <c:pt idx="652">
                  <c:v>1461</c:v>
                </c:pt>
                <c:pt idx="653">
                  <c:v>1461</c:v>
                </c:pt>
                <c:pt idx="654">
                  <c:v>1498</c:v>
                </c:pt>
                <c:pt idx="655">
                  <c:v>1546</c:v>
                </c:pt>
                <c:pt idx="656">
                  <c:v>1546</c:v>
                </c:pt>
                <c:pt idx="657">
                  <c:v>1577</c:v>
                </c:pt>
                <c:pt idx="658">
                  <c:v>1577</c:v>
                </c:pt>
                <c:pt idx="659">
                  <c:v>1578</c:v>
                </c:pt>
                <c:pt idx="660">
                  <c:v>1578</c:v>
                </c:pt>
                <c:pt idx="661">
                  <c:v>1581</c:v>
                </c:pt>
                <c:pt idx="662">
                  <c:v>1581</c:v>
                </c:pt>
                <c:pt idx="663">
                  <c:v>1593</c:v>
                </c:pt>
                <c:pt idx="664">
                  <c:v>1593</c:v>
                </c:pt>
                <c:pt idx="665">
                  <c:v>1594</c:v>
                </c:pt>
                <c:pt idx="666">
                  <c:v>1594</c:v>
                </c:pt>
                <c:pt idx="667">
                  <c:v>1605</c:v>
                </c:pt>
                <c:pt idx="668">
                  <c:v>1605</c:v>
                </c:pt>
                <c:pt idx="669">
                  <c:v>1609</c:v>
                </c:pt>
                <c:pt idx="670">
                  <c:v>1609</c:v>
                </c:pt>
                <c:pt idx="671">
                  <c:v>1665</c:v>
                </c:pt>
                <c:pt idx="672">
                  <c:v>1665</c:v>
                </c:pt>
                <c:pt idx="673">
                  <c:v>1674</c:v>
                </c:pt>
                <c:pt idx="674">
                  <c:v>1674</c:v>
                </c:pt>
                <c:pt idx="675">
                  <c:v>1697</c:v>
                </c:pt>
                <c:pt idx="676">
                  <c:v>1697</c:v>
                </c:pt>
                <c:pt idx="677">
                  <c:v>1706</c:v>
                </c:pt>
                <c:pt idx="678">
                  <c:v>1706</c:v>
                </c:pt>
                <c:pt idx="679">
                  <c:v>1709</c:v>
                </c:pt>
                <c:pt idx="680">
                  <c:v>1709</c:v>
                </c:pt>
                <c:pt idx="681">
                  <c:v>1721</c:v>
                </c:pt>
                <c:pt idx="682">
                  <c:v>1721</c:v>
                </c:pt>
                <c:pt idx="683">
                  <c:v>1722.7026949074061</c:v>
                </c:pt>
                <c:pt idx="684">
                  <c:v>1726</c:v>
                </c:pt>
                <c:pt idx="685">
                  <c:v>1726</c:v>
                </c:pt>
                <c:pt idx="686">
                  <c:v>1738</c:v>
                </c:pt>
                <c:pt idx="687">
                  <c:v>1738</c:v>
                </c:pt>
                <c:pt idx="688">
                  <c:v>1764</c:v>
                </c:pt>
                <c:pt idx="689">
                  <c:v>1764</c:v>
                </c:pt>
                <c:pt idx="690">
                  <c:v>1766</c:v>
                </c:pt>
                <c:pt idx="691">
                  <c:v>1766</c:v>
                </c:pt>
                <c:pt idx="692">
                  <c:v>1767</c:v>
                </c:pt>
                <c:pt idx="693">
                  <c:v>1767</c:v>
                </c:pt>
                <c:pt idx="694">
                  <c:v>1776</c:v>
                </c:pt>
                <c:pt idx="695">
                  <c:v>1776</c:v>
                </c:pt>
                <c:pt idx="696">
                  <c:v>1789.7026949074061</c:v>
                </c:pt>
                <c:pt idx="697">
                  <c:v>1795</c:v>
                </c:pt>
                <c:pt idx="698">
                  <c:v>1795</c:v>
                </c:pt>
                <c:pt idx="699">
                  <c:v>1815</c:v>
                </c:pt>
                <c:pt idx="700">
                  <c:v>1815</c:v>
                </c:pt>
                <c:pt idx="701">
                  <c:v>1819</c:v>
                </c:pt>
                <c:pt idx="702">
                  <c:v>1819</c:v>
                </c:pt>
                <c:pt idx="703">
                  <c:v>1834</c:v>
                </c:pt>
                <c:pt idx="704">
                  <c:v>1834</c:v>
                </c:pt>
                <c:pt idx="705">
                  <c:v>1836</c:v>
                </c:pt>
                <c:pt idx="706">
                  <c:v>1836</c:v>
                </c:pt>
                <c:pt idx="707">
                  <c:v>1854</c:v>
                </c:pt>
                <c:pt idx="708">
                  <c:v>1854</c:v>
                </c:pt>
                <c:pt idx="709">
                  <c:v>1855</c:v>
                </c:pt>
                <c:pt idx="710">
                  <c:v>1855</c:v>
                </c:pt>
                <c:pt idx="711">
                  <c:v>1856</c:v>
                </c:pt>
                <c:pt idx="712">
                  <c:v>1856</c:v>
                </c:pt>
                <c:pt idx="713">
                  <c:v>1867</c:v>
                </c:pt>
                <c:pt idx="714">
                  <c:v>1867</c:v>
                </c:pt>
                <c:pt idx="715">
                  <c:v>1878</c:v>
                </c:pt>
                <c:pt idx="716">
                  <c:v>1878</c:v>
                </c:pt>
                <c:pt idx="717">
                  <c:v>1891</c:v>
                </c:pt>
                <c:pt idx="718">
                  <c:v>1903</c:v>
                </c:pt>
                <c:pt idx="719">
                  <c:v>1903</c:v>
                </c:pt>
                <c:pt idx="720">
                  <c:v>1920</c:v>
                </c:pt>
                <c:pt idx="721">
                  <c:v>1920</c:v>
                </c:pt>
                <c:pt idx="722">
                  <c:v>1922.7026949074061</c:v>
                </c:pt>
                <c:pt idx="723">
                  <c:v>1938.7026949074061</c:v>
                </c:pt>
                <c:pt idx="724">
                  <c:v>1960</c:v>
                </c:pt>
                <c:pt idx="725">
                  <c:v>1960</c:v>
                </c:pt>
                <c:pt idx="726">
                  <c:v>2020</c:v>
                </c:pt>
                <c:pt idx="727">
                  <c:v>2020</c:v>
                </c:pt>
                <c:pt idx="728">
                  <c:v>2022</c:v>
                </c:pt>
                <c:pt idx="729">
                  <c:v>2022</c:v>
                </c:pt>
                <c:pt idx="730">
                  <c:v>2031</c:v>
                </c:pt>
                <c:pt idx="731">
                  <c:v>2031</c:v>
                </c:pt>
                <c:pt idx="732">
                  <c:v>2035</c:v>
                </c:pt>
                <c:pt idx="733">
                  <c:v>2058</c:v>
                </c:pt>
                <c:pt idx="734">
                  <c:v>2058</c:v>
                </c:pt>
                <c:pt idx="735">
                  <c:v>2085</c:v>
                </c:pt>
                <c:pt idx="736">
                  <c:v>2085</c:v>
                </c:pt>
                <c:pt idx="737">
                  <c:v>2089</c:v>
                </c:pt>
                <c:pt idx="738">
                  <c:v>2089</c:v>
                </c:pt>
                <c:pt idx="739">
                  <c:v>2187</c:v>
                </c:pt>
                <c:pt idx="740">
                  <c:v>2187</c:v>
                </c:pt>
                <c:pt idx="741">
                  <c:v>2225</c:v>
                </c:pt>
                <c:pt idx="742">
                  <c:v>2225.7026949074061</c:v>
                </c:pt>
                <c:pt idx="743">
                  <c:v>2227</c:v>
                </c:pt>
                <c:pt idx="744">
                  <c:v>2232.7026949074061</c:v>
                </c:pt>
                <c:pt idx="745">
                  <c:v>2239</c:v>
                </c:pt>
                <c:pt idx="746">
                  <c:v>2239</c:v>
                </c:pt>
                <c:pt idx="747">
                  <c:v>2247</c:v>
                </c:pt>
                <c:pt idx="748">
                  <c:v>2247</c:v>
                </c:pt>
                <c:pt idx="749">
                  <c:v>2262.7026949074061</c:v>
                </c:pt>
                <c:pt idx="750">
                  <c:v>2324</c:v>
                </c:pt>
                <c:pt idx="751">
                  <c:v>2324</c:v>
                </c:pt>
                <c:pt idx="752">
                  <c:v>2353</c:v>
                </c:pt>
                <c:pt idx="753">
                  <c:v>2353</c:v>
                </c:pt>
                <c:pt idx="754">
                  <c:v>2378</c:v>
                </c:pt>
                <c:pt idx="755">
                  <c:v>2393.7026949074061</c:v>
                </c:pt>
                <c:pt idx="756">
                  <c:v>2410</c:v>
                </c:pt>
                <c:pt idx="757">
                  <c:v>2422</c:v>
                </c:pt>
                <c:pt idx="758">
                  <c:v>2422</c:v>
                </c:pt>
                <c:pt idx="759">
                  <c:v>2445</c:v>
                </c:pt>
                <c:pt idx="760">
                  <c:v>2445</c:v>
                </c:pt>
                <c:pt idx="761">
                  <c:v>2473</c:v>
                </c:pt>
                <c:pt idx="762">
                  <c:v>2473</c:v>
                </c:pt>
                <c:pt idx="763">
                  <c:v>2475</c:v>
                </c:pt>
                <c:pt idx="764">
                  <c:v>2475</c:v>
                </c:pt>
                <c:pt idx="765">
                  <c:v>2483</c:v>
                </c:pt>
                <c:pt idx="766">
                  <c:v>2487</c:v>
                </c:pt>
                <c:pt idx="767">
                  <c:v>2487</c:v>
                </c:pt>
                <c:pt idx="768">
                  <c:v>2513.7026949074061</c:v>
                </c:pt>
                <c:pt idx="769">
                  <c:v>2516</c:v>
                </c:pt>
                <c:pt idx="770">
                  <c:v>2516</c:v>
                </c:pt>
                <c:pt idx="771">
                  <c:v>2555</c:v>
                </c:pt>
                <c:pt idx="772">
                  <c:v>2555</c:v>
                </c:pt>
                <c:pt idx="773">
                  <c:v>2596</c:v>
                </c:pt>
                <c:pt idx="774">
                  <c:v>2596</c:v>
                </c:pt>
                <c:pt idx="775">
                  <c:v>2648</c:v>
                </c:pt>
                <c:pt idx="776">
                  <c:v>2648</c:v>
                </c:pt>
                <c:pt idx="777">
                  <c:v>2657</c:v>
                </c:pt>
                <c:pt idx="778">
                  <c:v>2657</c:v>
                </c:pt>
                <c:pt idx="779">
                  <c:v>2702.7026949074061</c:v>
                </c:pt>
                <c:pt idx="780">
                  <c:v>2709.7026949074061</c:v>
                </c:pt>
                <c:pt idx="781">
                  <c:v>2755</c:v>
                </c:pt>
                <c:pt idx="782">
                  <c:v>2755</c:v>
                </c:pt>
                <c:pt idx="783">
                  <c:v>2796</c:v>
                </c:pt>
                <c:pt idx="784">
                  <c:v>2824</c:v>
                </c:pt>
                <c:pt idx="785">
                  <c:v>2849</c:v>
                </c:pt>
                <c:pt idx="786">
                  <c:v>2849</c:v>
                </c:pt>
                <c:pt idx="787">
                  <c:v>2851</c:v>
                </c:pt>
                <c:pt idx="788">
                  <c:v>2851</c:v>
                </c:pt>
                <c:pt idx="789">
                  <c:v>2895</c:v>
                </c:pt>
                <c:pt idx="790">
                  <c:v>2895</c:v>
                </c:pt>
                <c:pt idx="791">
                  <c:v>2967.7026949074061</c:v>
                </c:pt>
                <c:pt idx="792">
                  <c:v>2999</c:v>
                </c:pt>
                <c:pt idx="793">
                  <c:v>2999</c:v>
                </c:pt>
                <c:pt idx="794">
                  <c:v>3012</c:v>
                </c:pt>
                <c:pt idx="795">
                  <c:v>3012</c:v>
                </c:pt>
                <c:pt idx="796">
                  <c:v>3017.7026949074061</c:v>
                </c:pt>
                <c:pt idx="797">
                  <c:v>3055</c:v>
                </c:pt>
                <c:pt idx="798">
                  <c:v>3055</c:v>
                </c:pt>
                <c:pt idx="799">
                  <c:v>3076</c:v>
                </c:pt>
                <c:pt idx="800">
                  <c:v>3076</c:v>
                </c:pt>
                <c:pt idx="801">
                  <c:v>3107.7026949074061</c:v>
                </c:pt>
                <c:pt idx="802">
                  <c:v>3163.7026949074061</c:v>
                </c:pt>
                <c:pt idx="803">
                  <c:v>3181</c:v>
                </c:pt>
                <c:pt idx="804">
                  <c:v>3181</c:v>
                </c:pt>
                <c:pt idx="805">
                  <c:v>3211.7026949074061</c:v>
                </c:pt>
                <c:pt idx="806">
                  <c:v>3328</c:v>
                </c:pt>
                <c:pt idx="807">
                  <c:v>3342</c:v>
                </c:pt>
                <c:pt idx="808">
                  <c:v>3342</c:v>
                </c:pt>
                <c:pt idx="809">
                  <c:v>3437.7026949074061</c:v>
                </c:pt>
                <c:pt idx="810">
                  <c:v>3463</c:v>
                </c:pt>
                <c:pt idx="811">
                  <c:v>3463</c:v>
                </c:pt>
                <c:pt idx="812">
                  <c:v>3668</c:v>
                </c:pt>
                <c:pt idx="813">
                  <c:v>3668</c:v>
                </c:pt>
                <c:pt idx="814">
                  <c:v>3772.7026949074061</c:v>
                </c:pt>
                <c:pt idx="815">
                  <c:v>3806</c:v>
                </c:pt>
                <c:pt idx="816">
                  <c:v>3806</c:v>
                </c:pt>
                <c:pt idx="817">
                  <c:v>3892.7026949074061</c:v>
                </c:pt>
                <c:pt idx="818">
                  <c:v>3991</c:v>
                </c:pt>
                <c:pt idx="819">
                  <c:v>3991</c:v>
                </c:pt>
                <c:pt idx="820">
                  <c:v>4029.7026949074061</c:v>
                </c:pt>
                <c:pt idx="821">
                  <c:v>4050</c:v>
                </c:pt>
                <c:pt idx="822">
                  <c:v>4141.7026949074061</c:v>
                </c:pt>
                <c:pt idx="823">
                  <c:v>4175</c:v>
                </c:pt>
                <c:pt idx="824">
                  <c:v>4175</c:v>
                </c:pt>
                <c:pt idx="825">
                  <c:v>4213.7026949074061</c:v>
                </c:pt>
                <c:pt idx="826">
                  <c:v>4733.7026949074061</c:v>
                </c:pt>
                <c:pt idx="827">
                  <c:v>4750</c:v>
                </c:pt>
                <c:pt idx="828">
                  <c:v>4750</c:v>
                </c:pt>
                <c:pt idx="829">
                  <c:v>5061.7026949074061</c:v>
                </c:pt>
                <c:pt idx="830">
                  <c:v>6038</c:v>
                </c:pt>
                <c:pt idx="831">
                  <c:v>6038</c:v>
                </c:pt>
              </c:numCache>
            </c:numRef>
          </c:xVal>
          <c:yVal>
            <c:numRef>
              <c:f>Sheet3!$E$906:$E$1737</c:f>
              <c:numCache>
                <c:formatCode>0.0000</c:formatCode>
                <c:ptCount val="832"/>
                <c:pt idx="0">
                  <c:v>1</c:v>
                </c:pt>
                <c:pt idx="1">
                  <c:v>1</c:v>
                </c:pt>
                <c:pt idx="2">
                  <c:v>1</c:v>
                </c:pt>
                <c:pt idx="3" formatCode="General">
                  <c:v>1</c:v>
                </c:pt>
                <c:pt idx="4">
                  <c:v>0.99815837937384899</c:v>
                </c:pt>
                <c:pt idx="5">
                  <c:v>0.99815837937384899</c:v>
                </c:pt>
                <c:pt idx="6" formatCode="General">
                  <c:v>0.99815837937384899</c:v>
                </c:pt>
                <c:pt idx="7">
                  <c:v>0.99446832991220813</c:v>
                </c:pt>
                <c:pt idx="8" formatCode="General">
                  <c:v>0.99446832991220813</c:v>
                </c:pt>
                <c:pt idx="9">
                  <c:v>0.99262330518138764</c:v>
                </c:pt>
                <c:pt idx="10" formatCode="General">
                  <c:v>0.99262330518138764</c:v>
                </c:pt>
                <c:pt idx="11">
                  <c:v>0.99077484465032351</c:v>
                </c:pt>
                <c:pt idx="12" formatCode="General">
                  <c:v>0.99077484465032351</c:v>
                </c:pt>
                <c:pt idx="13">
                  <c:v>0.98892638411925948</c:v>
                </c:pt>
                <c:pt idx="14" formatCode="General">
                  <c:v>0.98892638411925948</c:v>
                </c:pt>
                <c:pt idx="15">
                  <c:v>0.98707446205162042</c:v>
                </c:pt>
                <c:pt idx="16" formatCode="General">
                  <c:v>0.98707446205162042</c:v>
                </c:pt>
                <c:pt idx="17">
                  <c:v>0.98521905892746331</c:v>
                </c:pt>
                <c:pt idx="18" formatCode="General">
                  <c:v>0.98521905892746331</c:v>
                </c:pt>
                <c:pt idx="19">
                  <c:v>0.98336015504269447</c:v>
                </c:pt>
                <c:pt idx="20">
                  <c:v>0.98336015504269447</c:v>
                </c:pt>
                <c:pt idx="21" formatCode="General">
                  <c:v>0.98336015504269447</c:v>
                </c:pt>
                <c:pt idx="22">
                  <c:v>0.98149419649422631</c:v>
                </c:pt>
                <c:pt idx="23" formatCode="General">
                  <c:v>0.98149419649422631</c:v>
                </c:pt>
                <c:pt idx="24">
                  <c:v>0.97962823794575826</c:v>
                </c:pt>
                <c:pt idx="25" formatCode="General">
                  <c:v>0.97962823794575826</c:v>
                </c:pt>
                <c:pt idx="26">
                  <c:v>0.97776227939729021</c:v>
                </c:pt>
                <c:pt idx="27">
                  <c:v>0.97776227939729021</c:v>
                </c:pt>
                <c:pt idx="28" formatCode="General">
                  <c:v>0.97776227939729021</c:v>
                </c:pt>
                <c:pt idx="29">
                  <c:v>0.97589275305045031</c:v>
                </c:pt>
                <c:pt idx="30">
                  <c:v>0.97589275305045031</c:v>
                </c:pt>
                <c:pt idx="31" formatCode="General">
                  <c:v>0.97589275305045031</c:v>
                </c:pt>
                <c:pt idx="32">
                  <c:v>0.97213931938487164</c:v>
                </c:pt>
                <c:pt idx="33" formatCode="General">
                  <c:v>0.97213931938487164</c:v>
                </c:pt>
                <c:pt idx="34">
                  <c:v>0.9683786256928606</c:v>
                </c:pt>
                <c:pt idx="35">
                  <c:v>0.9683786256928606</c:v>
                </c:pt>
                <c:pt idx="36" formatCode="General">
                  <c:v>0.9683786256928606</c:v>
                </c:pt>
                <c:pt idx="37">
                  <c:v>0.96649462058450875</c:v>
                </c:pt>
                <c:pt idx="38" formatCode="General">
                  <c:v>0.96649462058450875</c:v>
                </c:pt>
                <c:pt idx="39">
                  <c:v>0.96461061547615679</c:v>
                </c:pt>
                <c:pt idx="40" formatCode="General">
                  <c:v>0.96461061547615679</c:v>
                </c:pt>
                <c:pt idx="41">
                  <c:v>0.96272661036780494</c:v>
                </c:pt>
                <c:pt idx="42">
                  <c:v>0.96272661036780494</c:v>
                </c:pt>
                <c:pt idx="43" formatCode="General">
                  <c:v>0.96272661036780494</c:v>
                </c:pt>
                <c:pt idx="44">
                  <c:v>0.96083520248888987</c:v>
                </c:pt>
                <c:pt idx="45" formatCode="General">
                  <c:v>0.96083520248888987</c:v>
                </c:pt>
                <c:pt idx="46">
                  <c:v>0.9589437946099747</c:v>
                </c:pt>
                <c:pt idx="47" formatCode="General">
                  <c:v>0.9589437946099747</c:v>
                </c:pt>
                <c:pt idx="48">
                  <c:v>0.95704864877082452</c:v>
                </c:pt>
                <c:pt idx="49" formatCode="General">
                  <c:v>0.95704864877082452</c:v>
                </c:pt>
                <c:pt idx="50">
                  <c:v>0.95515350293167434</c:v>
                </c:pt>
                <c:pt idx="51" formatCode="General">
                  <c:v>0.95515350293167434</c:v>
                </c:pt>
                <c:pt idx="52">
                  <c:v>0.95325835709252416</c:v>
                </c:pt>
                <c:pt idx="53" formatCode="General">
                  <c:v>0.95325835709252416</c:v>
                </c:pt>
                <c:pt idx="54">
                  <c:v>0.94946051503239459</c:v>
                </c:pt>
                <c:pt idx="55" formatCode="General">
                  <c:v>0.94946051503239459</c:v>
                </c:pt>
                <c:pt idx="56">
                  <c:v>0.94565506206633287</c:v>
                </c:pt>
                <c:pt idx="57" formatCode="General">
                  <c:v>0.94565506206633287</c:v>
                </c:pt>
                <c:pt idx="58">
                  <c:v>0.94184960910027116</c:v>
                </c:pt>
                <c:pt idx="59" formatCode="General">
                  <c:v>0.94184960910027116</c:v>
                </c:pt>
                <c:pt idx="60">
                  <c:v>0.93994688261724024</c:v>
                </c:pt>
                <c:pt idx="61" formatCode="General">
                  <c:v>0.93994688261724024</c:v>
                </c:pt>
                <c:pt idx="62">
                  <c:v>0.93423870316814772</c:v>
                </c:pt>
                <c:pt idx="63" formatCode="General">
                  <c:v>0.93423870316814772</c:v>
                </c:pt>
                <c:pt idx="64">
                  <c:v>0.93233597668511681</c:v>
                </c:pt>
                <c:pt idx="65" formatCode="General">
                  <c:v>0.93233597668511681</c:v>
                </c:pt>
                <c:pt idx="66">
                  <c:v>0.93043325020208589</c:v>
                </c:pt>
                <c:pt idx="67" formatCode="General">
                  <c:v>0.93043325020208589</c:v>
                </c:pt>
                <c:pt idx="68">
                  <c:v>0.92852662468937675</c:v>
                </c:pt>
                <c:pt idx="69">
                  <c:v>0.92852662468937675</c:v>
                </c:pt>
                <c:pt idx="70" formatCode="General">
                  <c:v>0.92852662468937675</c:v>
                </c:pt>
                <c:pt idx="71">
                  <c:v>0.92470552746843282</c:v>
                </c:pt>
                <c:pt idx="72">
                  <c:v>0.92470552746843282</c:v>
                </c:pt>
                <c:pt idx="73" formatCode="General">
                  <c:v>0.92470552746843282</c:v>
                </c:pt>
                <c:pt idx="74">
                  <c:v>0.92279102327077556</c:v>
                </c:pt>
                <c:pt idx="75" formatCode="General">
                  <c:v>0.92279102327077556</c:v>
                </c:pt>
                <c:pt idx="76">
                  <c:v>0.92087253881491116</c:v>
                </c:pt>
                <c:pt idx="77" formatCode="General">
                  <c:v>0.92087253881491116</c:v>
                </c:pt>
                <c:pt idx="78">
                  <c:v>0.91895405435904676</c:v>
                </c:pt>
                <c:pt idx="79" formatCode="General">
                  <c:v>0.91895405435904676</c:v>
                </c:pt>
                <c:pt idx="80">
                  <c:v>0.91511708544731796</c:v>
                </c:pt>
                <c:pt idx="81" formatCode="General">
                  <c:v>0.91511708544731796</c:v>
                </c:pt>
                <c:pt idx="82">
                  <c:v>0.91319860099145356</c:v>
                </c:pt>
                <c:pt idx="83" formatCode="General">
                  <c:v>0.91319860099145356</c:v>
                </c:pt>
                <c:pt idx="84">
                  <c:v>0.91128011653558916</c:v>
                </c:pt>
                <c:pt idx="85" formatCode="General">
                  <c:v>0.91128011653558916</c:v>
                </c:pt>
                <c:pt idx="86">
                  <c:v>0.90744314762386036</c:v>
                </c:pt>
                <c:pt idx="87">
                  <c:v>0.90744314762386036</c:v>
                </c:pt>
                <c:pt idx="88" formatCode="General">
                  <c:v>0.90744314762386036</c:v>
                </c:pt>
                <c:pt idx="89">
                  <c:v>0.90551651673718547</c:v>
                </c:pt>
                <c:pt idx="90" formatCode="General">
                  <c:v>0.90551651673718547</c:v>
                </c:pt>
                <c:pt idx="91">
                  <c:v>0.9035898858505107</c:v>
                </c:pt>
                <c:pt idx="92" formatCode="General">
                  <c:v>0.9035898858505107</c:v>
                </c:pt>
                <c:pt idx="93">
                  <c:v>0.89973662407716093</c:v>
                </c:pt>
                <c:pt idx="94" formatCode="General">
                  <c:v>0.89973662407716093</c:v>
                </c:pt>
                <c:pt idx="95">
                  <c:v>0.89395673141713627</c:v>
                </c:pt>
                <c:pt idx="96" formatCode="General">
                  <c:v>0.89395673141713627</c:v>
                </c:pt>
                <c:pt idx="97">
                  <c:v>0.89203010053046139</c:v>
                </c:pt>
                <c:pt idx="98" formatCode="General">
                  <c:v>0.89203010053046139</c:v>
                </c:pt>
                <c:pt idx="99">
                  <c:v>0.8901034696437865</c:v>
                </c:pt>
                <c:pt idx="100" formatCode="General">
                  <c:v>0.8901034696437865</c:v>
                </c:pt>
                <c:pt idx="101">
                  <c:v>0.88817683875711162</c:v>
                </c:pt>
                <c:pt idx="102" formatCode="General">
                  <c:v>0.88817683875711162</c:v>
                </c:pt>
                <c:pt idx="103">
                  <c:v>0.88625020787043685</c:v>
                </c:pt>
                <c:pt idx="104" formatCode="General">
                  <c:v>0.88625020787043685</c:v>
                </c:pt>
                <c:pt idx="105">
                  <c:v>0.88238855119126292</c:v>
                </c:pt>
                <c:pt idx="106" formatCode="General">
                  <c:v>0.88238855119126292</c:v>
                </c:pt>
                <c:pt idx="107">
                  <c:v>0.87852689451208887</c:v>
                </c:pt>
                <c:pt idx="108" formatCode="General">
                  <c:v>0.87852689451208887</c:v>
                </c:pt>
                <c:pt idx="109">
                  <c:v>0.87659606617250185</c:v>
                </c:pt>
                <c:pt idx="110" formatCode="General">
                  <c:v>0.87659606617250185</c:v>
                </c:pt>
                <c:pt idx="111">
                  <c:v>0.87466523783291483</c:v>
                </c:pt>
                <c:pt idx="112" formatCode="General">
                  <c:v>0.87466523783291483</c:v>
                </c:pt>
                <c:pt idx="113">
                  <c:v>0.87273440949332781</c:v>
                </c:pt>
                <c:pt idx="114" formatCode="General">
                  <c:v>0.87273440949332781</c:v>
                </c:pt>
                <c:pt idx="115">
                  <c:v>0.86887275281415377</c:v>
                </c:pt>
                <c:pt idx="116" formatCode="General">
                  <c:v>0.86887275281415377</c:v>
                </c:pt>
                <c:pt idx="117">
                  <c:v>0.86694192447456675</c:v>
                </c:pt>
                <c:pt idx="118" formatCode="General">
                  <c:v>0.86694192447456675</c:v>
                </c:pt>
                <c:pt idx="119">
                  <c:v>0.86501109613497973</c:v>
                </c:pt>
                <c:pt idx="120" formatCode="General">
                  <c:v>0.86501109613497973</c:v>
                </c:pt>
                <c:pt idx="121">
                  <c:v>0.86308026779539271</c:v>
                </c:pt>
                <c:pt idx="122" formatCode="General">
                  <c:v>0.86308026779539271</c:v>
                </c:pt>
                <c:pt idx="123">
                  <c:v>0.86114943945580569</c:v>
                </c:pt>
                <c:pt idx="124" formatCode="General">
                  <c:v>0.86114943945580569</c:v>
                </c:pt>
                <c:pt idx="125">
                  <c:v>0.85921861111621867</c:v>
                </c:pt>
                <c:pt idx="126" formatCode="General">
                  <c:v>0.85921861111621867</c:v>
                </c:pt>
                <c:pt idx="127">
                  <c:v>0.85728778277663165</c:v>
                </c:pt>
                <c:pt idx="128" formatCode="General">
                  <c:v>0.85728778277663165</c:v>
                </c:pt>
                <c:pt idx="129">
                  <c:v>0.85341740903949104</c:v>
                </c:pt>
                <c:pt idx="130" formatCode="General">
                  <c:v>0.85341740903949104</c:v>
                </c:pt>
                <c:pt idx="131">
                  <c:v>0.85148222217092073</c:v>
                </c:pt>
                <c:pt idx="132" formatCode="General">
                  <c:v>0.85148222217092073</c:v>
                </c:pt>
                <c:pt idx="133">
                  <c:v>0.84954703530235043</c:v>
                </c:pt>
                <c:pt idx="134" formatCode="General">
                  <c:v>0.84954703530235043</c:v>
                </c:pt>
                <c:pt idx="135">
                  <c:v>0.84761184843378012</c:v>
                </c:pt>
                <c:pt idx="136" formatCode="General">
                  <c:v>0.84761184843378012</c:v>
                </c:pt>
                <c:pt idx="137">
                  <c:v>0.84567223321997287</c:v>
                </c:pt>
                <c:pt idx="138" formatCode="General">
                  <c:v>0.84567223321997287</c:v>
                </c:pt>
                <c:pt idx="139">
                  <c:v>0.84372815912061661</c:v>
                </c:pt>
                <c:pt idx="140" formatCode="General">
                  <c:v>0.84372815912061661</c:v>
                </c:pt>
                <c:pt idx="141">
                  <c:v>0.84178408502126034</c:v>
                </c:pt>
                <c:pt idx="142" formatCode="General">
                  <c:v>0.84178408502126034</c:v>
                </c:pt>
                <c:pt idx="143">
                  <c:v>0.83983551075037788</c:v>
                </c:pt>
                <c:pt idx="144" formatCode="General">
                  <c:v>0.83983551075037788</c:v>
                </c:pt>
                <c:pt idx="145">
                  <c:v>0.83788693647949541</c:v>
                </c:pt>
                <c:pt idx="146" formatCode="General">
                  <c:v>0.83788693647949541</c:v>
                </c:pt>
                <c:pt idx="147">
                  <c:v>0.83398978793773038</c:v>
                </c:pt>
                <c:pt idx="148" formatCode="General">
                  <c:v>0.83398978793773038</c:v>
                </c:pt>
                <c:pt idx="149">
                  <c:v>0.8320412136668478</c:v>
                </c:pt>
                <c:pt idx="150" formatCode="General">
                  <c:v>0.8320412136668478</c:v>
                </c:pt>
                <c:pt idx="151">
                  <c:v>0.83009263939596523</c:v>
                </c:pt>
                <c:pt idx="152" formatCode="General">
                  <c:v>0.83009263939596523</c:v>
                </c:pt>
                <c:pt idx="153">
                  <c:v>0.82814406512508265</c:v>
                </c:pt>
                <c:pt idx="154" formatCode="General">
                  <c:v>0.82814406512508265</c:v>
                </c:pt>
                <c:pt idx="155">
                  <c:v>0.8242469165833175</c:v>
                </c:pt>
                <c:pt idx="156" formatCode="General">
                  <c:v>0.8242469165833175</c:v>
                </c:pt>
                <c:pt idx="157">
                  <c:v>0.82229834231243493</c:v>
                </c:pt>
                <c:pt idx="158" formatCode="General">
                  <c:v>0.82229834231243493</c:v>
                </c:pt>
                <c:pt idx="159">
                  <c:v>0.82034976804155235</c:v>
                </c:pt>
                <c:pt idx="160" formatCode="General">
                  <c:v>0.82034976804155235</c:v>
                </c:pt>
                <c:pt idx="161">
                  <c:v>0.81840119377066978</c:v>
                </c:pt>
                <c:pt idx="162" formatCode="General">
                  <c:v>0.81840119377066978</c:v>
                </c:pt>
                <c:pt idx="163">
                  <c:v>0.8164526194997872</c:v>
                </c:pt>
                <c:pt idx="164" formatCode="General">
                  <c:v>0.8164526194997872</c:v>
                </c:pt>
                <c:pt idx="165">
                  <c:v>0.81450404522890463</c:v>
                </c:pt>
                <c:pt idx="166">
                  <c:v>0.81450404522890463</c:v>
                </c:pt>
                <c:pt idx="167" formatCode="General">
                  <c:v>0.81450404522890463</c:v>
                </c:pt>
                <c:pt idx="168">
                  <c:v>0.81255079811804398</c:v>
                </c:pt>
                <c:pt idx="169" formatCode="General">
                  <c:v>0.81255079811804398</c:v>
                </c:pt>
                <c:pt idx="170">
                  <c:v>0.80864430389632258</c:v>
                </c:pt>
                <c:pt idx="171" formatCode="General">
                  <c:v>0.80864430389632258</c:v>
                </c:pt>
                <c:pt idx="172">
                  <c:v>0.80669105678546194</c:v>
                </c:pt>
                <c:pt idx="173" formatCode="General">
                  <c:v>0.80669105678546194</c:v>
                </c:pt>
                <c:pt idx="174">
                  <c:v>0.80473780967460118</c:v>
                </c:pt>
                <c:pt idx="175">
                  <c:v>0.80473780967460118</c:v>
                </c:pt>
                <c:pt idx="176" formatCode="General">
                  <c:v>0.80473780967460118</c:v>
                </c:pt>
                <c:pt idx="177">
                  <c:v>0.80277981013767996</c:v>
                </c:pt>
                <c:pt idx="178">
                  <c:v>0.80277981013767996</c:v>
                </c:pt>
                <c:pt idx="179" formatCode="General">
                  <c:v>0.80277981013767996</c:v>
                </c:pt>
                <c:pt idx="180">
                  <c:v>0.80081702331582749</c:v>
                </c:pt>
                <c:pt idx="181" formatCode="General">
                  <c:v>0.80081702331582749</c:v>
                </c:pt>
                <c:pt idx="182">
                  <c:v>0.79885423649397502</c:v>
                </c:pt>
                <c:pt idx="183" formatCode="General">
                  <c:v>0.79885423649397502</c:v>
                </c:pt>
                <c:pt idx="184">
                  <c:v>0.79689144967212255</c:v>
                </c:pt>
                <c:pt idx="185" formatCode="General">
                  <c:v>0.79689144967212255</c:v>
                </c:pt>
                <c:pt idx="186">
                  <c:v>0.79492866285026997</c:v>
                </c:pt>
                <c:pt idx="187">
                  <c:v>0.79492866285026997</c:v>
                </c:pt>
                <c:pt idx="188" formatCode="General">
                  <c:v>0.79492866285026997</c:v>
                </c:pt>
                <c:pt idx="189">
                  <c:v>0.792961017645195</c:v>
                </c:pt>
                <c:pt idx="190" formatCode="General">
                  <c:v>0.792961017645195</c:v>
                </c:pt>
                <c:pt idx="191">
                  <c:v>0.79099337244012002</c:v>
                </c:pt>
                <c:pt idx="192" formatCode="General">
                  <c:v>0.79099337244012002</c:v>
                </c:pt>
                <c:pt idx="193">
                  <c:v>0.78902572723504505</c:v>
                </c:pt>
                <c:pt idx="194" formatCode="General">
                  <c:v>0.78902572723504505</c:v>
                </c:pt>
                <c:pt idx="195">
                  <c:v>0.78705808202997019</c:v>
                </c:pt>
                <c:pt idx="196" formatCode="General">
                  <c:v>0.78705808202997019</c:v>
                </c:pt>
                <c:pt idx="197">
                  <c:v>0.78508550538327848</c:v>
                </c:pt>
                <c:pt idx="198" formatCode="General">
                  <c:v>0.78508550538327848</c:v>
                </c:pt>
                <c:pt idx="199">
                  <c:v>0.78114035208989518</c:v>
                </c:pt>
                <c:pt idx="200" formatCode="General">
                  <c:v>0.78114035208989518</c:v>
                </c:pt>
                <c:pt idx="201">
                  <c:v>0.77916777544320359</c:v>
                </c:pt>
                <c:pt idx="202">
                  <c:v>0.77916777544320359</c:v>
                </c:pt>
                <c:pt idx="203">
                  <c:v>0.77916777544320359</c:v>
                </c:pt>
                <c:pt idx="204" formatCode="General">
                  <c:v>0.77916777544320359</c:v>
                </c:pt>
                <c:pt idx="205">
                  <c:v>0.77718516023851358</c:v>
                </c:pt>
                <c:pt idx="206" formatCode="General">
                  <c:v>0.77718516023851358</c:v>
                </c:pt>
                <c:pt idx="207">
                  <c:v>0.77520254503382346</c:v>
                </c:pt>
                <c:pt idx="208" formatCode="General">
                  <c:v>0.77520254503382346</c:v>
                </c:pt>
                <c:pt idx="209">
                  <c:v>0.77321992982913335</c:v>
                </c:pt>
                <c:pt idx="210" formatCode="General">
                  <c:v>0.77321992982913335</c:v>
                </c:pt>
                <c:pt idx="211">
                  <c:v>0.77123731462444323</c:v>
                </c:pt>
                <c:pt idx="212" formatCode="General">
                  <c:v>0.77123731462444323</c:v>
                </c:pt>
                <c:pt idx="213">
                  <c:v>0.76727208421506299</c:v>
                </c:pt>
                <c:pt idx="214" formatCode="General">
                  <c:v>0.76727208421506299</c:v>
                </c:pt>
                <c:pt idx="215">
                  <c:v>0.76528946901037298</c:v>
                </c:pt>
                <c:pt idx="216" formatCode="General">
                  <c:v>0.76528946901037298</c:v>
                </c:pt>
                <c:pt idx="217">
                  <c:v>0.76330685380568286</c:v>
                </c:pt>
                <c:pt idx="218" formatCode="General">
                  <c:v>0.76330685380568286</c:v>
                </c:pt>
                <c:pt idx="219">
                  <c:v>0.76132423860099274</c:v>
                </c:pt>
                <c:pt idx="220" formatCode="General">
                  <c:v>0.76132423860099274</c:v>
                </c:pt>
                <c:pt idx="221">
                  <c:v>0.75934162339630273</c:v>
                </c:pt>
                <c:pt idx="222" formatCode="General">
                  <c:v>0.75934162339630273</c:v>
                </c:pt>
                <c:pt idx="223">
                  <c:v>0.75735381809945379</c:v>
                </c:pt>
                <c:pt idx="224" formatCode="General">
                  <c:v>0.75735381809945379</c:v>
                </c:pt>
                <c:pt idx="225">
                  <c:v>0.75536078173603416</c:v>
                </c:pt>
                <c:pt idx="226" formatCode="General">
                  <c:v>0.75536078173603416</c:v>
                </c:pt>
                <c:pt idx="227">
                  <c:v>0.75336774537261453</c:v>
                </c:pt>
                <c:pt idx="228" formatCode="General">
                  <c:v>0.75336774537261453</c:v>
                </c:pt>
                <c:pt idx="229">
                  <c:v>0.7513747090091949</c:v>
                </c:pt>
                <c:pt idx="230">
                  <c:v>0.7513747090091949</c:v>
                </c:pt>
                <c:pt idx="231" formatCode="General">
                  <c:v>0.7513747090091949</c:v>
                </c:pt>
                <c:pt idx="232">
                  <c:v>0.74937637201714924</c:v>
                </c:pt>
                <c:pt idx="233" formatCode="General">
                  <c:v>0.74937637201714924</c:v>
                </c:pt>
                <c:pt idx="234">
                  <c:v>0.74737803502510347</c:v>
                </c:pt>
                <c:pt idx="235" formatCode="General">
                  <c:v>0.74737803502510347</c:v>
                </c:pt>
                <c:pt idx="236">
                  <c:v>0.7453743405612292</c:v>
                </c:pt>
                <c:pt idx="237" formatCode="General">
                  <c:v>0.7453743405612292</c:v>
                </c:pt>
                <c:pt idx="238">
                  <c:v>0.74336524530365178</c:v>
                </c:pt>
                <c:pt idx="239">
                  <c:v>0.74336524530365178</c:v>
                </c:pt>
                <c:pt idx="240" formatCode="General">
                  <c:v>0.74336524530365178</c:v>
                </c:pt>
                <c:pt idx="241">
                  <c:v>0.74135070534347924</c:v>
                </c:pt>
                <c:pt idx="242">
                  <c:v>0.74135070534347924</c:v>
                </c:pt>
                <c:pt idx="243" formatCode="General">
                  <c:v>0.74135070534347924</c:v>
                </c:pt>
                <c:pt idx="244">
                  <c:v>0.73729960859296839</c:v>
                </c:pt>
                <c:pt idx="245" formatCode="General">
                  <c:v>0.73729960859296839</c:v>
                </c:pt>
                <c:pt idx="246">
                  <c:v>0.73527406021771302</c:v>
                </c:pt>
                <c:pt idx="247" formatCode="General">
                  <c:v>0.73527406021771302</c:v>
                </c:pt>
                <c:pt idx="248">
                  <c:v>0.73324851184245754</c:v>
                </c:pt>
                <c:pt idx="249" formatCode="General">
                  <c:v>0.73324851184245754</c:v>
                </c:pt>
                <c:pt idx="250">
                  <c:v>0.73122296346720206</c:v>
                </c:pt>
                <c:pt idx="251" formatCode="General">
                  <c:v>0.73122296346720206</c:v>
                </c:pt>
                <c:pt idx="252">
                  <c:v>0.72919741509194669</c:v>
                </c:pt>
                <c:pt idx="253" formatCode="General">
                  <c:v>0.72919741509194669</c:v>
                </c:pt>
                <c:pt idx="254">
                  <c:v>0.72717186671669132</c:v>
                </c:pt>
                <c:pt idx="255" formatCode="General">
                  <c:v>0.72717186671669132</c:v>
                </c:pt>
                <c:pt idx="256">
                  <c:v>0.72312076996618047</c:v>
                </c:pt>
                <c:pt idx="257" formatCode="General">
                  <c:v>0.72312076996618047</c:v>
                </c:pt>
                <c:pt idx="258">
                  <c:v>0.7210952215909251</c:v>
                </c:pt>
                <c:pt idx="259">
                  <c:v>0.7210952215909251</c:v>
                </c:pt>
                <c:pt idx="260" formatCode="General">
                  <c:v>0.7210952215909251</c:v>
                </c:pt>
                <c:pt idx="261">
                  <c:v>0.71906396744559853</c:v>
                </c:pt>
                <c:pt idx="262" formatCode="General">
                  <c:v>0.71906396744559853</c:v>
                </c:pt>
                <c:pt idx="263">
                  <c:v>0.71498995063287563</c:v>
                </c:pt>
                <c:pt idx="264" formatCode="General">
                  <c:v>0.71498995063287563</c:v>
                </c:pt>
                <c:pt idx="265">
                  <c:v>0.71091593382015272</c:v>
                </c:pt>
                <c:pt idx="266" formatCode="General">
                  <c:v>0.71091593382015272</c:v>
                </c:pt>
                <c:pt idx="267">
                  <c:v>0.70684191700742982</c:v>
                </c:pt>
                <c:pt idx="268" formatCode="General">
                  <c:v>0.70684191700742982</c:v>
                </c:pt>
                <c:pt idx="269">
                  <c:v>0.70480490860106837</c:v>
                </c:pt>
                <c:pt idx="270" formatCode="General">
                  <c:v>0.70480490860106837</c:v>
                </c:pt>
                <c:pt idx="271">
                  <c:v>0.70276199582251464</c:v>
                </c:pt>
                <c:pt idx="272" formatCode="General">
                  <c:v>0.70276199582251464</c:v>
                </c:pt>
                <c:pt idx="273">
                  <c:v>0.69867617026540696</c:v>
                </c:pt>
                <c:pt idx="274" formatCode="General">
                  <c:v>0.69867617026540696</c:v>
                </c:pt>
                <c:pt idx="275">
                  <c:v>0.69663325748685312</c:v>
                </c:pt>
                <c:pt idx="276">
                  <c:v>0.69663325748685312</c:v>
                </c:pt>
                <c:pt idx="277">
                  <c:v>0.69663325748685312</c:v>
                </c:pt>
                <c:pt idx="278">
                  <c:v>0.69663325748685312</c:v>
                </c:pt>
                <c:pt idx="279" formatCode="General">
                  <c:v>0.69663325748685312</c:v>
                </c:pt>
                <c:pt idx="280">
                  <c:v>0.69457221234635946</c:v>
                </c:pt>
                <c:pt idx="281" formatCode="General">
                  <c:v>0.69457221234635946</c:v>
                </c:pt>
                <c:pt idx="282">
                  <c:v>0.69251116720586581</c:v>
                </c:pt>
                <c:pt idx="283" formatCode="General">
                  <c:v>0.69251116720586581</c:v>
                </c:pt>
                <c:pt idx="284">
                  <c:v>0.69045012206537215</c:v>
                </c:pt>
                <c:pt idx="285">
                  <c:v>0.69045012206537215</c:v>
                </c:pt>
                <c:pt idx="286" formatCode="General">
                  <c:v>0.69045012206537215</c:v>
                </c:pt>
                <c:pt idx="287">
                  <c:v>0.68838290613104469</c:v>
                </c:pt>
                <c:pt idx="288" formatCode="General">
                  <c:v>0.68838290613104469</c:v>
                </c:pt>
                <c:pt idx="289">
                  <c:v>0.68631569019671723</c:v>
                </c:pt>
                <c:pt idx="290" formatCode="General">
                  <c:v>0.68631569019671723</c:v>
                </c:pt>
                <c:pt idx="291">
                  <c:v>0.68424847426238977</c:v>
                </c:pt>
                <c:pt idx="292">
                  <c:v>0.68424847426238977</c:v>
                </c:pt>
                <c:pt idx="293" formatCode="General">
                  <c:v>0.68424847426238977</c:v>
                </c:pt>
                <c:pt idx="294">
                  <c:v>0.68010151381231465</c:v>
                </c:pt>
                <c:pt idx="295" formatCode="General">
                  <c:v>0.68010151381231465</c:v>
                </c:pt>
                <c:pt idx="296">
                  <c:v>0.67802803358727715</c:v>
                </c:pt>
                <c:pt idx="297" formatCode="General">
                  <c:v>0.67802803358727715</c:v>
                </c:pt>
                <c:pt idx="298">
                  <c:v>0.67595455336223964</c:v>
                </c:pt>
                <c:pt idx="299" formatCode="General">
                  <c:v>0.67595455336223964</c:v>
                </c:pt>
                <c:pt idx="300">
                  <c:v>0.67388107313720214</c:v>
                </c:pt>
                <c:pt idx="301" formatCode="General">
                  <c:v>0.67388107313720214</c:v>
                </c:pt>
                <c:pt idx="302">
                  <c:v>0.67180759291216463</c:v>
                </c:pt>
                <c:pt idx="303" formatCode="General">
                  <c:v>0.67180759291216463</c:v>
                </c:pt>
                <c:pt idx="304">
                  <c:v>0.66973411268712713</c:v>
                </c:pt>
                <c:pt idx="305" formatCode="General">
                  <c:v>0.66973411268712713</c:v>
                </c:pt>
                <c:pt idx="306">
                  <c:v>0.66766063246208951</c:v>
                </c:pt>
                <c:pt idx="307" formatCode="General">
                  <c:v>0.66766063246208951</c:v>
                </c:pt>
                <c:pt idx="308">
                  <c:v>0.665587152237052</c:v>
                </c:pt>
                <c:pt idx="309">
                  <c:v>0.665587152237052</c:v>
                </c:pt>
                <c:pt idx="310" formatCode="General">
                  <c:v>0.665587152237052</c:v>
                </c:pt>
                <c:pt idx="311">
                  <c:v>0.66350719238631117</c:v>
                </c:pt>
                <c:pt idx="312" formatCode="General">
                  <c:v>0.66350719238631117</c:v>
                </c:pt>
                <c:pt idx="313">
                  <c:v>0.66142723253557034</c:v>
                </c:pt>
                <c:pt idx="314" formatCode="General">
                  <c:v>0.66142723253557034</c:v>
                </c:pt>
                <c:pt idx="315">
                  <c:v>0.65934727268482951</c:v>
                </c:pt>
                <c:pt idx="316">
                  <c:v>0.65934727268482951</c:v>
                </c:pt>
                <c:pt idx="317" formatCode="General">
                  <c:v>0.65934727268482951</c:v>
                </c:pt>
                <c:pt idx="318">
                  <c:v>0.65726073068266233</c:v>
                </c:pt>
                <c:pt idx="319" formatCode="General">
                  <c:v>0.65726073068266233</c:v>
                </c:pt>
                <c:pt idx="320">
                  <c:v>0.65517418868049515</c:v>
                </c:pt>
                <c:pt idx="321" formatCode="General">
                  <c:v>0.65517418868049515</c:v>
                </c:pt>
                <c:pt idx="322">
                  <c:v>0.65100110467616079</c:v>
                </c:pt>
                <c:pt idx="323" formatCode="General">
                  <c:v>0.65100110467616079</c:v>
                </c:pt>
                <c:pt idx="324">
                  <c:v>0.64891456267399361</c:v>
                </c:pt>
                <c:pt idx="325">
                  <c:v>0.64891456267399361</c:v>
                </c:pt>
                <c:pt idx="326">
                  <c:v>0.64891456267399361</c:v>
                </c:pt>
                <c:pt idx="327" formatCode="General">
                  <c:v>0.64891456267399361</c:v>
                </c:pt>
                <c:pt idx="328">
                  <c:v>0.64681451554559888</c:v>
                </c:pt>
                <c:pt idx="329">
                  <c:v>0.64681451554559888</c:v>
                </c:pt>
                <c:pt idx="330" formatCode="General">
                  <c:v>0.64681451554559888</c:v>
                </c:pt>
                <c:pt idx="331">
                  <c:v>0.64470762787281188</c:v>
                </c:pt>
                <c:pt idx="332" formatCode="General">
                  <c:v>0.64470762787281188</c:v>
                </c:pt>
                <c:pt idx="333">
                  <c:v>0.64260074020002489</c:v>
                </c:pt>
                <c:pt idx="334" formatCode="General">
                  <c:v>0.64260074020002489</c:v>
                </c:pt>
                <c:pt idx="335">
                  <c:v>0.64048692197568269</c:v>
                </c:pt>
                <c:pt idx="336" formatCode="General">
                  <c:v>0.64048692197568269</c:v>
                </c:pt>
                <c:pt idx="337">
                  <c:v>0.63837310375134049</c:v>
                </c:pt>
                <c:pt idx="338">
                  <c:v>0.63837310375134049</c:v>
                </c:pt>
                <c:pt idx="339" formatCode="General">
                  <c:v>0.63837310375134049</c:v>
                </c:pt>
                <c:pt idx="340">
                  <c:v>0.63625226287509018</c:v>
                </c:pt>
                <c:pt idx="341" formatCode="General">
                  <c:v>0.63625226287509018</c:v>
                </c:pt>
                <c:pt idx="342">
                  <c:v>0.63413142199883987</c:v>
                </c:pt>
                <c:pt idx="343" formatCode="General">
                  <c:v>0.63413142199883987</c:v>
                </c:pt>
                <c:pt idx="344">
                  <c:v>0.63201058112258957</c:v>
                </c:pt>
                <c:pt idx="345" formatCode="General">
                  <c:v>0.63201058112258957</c:v>
                </c:pt>
                <c:pt idx="346">
                  <c:v>0.62988974024633926</c:v>
                </c:pt>
                <c:pt idx="347" formatCode="General">
                  <c:v>0.62988974024633926</c:v>
                </c:pt>
                <c:pt idx="348">
                  <c:v>0.62776889937008895</c:v>
                </c:pt>
                <c:pt idx="349" formatCode="General">
                  <c:v>0.62776889937008895</c:v>
                </c:pt>
                <c:pt idx="350">
                  <c:v>0.62564805849383864</c:v>
                </c:pt>
                <c:pt idx="351" formatCode="General">
                  <c:v>0.62564805849383864</c:v>
                </c:pt>
                <c:pt idx="352">
                  <c:v>0.62352721761758834</c:v>
                </c:pt>
                <c:pt idx="353" formatCode="General">
                  <c:v>0.62352721761758834</c:v>
                </c:pt>
                <c:pt idx="354">
                  <c:v>0.62140637674133803</c:v>
                </c:pt>
                <c:pt idx="355">
                  <c:v>0.62140637674133803</c:v>
                </c:pt>
                <c:pt idx="356" formatCode="General">
                  <c:v>0.62140637674133803</c:v>
                </c:pt>
                <c:pt idx="357">
                  <c:v>0.6192782727114019</c:v>
                </c:pt>
                <c:pt idx="358" formatCode="General">
                  <c:v>0.6192782727114019</c:v>
                </c:pt>
                <c:pt idx="359">
                  <c:v>0.61715016868146577</c:v>
                </c:pt>
                <c:pt idx="360">
                  <c:v>0.61715016868146577</c:v>
                </c:pt>
                <c:pt idx="361" formatCode="General">
                  <c:v>0.61715016868146577</c:v>
                </c:pt>
                <c:pt idx="362">
                  <c:v>0.61501470096976518</c:v>
                </c:pt>
                <c:pt idx="363" formatCode="General">
                  <c:v>0.61501470096976518</c:v>
                </c:pt>
                <c:pt idx="364">
                  <c:v>0.61287923325806459</c:v>
                </c:pt>
                <c:pt idx="365">
                  <c:v>0.61287923325806459</c:v>
                </c:pt>
                <c:pt idx="366">
                  <c:v>0.61287923325806459</c:v>
                </c:pt>
                <c:pt idx="367" formatCode="General">
                  <c:v>0.61287923325806459</c:v>
                </c:pt>
                <c:pt idx="368">
                  <c:v>0.61072120778884609</c:v>
                </c:pt>
                <c:pt idx="369" formatCode="General">
                  <c:v>0.61072120778884609</c:v>
                </c:pt>
                <c:pt idx="370">
                  <c:v>0.60640515685040897</c:v>
                </c:pt>
                <c:pt idx="371" formatCode="General">
                  <c:v>0.60640515685040897</c:v>
                </c:pt>
                <c:pt idx="372">
                  <c:v>0.60424713138119046</c:v>
                </c:pt>
                <c:pt idx="373" formatCode="General">
                  <c:v>0.60424713138119046</c:v>
                </c:pt>
                <c:pt idx="374">
                  <c:v>0.59993108044275345</c:v>
                </c:pt>
                <c:pt idx="375" formatCode="General">
                  <c:v>0.59993108044275345</c:v>
                </c:pt>
                <c:pt idx="376">
                  <c:v>0.59777305497353495</c:v>
                </c:pt>
                <c:pt idx="377">
                  <c:v>0.59777305497353495</c:v>
                </c:pt>
                <c:pt idx="378" formatCode="General">
                  <c:v>0.59777305497353495</c:v>
                </c:pt>
                <c:pt idx="379">
                  <c:v>0.59560721057145694</c:v>
                </c:pt>
                <c:pt idx="380" formatCode="General">
                  <c:v>0.59560721057145694</c:v>
                </c:pt>
                <c:pt idx="381">
                  <c:v>0.59344136616937893</c:v>
                </c:pt>
                <c:pt idx="382" formatCode="General">
                  <c:v>0.59344136616937893</c:v>
                </c:pt>
                <c:pt idx="383">
                  <c:v>0.59127552176730092</c:v>
                </c:pt>
                <c:pt idx="384" formatCode="General">
                  <c:v>0.59127552176730092</c:v>
                </c:pt>
                <c:pt idx="385">
                  <c:v>0.58910967736522291</c:v>
                </c:pt>
                <c:pt idx="386" formatCode="General">
                  <c:v>0.58910967736522291</c:v>
                </c:pt>
                <c:pt idx="387">
                  <c:v>0.5869438329631449</c:v>
                </c:pt>
                <c:pt idx="388" formatCode="General">
                  <c:v>0.5869438329631449</c:v>
                </c:pt>
                <c:pt idx="389">
                  <c:v>0.58477798856106689</c:v>
                </c:pt>
                <c:pt idx="390">
                  <c:v>0.58477798856106689</c:v>
                </c:pt>
                <c:pt idx="391">
                  <c:v>0.58477798856106689</c:v>
                </c:pt>
                <c:pt idx="392" formatCode="General">
                  <c:v>0.58477798856106689</c:v>
                </c:pt>
                <c:pt idx="393">
                  <c:v>0.58258780882862837</c:v>
                </c:pt>
                <c:pt idx="394" formatCode="General">
                  <c:v>0.58258780882862837</c:v>
                </c:pt>
                <c:pt idx="395">
                  <c:v>0.58039762909618986</c:v>
                </c:pt>
                <c:pt idx="396" formatCode="General">
                  <c:v>0.58039762909618986</c:v>
                </c:pt>
                <c:pt idx="397">
                  <c:v>0.57820744936375146</c:v>
                </c:pt>
                <c:pt idx="398" formatCode="General">
                  <c:v>0.57820744936375146</c:v>
                </c:pt>
                <c:pt idx="399">
                  <c:v>0.57601726963131306</c:v>
                </c:pt>
                <c:pt idx="400">
                  <c:v>0.57601726963131306</c:v>
                </c:pt>
                <c:pt idx="401" formatCode="General">
                  <c:v>0.57601726963131306</c:v>
                </c:pt>
                <c:pt idx="402">
                  <c:v>0.57381873043424703</c:v>
                </c:pt>
                <c:pt idx="403" formatCode="General">
                  <c:v>0.57381873043424703</c:v>
                </c:pt>
                <c:pt idx="404">
                  <c:v>0.57162019123718089</c:v>
                </c:pt>
                <c:pt idx="405" formatCode="General">
                  <c:v>0.57162019123718089</c:v>
                </c:pt>
                <c:pt idx="406">
                  <c:v>0.56942165204011486</c:v>
                </c:pt>
                <c:pt idx="407" formatCode="General">
                  <c:v>0.56942165204011486</c:v>
                </c:pt>
                <c:pt idx="408">
                  <c:v>0.56721459137329266</c:v>
                </c:pt>
                <c:pt idx="409">
                  <c:v>0.56721459137329266</c:v>
                </c:pt>
                <c:pt idx="410" formatCode="General">
                  <c:v>0.56721459137329266</c:v>
                </c:pt>
                <c:pt idx="411">
                  <c:v>0.56499890937574071</c:v>
                </c:pt>
                <c:pt idx="412" formatCode="General">
                  <c:v>0.56499890937574071</c:v>
                </c:pt>
                <c:pt idx="413">
                  <c:v>0.56278322737818876</c:v>
                </c:pt>
                <c:pt idx="414" formatCode="General">
                  <c:v>0.56278322737818876</c:v>
                </c:pt>
                <c:pt idx="415">
                  <c:v>0.5605675453806368</c:v>
                </c:pt>
                <c:pt idx="416" formatCode="General">
                  <c:v>0.5605675453806368</c:v>
                </c:pt>
                <c:pt idx="417">
                  <c:v>0.55835186338308485</c:v>
                </c:pt>
                <c:pt idx="418">
                  <c:v>0.55835186338308485</c:v>
                </c:pt>
                <c:pt idx="419">
                  <c:v>0.55835186338308485</c:v>
                </c:pt>
                <c:pt idx="420" formatCode="General">
                  <c:v>0.55835186338308485</c:v>
                </c:pt>
                <c:pt idx="421">
                  <c:v>0.55388504847602016</c:v>
                </c:pt>
                <c:pt idx="422" formatCode="General">
                  <c:v>0.55388504847602016</c:v>
                </c:pt>
                <c:pt idx="423">
                  <c:v>0.55165164102248787</c:v>
                </c:pt>
                <c:pt idx="424" formatCode="General">
                  <c:v>0.55165164102248787</c:v>
                </c:pt>
                <c:pt idx="425">
                  <c:v>0.54718482611542318</c:v>
                </c:pt>
                <c:pt idx="426" formatCode="General">
                  <c:v>0.54718482611542318</c:v>
                </c:pt>
                <c:pt idx="427">
                  <c:v>0.54495141866189079</c:v>
                </c:pt>
                <c:pt idx="428" formatCode="General">
                  <c:v>0.54495141866189079</c:v>
                </c:pt>
                <c:pt idx="429">
                  <c:v>0.5427180112083585</c:v>
                </c:pt>
                <c:pt idx="430" formatCode="General">
                  <c:v>0.5427180112083585</c:v>
                </c:pt>
                <c:pt idx="431">
                  <c:v>0.54048460375482621</c:v>
                </c:pt>
                <c:pt idx="432" formatCode="General">
                  <c:v>0.54048460375482621</c:v>
                </c:pt>
                <c:pt idx="433">
                  <c:v>0.53825119630129392</c:v>
                </c:pt>
                <c:pt idx="434" formatCode="General">
                  <c:v>0.53825119630129392</c:v>
                </c:pt>
                <c:pt idx="435">
                  <c:v>0.53601778884776163</c:v>
                </c:pt>
                <c:pt idx="436" formatCode="General">
                  <c:v>0.53601778884776163</c:v>
                </c:pt>
                <c:pt idx="437">
                  <c:v>0.53378438139422935</c:v>
                </c:pt>
                <c:pt idx="438" formatCode="General">
                  <c:v>0.53378438139422935</c:v>
                </c:pt>
                <c:pt idx="439">
                  <c:v>0.53155097394069706</c:v>
                </c:pt>
                <c:pt idx="440" formatCode="General">
                  <c:v>0.53155097394069706</c:v>
                </c:pt>
                <c:pt idx="441">
                  <c:v>0.52931756648716477</c:v>
                </c:pt>
                <c:pt idx="442" formatCode="General">
                  <c:v>0.52931756648716477</c:v>
                </c:pt>
                <c:pt idx="443">
                  <c:v>0.52708415903363248</c:v>
                </c:pt>
                <c:pt idx="444" formatCode="General">
                  <c:v>0.52708415903363248</c:v>
                </c:pt>
                <c:pt idx="445">
                  <c:v>0.52485075158010019</c:v>
                </c:pt>
                <c:pt idx="446">
                  <c:v>0.52485075158010019</c:v>
                </c:pt>
                <c:pt idx="447">
                  <c:v>0.52485075158010019</c:v>
                </c:pt>
                <c:pt idx="448" formatCode="General">
                  <c:v>0.52485075158010019</c:v>
                </c:pt>
                <c:pt idx="449">
                  <c:v>0.52034559491417665</c:v>
                </c:pt>
                <c:pt idx="450" formatCode="General">
                  <c:v>0.52034559491417665</c:v>
                </c:pt>
                <c:pt idx="451">
                  <c:v>0.51809301658121487</c:v>
                </c:pt>
                <c:pt idx="452" formatCode="General">
                  <c:v>0.51809301658121487</c:v>
                </c:pt>
                <c:pt idx="453">
                  <c:v>0.5158404382482531</c:v>
                </c:pt>
                <c:pt idx="454" formatCode="General">
                  <c:v>0.5158404382482531</c:v>
                </c:pt>
                <c:pt idx="455">
                  <c:v>0.51358785991529132</c:v>
                </c:pt>
                <c:pt idx="456">
                  <c:v>0.51358785991529132</c:v>
                </c:pt>
                <c:pt idx="457" formatCode="General">
                  <c:v>0.51358785991529132</c:v>
                </c:pt>
                <c:pt idx="458">
                  <c:v>0.51132535832976134</c:v>
                </c:pt>
                <c:pt idx="459" formatCode="General">
                  <c:v>0.51132535832976134</c:v>
                </c:pt>
                <c:pt idx="460">
                  <c:v>0.50906285674423146</c:v>
                </c:pt>
                <c:pt idx="461">
                  <c:v>0.50906285674423146</c:v>
                </c:pt>
                <c:pt idx="462">
                  <c:v>0.50906285674423146</c:v>
                </c:pt>
                <c:pt idx="463">
                  <c:v>0.50906285674423146</c:v>
                </c:pt>
                <c:pt idx="464" formatCode="General">
                  <c:v>0.50906285674423146</c:v>
                </c:pt>
                <c:pt idx="465">
                  <c:v>0.50447670488167085</c:v>
                </c:pt>
                <c:pt idx="466">
                  <c:v>0.50447670488167085</c:v>
                </c:pt>
                <c:pt idx="467" formatCode="General">
                  <c:v>0.50447670488167085</c:v>
                </c:pt>
                <c:pt idx="468">
                  <c:v>0.50216259155652554</c:v>
                </c:pt>
                <c:pt idx="469" formatCode="General">
                  <c:v>0.50216259155652554</c:v>
                </c:pt>
                <c:pt idx="470">
                  <c:v>0.49984847823138029</c:v>
                </c:pt>
                <c:pt idx="471" formatCode="General">
                  <c:v>0.49984847823138029</c:v>
                </c:pt>
                <c:pt idx="472">
                  <c:v>0.49752360158844366</c:v>
                </c:pt>
                <c:pt idx="473" formatCode="General">
                  <c:v>0.49752360158844366</c:v>
                </c:pt>
                <c:pt idx="474">
                  <c:v>0.49519872494550704</c:v>
                </c:pt>
                <c:pt idx="475" formatCode="General">
                  <c:v>0.49519872494550704</c:v>
                </c:pt>
                <c:pt idx="476">
                  <c:v>0.49287384830257042</c:v>
                </c:pt>
                <c:pt idx="477" formatCode="General">
                  <c:v>0.49287384830257042</c:v>
                </c:pt>
                <c:pt idx="478">
                  <c:v>0.49054897165963374</c:v>
                </c:pt>
                <c:pt idx="479" formatCode="General">
                  <c:v>0.49054897165963374</c:v>
                </c:pt>
                <c:pt idx="480">
                  <c:v>0.48822409501669706</c:v>
                </c:pt>
                <c:pt idx="481" formatCode="General">
                  <c:v>0.48822409501669706</c:v>
                </c:pt>
                <c:pt idx="482">
                  <c:v>0.48357434173082375</c:v>
                </c:pt>
                <c:pt idx="483" formatCode="General">
                  <c:v>0.48357434173082375</c:v>
                </c:pt>
                <c:pt idx="484">
                  <c:v>0.48124946508788713</c:v>
                </c:pt>
                <c:pt idx="485" formatCode="General">
                  <c:v>0.48124946508788713</c:v>
                </c:pt>
                <c:pt idx="486">
                  <c:v>0.47892458844495045</c:v>
                </c:pt>
                <c:pt idx="487" formatCode="General">
                  <c:v>0.47892458844495045</c:v>
                </c:pt>
                <c:pt idx="488">
                  <c:v>0.47659971180201383</c:v>
                </c:pt>
                <c:pt idx="489" formatCode="General">
                  <c:v>0.47659971180201383</c:v>
                </c:pt>
                <c:pt idx="490">
                  <c:v>0.47426343870494514</c:v>
                </c:pt>
                <c:pt idx="491" formatCode="General">
                  <c:v>0.47426343870494514</c:v>
                </c:pt>
                <c:pt idx="492">
                  <c:v>0.46959089251080777</c:v>
                </c:pt>
                <c:pt idx="493" formatCode="General">
                  <c:v>0.46959089251080777</c:v>
                </c:pt>
                <c:pt idx="494">
                  <c:v>0.46491834631667039</c:v>
                </c:pt>
                <c:pt idx="495" formatCode="General">
                  <c:v>0.46491834631667039</c:v>
                </c:pt>
                <c:pt idx="496">
                  <c:v>0.46258207321960171</c:v>
                </c:pt>
                <c:pt idx="497" formatCode="General">
                  <c:v>0.46258207321960171</c:v>
                </c:pt>
                <c:pt idx="498">
                  <c:v>0.46024580012253302</c:v>
                </c:pt>
                <c:pt idx="499" formatCode="General">
                  <c:v>0.46024580012253302</c:v>
                </c:pt>
                <c:pt idx="500">
                  <c:v>0.45790952702546434</c:v>
                </c:pt>
                <c:pt idx="501" formatCode="General">
                  <c:v>0.45790952702546434</c:v>
                </c:pt>
                <c:pt idx="502">
                  <c:v>0.45557325392839565</c:v>
                </c:pt>
                <c:pt idx="503" formatCode="General">
                  <c:v>0.45557325392839565</c:v>
                </c:pt>
                <c:pt idx="504">
                  <c:v>0.45323698083132696</c:v>
                </c:pt>
                <c:pt idx="505" formatCode="General">
                  <c:v>0.45323698083132696</c:v>
                </c:pt>
                <c:pt idx="506">
                  <c:v>0.45090070773425828</c:v>
                </c:pt>
                <c:pt idx="507">
                  <c:v>0.45090070773425828</c:v>
                </c:pt>
                <c:pt idx="508" formatCode="General">
                  <c:v>0.45090070773425828</c:v>
                </c:pt>
                <c:pt idx="509">
                  <c:v>0.44855226654814234</c:v>
                </c:pt>
                <c:pt idx="510">
                  <c:v>0.44855226654814234</c:v>
                </c:pt>
                <c:pt idx="511" formatCode="General">
                  <c:v>0.44855226654814234</c:v>
                </c:pt>
                <c:pt idx="512">
                  <c:v>0.44619146514525737</c:v>
                </c:pt>
                <c:pt idx="513" formatCode="General">
                  <c:v>0.44619146514525737</c:v>
                </c:pt>
                <c:pt idx="514">
                  <c:v>0.4438306637423724</c:v>
                </c:pt>
                <c:pt idx="515" formatCode="General">
                  <c:v>0.4438306637423724</c:v>
                </c:pt>
                <c:pt idx="516">
                  <c:v>0.44146986233948743</c:v>
                </c:pt>
                <c:pt idx="517" formatCode="General">
                  <c:v>0.44146986233948743</c:v>
                </c:pt>
                <c:pt idx="518">
                  <c:v>0.43910906093660246</c:v>
                </c:pt>
                <c:pt idx="519" formatCode="General">
                  <c:v>0.43910906093660246</c:v>
                </c:pt>
                <c:pt idx="520">
                  <c:v>0.43674825953371749</c:v>
                </c:pt>
                <c:pt idx="521">
                  <c:v>0.43674825953371749</c:v>
                </c:pt>
                <c:pt idx="522" formatCode="General">
                  <c:v>0.43674825953371749</c:v>
                </c:pt>
                <c:pt idx="523">
                  <c:v>0.43437462768842555</c:v>
                </c:pt>
                <c:pt idx="524">
                  <c:v>0.43437462768842555</c:v>
                </c:pt>
                <c:pt idx="525" formatCode="General">
                  <c:v>0.43437462768842555</c:v>
                </c:pt>
                <c:pt idx="526">
                  <c:v>0.43198795390991773</c:v>
                </c:pt>
                <c:pt idx="527" formatCode="General">
                  <c:v>0.43198795390991773</c:v>
                </c:pt>
                <c:pt idx="528">
                  <c:v>0.42960128013140991</c:v>
                </c:pt>
                <c:pt idx="529" formatCode="General">
                  <c:v>0.42960128013140991</c:v>
                </c:pt>
                <c:pt idx="530">
                  <c:v>0.42721460635290209</c:v>
                </c:pt>
                <c:pt idx="531" formatCode="General">
                  <c:v>0.42721460635290209</c:v>
                </c:pt>
                <c:pt idx="532">
                  <c:v>0.42482793257439422</c:v>
                </c:pt>
                <c:pt idx="533" formatCode="General">
                  <c:v>0.42482793257439422</c:v>
                </c:pt>
                <c:pt idx="534">
                  <c:v>0.4224412587958864</c:v>
                </c:pt>
                <c:pt idx="535" formatCode="General">
                  <c:v>0.4224412587958864</c:v>
                </c:pt>
                <c:pt idx="536">
                  <c:v>0.41764078994593312</c:v>
                </c:pt>
                <c:pt idx="537" formatCode="General">
                  <c:v>0.41764078994593312</c:v>
                </c:pt>
                <c:pt idx="538">
                  <c:v>0.41524055552095646</c:v>
                </c:pt>
                <c:pt idx="539" formatCode="General">
                  <c:v>0.41524055552095646</c:v>
                </c:pt>
                <c:pt idx="540">
                  <c:v>0.41282636624467184</c:v>
                </c:pt>
                <c:pt idx="541" formatCode="General">
                  <c:v>0.41282636624467184</c:v>
                </c:pt>
                <c:pt idx="542">
                  <c:v>0.41041217696838717</c:v>
                </c:pt>
                <c:pt idx="543" formatCode="General">
                  <c:v>0.41041217696838717</c:v>
                </c:pt>
                <c:pt idx="544">
                  <c:v>0.40799798769210255</c:v>
                </c:pt>
                <c:pt idx="545" formatCode="General">
                  <c:v>0.40799798769210255</c:v>
                </c:pt>
                <c:pt idx="546">
                  <c:v>0.40558379841581793</c:v>
                </c:pt>
                <c:pt idx="547" formatCode="General">
                  <c:v>0.40558379841581793</c:v>
                </c:pt>
                <c:pt idx="548">
                  <c:v>0.40316960913953331</c:v>
                </c:pt>
                <c:pt idx="549">
                  <c:v>0.40316960913953331</c:v>
                </c:pt>
                <c:pt idx="550" formatCode="General">
                  <c:v>0.40316960913953331</c:v>
                </c:pt>
                <c:pt idx="551">
                  <c:v>0.40074087655435542</c:v>
                </c:pt>
                <c:pt idx="552" formatCode="General">
                  <c:v>0.40074087655435542</c:v>
                </c:pt>
                <c:pt idx="553">
                  <c:v>0.39831214396917747</c:v>
                </c:pt>
                <c:pt idx="554" formatCode="General">
                  <c:v>0.39831214396917747</c:v>
                </c:pt>
                <c:pt idx="555">
                  <c:v>0.39588341138399957</c:v>
                </c:pt>
                <c:pt idx="556">
                  <c:v>0.39588341138399957</c:v>
                </c:pt>
                <c:pt idx="557" formatCode="General">
                  <c:v>0.39588341138399957</c:v>
                </c:pt>
                <c:pt idx="558">
                  <c:v>0.39343968662236994</c:v>
                </c:pt>
                <c:pt idx="559" formatCode="General">
                  <c:v>0.39343968662236994</c:v>
                </c:pt>
                <c:pt idx="560">
                  <c:v>0.39099596186074032</c:v>
                </c:pt>
                <c:pt idx="561">
                  <c:v>0.39099596186074032</c:v>
                </c:pt>
                <c:pt idx="562">
                  <c:v>0.39099596186074032</c:v>
                </c:pt>
                <c:pt idx="563" formatCode="General">
                  <c:v>0.39099596186074032</c:v>
                </c:pt>
                <c:pt idx="564">
                  <c:v>0.38852130387427991</c:v>
                </c:pt>
                <c:pt idx="565">
                  <c:v>0.38852130387427991</c:v>
                </c:pt>
                <c:pt idx="566" formatCode="General">
                  <c:v>0.38852130387427991</c:v>
                </c:pt>
                <c:pt idx="567">
                  <c:v>0.38603078269559865</c:v>
                </c:pt>
                <c:pt idx="568">
                  <c:v>0.38603078269559865</c:v>
                </c:pt>
                <c:pt idx="569" formatCode="General">
                  <c:v>0.38603078269559865</c:v>
                </c:pt>
                <c:pt idx="570">
                  <c:v>0.38352408930147142</c:v>
                </c:pt>
                <c:pt idx="571" formatCode="General">
                  <c:v>0.38352408930147142</c:v>
                </c:pt>
                <c:pt idx="572">
                  <c:v>0.38101739590734418</c:v>
                </c:pt>
                <c:pt idx="573" formatCode="General">
                  <c:v>0.38101739590734418</c:v>
                </c:pt>
                <c:pt idx="574">
                  <c:v>0.37851070251321695</c:v>
                </c:pt>
                <c:pt idx="575" formatCode="General">
                  <c:v>0.37851070251321695</c:v>
                </c:pt>
                <c:pt idx="576">
                  <c:v>0.37600400911908965</c:v>
                </c:pt>
                <c:pt idx="577" formatCode="General">
                  <c:v>0.37600400911908965</c:v>
                </c:pt>
                <c:pt idx="578">
                  <c:v>0.37349731572496236</c:v>
                </c:pt>
                <c:pt idx="579" formatCode="General">
                  <c:v>0.37349731572496236</c:v>
                </c:pt>
                <c:pt idx="580">
                  <c:v>0.37099062233083513</c:v>
                </c:pt>
                <c:pt idx="581" formatCode="General">
                  <c:v>0.37099062233083513</c:v>
                </c:pt>
                <c:pt idx="582">
                  <c:v>0.36848392893670784</c:v>
                </c:pt>
                <c:pt idx="583" formatCode="General">
                  <c:v>0.36848392893670784</c:v>
                </c:pt>
                <c:pt idx="584">
                  <c:v>0.36597723554258055</c:v>
                </c:pt>
                <c:pt idx="585" formatCode="General">
                  <c:v>0.36597723554258055</c:v>
                </c:pt>
                <c:pt idx="586">
                  <c:v>0.36347054214845326</c:v>
                </c:pt>
                <c:pt idx="587">
                  <c:v>0.36347054214845326</c:v>
                </c:pt>
                <c:pt idx="588" formatCode="General">
                  <c:v>0.36347054214845326</c:v>
                </c:pt>
                <c:pt idx="589">
                  <c:v>0.36094644116131125</c:v>
                </c:pt>
                <c:pt idx="590" formatCode="General">
                  <c:v>0.36094644116131125</c:v>
                </c:pt>
                <c:pt idx="591">
                  <c:v>0.35842234017416924</c:v>
                </c:pt>
                <c:pt idx="592" formatCode="General">
                  <c:v>0.35842234017416924</c:v>
                </c:pt>
                <c:pt idx="593">
                  <c:v>0.35337413819988517</c:v>
                </c:pt>
                <c:pt idx="594" formatCode="General">
                  <c:v>0.35337413819988517</c:v>
                </c:pt>
                <c:pt idx="595">
                  <c:v>0.35085003721274316</c:v>
                </c:pt>
                <c:pt idx="596" formatCode="General">
                  <c:v>0.35085003721274316</c:v>
                </c:pt>
                <c:pt idx="597">
                  <c:v>0.34832593622560115</c:v>
                </c:pt>
                <c:pt idx="598" formatCode="General">
                  <c:v>0.34832593622560115</c:v>
                </c:pt>
                <c:pt idx="599">
                  <c:v>0.34580183523845909</c:v>
                </c:pt>
                <c:pt idx="600" formatCode="General">
                  <c:v>0.34580183523845909</c:v>
                </c:pt>
                <c:pt idx="601">
                  <c:v>0.34327773425131708</c:v>
                </c:pt>
                <c:pt idx="602" formatCode="General">
                  <c:v>0.34327773425131708</c:v>
                </c:pt>
                <c:pt idx="603">
                  <c:v>0.34075363326417507</c:v>
                </c:pt>
                <c:pt idx="604">
                  <c:v>0.34075363326417507</c:v>
                </c:pt>
                <c:pt idx="605" formatCode="General">
                  <c:v>0.34075363326417507</c:v>
                </c:pt>
                <c:pt idx="606">
                  <c:v>0.33821069570250212</c:v>
                </c:pt>
                <c:pt idx="607" formatCode="General">
                  <c:v>0.33821069570250212</c:v>
                </c:pt>
                <c:pt idx="608">
                  <c:v>0.33566775814082916</c:v>
                </c:pt>
                <c:pt idx="609" formatCode="General">
                  <c:v>0.33566775814082916</c:v>
                </c:pt>
                <c:pt idx="610">
                  <c:v>0.33312482057915621</c:v>
                </c:pt>
                <c:pt idx="611" formatCode="General">
                  <c:v>0.33312482057915621</c:v>
                </c:pt>
                <c:pt idx="612">
                  <c:v>0.33058188301748326</c:v>
                </c:pt>
                <c:pt idx="613" formatCode="General">
                  <c:v>0.33058188301748326</c:v>
                </c:pt>
                <c:pt idx="614">
                  <c:v>0.32801923276153377</c:v>
                </c:pt>
                <c:pt idx="615" formatCode="General">
                  <c:v>0.32801923276153377</c:v>
                </c:pt>
                <c:pt idx="616">
                  <c:v>0.32545658250558429</c:v>
                </c:pt>
                <c:pt idx="617" formatCode="General">
                  <c:v>0.32545658250558429</c:v>
                </c:pt>
                <c:pt idx="618">
                  <c:v>0.32289393224963481</c:v>
                </c:pt>
                <c:pt idx="619" formatCode="General">
                  <c:v>0.32289393224963481</c:v>
                </c:pt>
                <c:pt idx="620">
                  <c:v>0.32033128199368532</c:v>
                </c:pt>
                <c:pt idx="621" formatCode="General">
                  <c:v>0.32033128199368532</c:v>
                </c:pt>
                <c:pt idx="622">
                  <c:v>0.31776863173773584</c:v>
                </c:pt>
                <c:pt idx="623" formatCode="General">
                  <c:v>0.31776863173773584</c:v>
                </c:pt>
                <c:pt idx="624">
                  <c:v>0.31520598148178636</c:v>
                </c:pt>
                <c:pt idx="625" formatCode="General">
                  <c:v>0.31520598148178636</c:v>
                </c:pt>
                <c:pt idx="626">
                  <c:v>0.31264333122583687</c:v>
                </c:pt>
                <c:pt idx="627" formatCode="General">
                  <c:v>0.31264333122583687</c:v>
                </c:pt>
                <c:pt idx="628">
                  <c:v>0.31008068096988739</c:v>
                </c:pt>
                <c:pt idx="629">
                  <c:v>0.31008068096988739</c:v>
                </c:pt>
                <c:pt idx="630" formatCode="General">
                  <c:v>0.31008068096988739</c:v>
                </c:pt>
                <c:pt idx="631">
                  <c:v>0.30749667529513836</c:v>
                </c:pt>
                <c:pt idx="632" formatCode="General">
                  <c:v>0.30749667529513836</c:v>
                </c:pt>
                <c:pt idx="633">
                  <c:v>0.30491266962038932</c:v>
                </c:pt>
                <c:pt idx="634" formatCode="General">
                  <c:v>0.30491266962038932</c:v>
                </c:pt>
                <c:pt idx="635">
                  <c:v>0.30232866394564029</c:v>
                </c:pt>
                <c:pt idx="636">
                  <c:v>0.30232866394564029</c:v>
                </c:pt>
                <c:pt idx="637">
                  <c:v>0.30232866394564029</c:v>
                </c:pt>
                <c:pt idx="638" formatCode="General">
                  <c:v>0.30232866394564029</c:v>
                </c:pt>
                <c:pt idx="639">
                  <c:v>0.29969971904176518</c:v>
                </c:pt>
                <c:pt idx="640" formatCode="General">
                  <c:v>0.29969971904176518</c:v>
                </c:pt>
                <c:pt idx="641">
                  <c:v>0.29707077413789001</c:v>
                </c:pt>
                <c:pt idx="642" formatCode="General">
                  <c:v>0.29707077413789001</c:v>
                </c:pt>
                <c:pt idx="643">
                  <c:v>0.29444182923401485</c:v>
                </c:pt>
                <c:pt idx="644" formatCode="General">
                  <c:v>0.29444182923401485</c:v>
                </c:pt>
                <c:pt idx="645">
                  <c:v>0.29181288433013974</c:v>
                </c:pt>
                <c:pt idx="646" formatCode="General">
                  <c:v>0.29181288433013974</c:v>
                </c:pt>
                <c:pt idx="647">
                  <c:v>0.28918393942626458</c:v>
                </c:pt>
                <c:pt idx="648" formatCode="General">
                  <c:v>0.28918393942626458</c:v>
                </c:pt>
                <c:pt idx="649">
                  <c:v>0.28655499452238947</c:v>
                </c:pt>
                <c:pt idx="650" formatCode="General">
                  <c:v>0.28655499452238947</c:v>
                </c:pt>
                <c:pt idx="651">
                  <c:v>0.28392604961851436</c:v>
                </c:pt>
                <c:pt idx="652" formatCode="General">
                  <c:v>0.28392604961851436</c:v>
                </c:pt>
                <c:pt idx="653">
                  <c:v>0.2812971047146392</c:v>
                </c:pt>
                <c:pt idx="654">
                  <c:v>0.2812971047146392</c:v>
                </c:pt>
                <c:pt idx="655" formatCode="General">
                  <c:v>0.2812971047146392</c:v>
                </c:pt>
                <c:pt idx="656">
                  <c:v>0.27864335844374638</c:v>
                </c:pt>
                <c:pt idx="657" formatCode="General">
                  <c:v>0.27864335844374638</c:v>
                </c:pt>
                <c:pt idx="658">
                  <c:v>0.27598961217285356</c:v>
                </c:pt>
                <c:pt idx="659" formatCode="General">
                  <c:v>0.27598961217285356</c:v>
                </c:pt>
                <c:pt idx="660">
                  <c:v>0.27333586590196074</c:v>
                </c:pt>
                <c:pt idx="661" formatCode="General">
                  <c:v>0.27333586590196074</c:v>
                </c:pt>
                <c:pt idx="662">
                  <c:v>0.27068211963106792</c:v>
                </c:pt>
                <c:pt idx="663" formatCode="General">
                  <c:v>0.27068211963106792</c:v>
                </c:pt>
                <c:pt idx="664">
                  <c:v>0.2680283733601751</c:v>
                </c:pt>
                <c:pt idx="665" formatCode="General">
                  <c:v>0.2680283733601751</c:v>
                </c:pt>
                <c:pt idx="666">
                  <c:v>0.26537462708928228</c:v>
                </c:pt>
                <c:pt idx="667" formatCode="General">
                  <c:v>0.26537462708928228</c:v>
                </c:pt>
                <c:pt idx="668">
                  <c:v>0.26272088081838946</c:v>
                </c:pt>
                <c:pt idx="669" formatCode="General">
                  <c:v>0.26272088081838946</c:v>
                </c:pt>
                <c:pt idx="670">
                  <c:v>0.26006713454749664</c:v>
                </c:pt>
                <c:pt idx="671" formatCode="General">
                  <c:v>0.26006713454749664</c:v>
                </c:pt>
                <c:pt idx="672">
                  <c:v>0.25741338827660382</c:v>
                </c:pt>
                <c:pt idx="673" formatCode="General">
                  <c:v>0.25741338827660382</c:v>
                </c:pt>
                <c:pt idx="674">
                  <c:v>0.254759642005711</c:v>
                </c:pt>
                <c:pt idx="675" formatCode="General">
                  <c:v>0.254759642005711</c:v>
                </c:pt>
                <c:pt idx="676">
                  <c:v>0.25210589573481818</c:v>
                </c:pt>
                <c:pt idx="677" formatCode="General">
                  <c:v>0.25210589573481818</c:v>
                </c:pt>
                <c:pt idx="678">
                  <c:v>0.24945214946392535</c:v>
                </c:pt>
                <c:pt idx="679" formatCode="General">
                  <c:v>0.24945214946392535</c:v>
                </c:pt>
                <c:pt idx="680">
                  <c:v>0.24679840319303253</c:v>
                </c:pt>
                <c:pt idx="681" formatCode="General">
                  <c:v>0.24679840319303253</c:v>
                </c:pt>
                <c:pt idx="682">
                  <c:v>0.24414465692213971</c:v>
                </c:pt>
                <c:pt idx="683">
                  <c:v>0.24414465692213971</c:v>
                </c:pt>
                <c:pt idx="684" formatCode="General">
                  <c:v>0.24414465692213971</c:v>
                </c:pt>
                <c:pt idx="685">
                  <c:v>0.24146174860431402</c:v>
                </c:pt>
                <c:pt idx="686" formatCode="General">
                  <c:v>0.24146174860431402</c:v>
                </c:pt>
                <c:pt idx="687">
                  <c:v>0.23877884028648833</c:v>
                </c:pt>
                <c:pt idx="688" formatCode="General">
                  <c:v>0.23877884028648833</c:v>
                </c:pt>
                <c:pt idx="689">
                  <c:v>0.2360959319686626</c:v>
                </c:pt>
                <c:pt idx="690" formatCode="General">
                  <c:v>0.2360959319686626</c:v>
                </c:pt>
                <c:pt idx="691">
                  <c:v>0.23341302365083688</c:v>
                </c:pt>
                <c:pt idx="692" formatCode="General">
                  <c:v>0.23341302365083688</c:v>
                </c:pt>
                <c:pt idx="693">
                  <c:v>0.23073011533301116</c:v>
                </c:pt>
                <c:pt idx="694" formatCode="General">
                  <c:v>0.23073011533301116</c:v>
                </c:pt>
                <c:pt idx="695">
                  <c:v>0.22804720701518544</c:v>
                </c:pt>
                <c:pt idx="696">
                  <c:v>0.22804720701518544</c:v>
                </c:pt>
                <c:pt idx="697" formatCode="General">
                  <c:v>0.22804720701518544</c:v>
                </c:pt>
                <c:pt idx="698">
                  <c:v>0.22533235931262371</c:v>
                </c:pt>
                <c:pt idx="699" formatCode="General">
                  <c:v>0.22533235931262371</c:v>
                </c:pt>
                <c:pt idx="700">
                  <c:v>0.22261751161006196</c:v>
                </c:pt>
                <c:pt idx="701" formatCode="General">
                  <c:v>0.22261751161006196</c:v>
                </c:pt>
                <c:pt idx="702">
                  <c:v>0.21990266390750024</c:v>
                </c:pt>
                <c:pt idx="703" formatCode="General">
                  <c:v>0.21990266390750024</c:v>
                </c:pt>
                <c:pt idx="704">
                  <c:v>0.21718781620493849</c:v>
                </c:pt>
                <c:pt idx="705" formatCode="General">
                  <c:v>0.21718781620493849</c:v>
                </c:pt>
                <c:pt idx="706">
                  <c:v>0.21447296850237677</c:v>
                </c:pt>
                <c:pt idx="707" formatCode="General">
                  <c:v>0.21447296850237677</c:v>
                </c:pt>
                <c:pt idx="708">
                  <c:v>0.21175812079981504</c:v>
                </c:pt>
                <c:pt idx="709" formatCode="General">
                  <c:v>0.21175812079981504</c:v>
                </c:pt>
                <c:pt idx="710">
                  <c:v>0.20904327309725332</c:v>
                </c:pt>
                <c:pt idx="711" formatCode="General">
                  <c:v>0.20904327309725332</c:v>
                </c:pt>
                <c:pt idx="712">
                  <c:v>0.20632842539469159</c:v>
                </c:pt>
                <c:pt idx="713" formatCode="General">
                  <c:v>0.20632842539469159</c:v>
                </c:pt>
                <c:pt idx="714">
                  <c:v>0.20361357769212984</c:v>
                </c:pt>
                <c:pt idx="715" formatCode="General">
                  <c:v>0.20361357769212984</c:v>
                </c:pt>
                <c:pt idx="716">
                  <c:v>0.20089872998956812</c:v>
                </c:pt>
                <c:pt idx="717">
                  <c:v>0.20089872998956812</c:v>
                </c:pt>
                <c:pt idx="718" formatCode="General">
                  <c:v>0.20089872998956812</c:v>
                </c:pt>
                <c:pt idx="719">
                  <c:v>0.19814669259245074</c:v>
                </c:pt>
                <c:pt idx="720" formatCode="General">
                  <c:v>0.19814669259245074</c:v>
                </c:pt>
                <c:pt idx="721">
                  <c:v>0.19539465519533339</c:v>
                </c:pt>
                <c:pt idx="722">
                  <c:v>0.19539465519533339</c:v>
                </c:pt>
                <c:pt idx="723">
                  <c:v>0.19539465519533339</c:v>
                </c:pt>
                <c:pt idx="724" formatCode="General">
                  <c:v>0.19539465519533339</c:v>
                </c:pt>
                <c:pt idx="725">
                  <c:v>0.19256284859829959</c:v>
                </c:pt>
                <c:pt idx="726" formatCode="General">
                  <c:v>0.19256284859829959</c:v>
                </c:pt>
                <c:pt idx="727">
                  <c:v>0.18973104200126578</c:v>
                </c:pt>
                <c:pt idx="728" formatCode="General">
                  <c:v>0.18973104200126578</c:v>
                </c:pt>
                <c:pt idx="729">
                  <c:v>0.18689923540423195</c:v>
                </c:pt>
                <c:pt idx="730" formatCode="General">
                  <c:v>0.18689923540423195</c:v>
                </c:pt>
                <c:pt idx="731">
                  <c:v>0.18406742880719815</c:v>
                </c:pt>
                <c:pt idx="732">
                  <c:v>0.18406742880719815</c:v>
                </c:pt>
                <c:pt idx="733" formatCode="General">
                  <c:v>0.18406742880719815</c:v>
                </c:pt>
                <c:pt idx="734">
                  <c:v>0.18119137523208567</c:v>
                </c:pt>
                <c:pt idx="735" formatCode="General">
                  <c:v>0.18119137523208567</c:v>
                </c:pt>
                <c:pt idx="736">
                  <c:v>0.1783153216569732</c:v>
                </c:pt>
                <c:pt idx="737" formatCode="General">
                  <c:v>0.1783153216569732</c:v>
                </c:pt>
                <c:pt idx="738">
                  <c:v>0.17543926808186072</c:v>
                </c:pt>
                <c:pt idx="739" formatCode="General">
                  <c:v>0.17543926808186072</c:v>
                </c:pt>
                <c:pt idx="740">
                  <c:v>0.17256321450674825</c:v>
                </c:pt>
                <c:pt idx="741">
                  <c:v>0.17256321450674825</c:v>
                </c:pt>
                <c:pt idx="742">
                  <c:v>0.17256321450674825</c:v>
                </c:pt>
                <c:pt idx="743">
                  <c:v>0.17256321450674825</c:v>
                </c:pt>
                <c:pt idx="744">
                  <c:v>0.17256321450674825</c:v>
                </c:pt>
                <c:pt idx="745" formatCode="General">
                  <c:v>0.17256321450674825</c:v>
                </c:pt>
                <c:pt idx="746">
                  <c:v>0.16948172853341345</c:v>
                </c:pt>
                <c:pt idx="747" formatCode="General">
                  <c:v>0.16948172853341345</c:v>
                </c:pt>
                <c:pt idx="748">
                  <c:v>0.16640024256007865</c:v>
                </c:pt>
                <c:pt idx="749">
                  <c:v>0.16640024256007865</c:v>
                </c:pt>
                <c:pt idx="750" formatCode="General">
                  <c:v>0.16640024256007865</c:v>
                </c:pt>
                <c:pt idx="751">
                  <c:v>0.16326061534196395</c:v>
                </c:pt>
                <c:pt idx="752" formatCode="General">
                  <c:v>0.16326061534196395</c:v>
                </c:pt>
                <c:pt idx="753">
                  <c:v>0.16012098812384926</c:v>
                </c:pt>
                <c:pt idx="754">
                  <c:v>0.16012098812384926</c:v>
                </c:pt>
                <c:pt idx="755">
                  <c:v>0.16012098812384926</c:v>
                </c:pt>
                <c:pt idx="756">
                  <c:v>0.16012098812384926</c:v>
                </c:pt>
                <c:pt idx="757" formatCode="General">
                  <c:v>0.16012098812384926</c:v>
                </c:pt>
                <c:pt idx="758">
                  <c:v>0.15678513420460238</c:v>
                </c:pt>
                <c:pt idx="759" formatCode="General">
                  <c:v>0.15678513420460238</c:v>
                </c:pt>
                <c:pt idx="760">
                  <c:v>0.15344928028535551</c:v>
                </c:pt>
                <c:pt idx="761" formatCode="General">
                  <c:v>0.15344928028535551</c:v>
                </c:pt>
                <c:pt idx="762">
                  <c:v>0.15011342636610867</c:v>
                </c:pt>
                <c:pt idx="763" formatCode="General">
                  <c:v>0.15011342636610867</c:v>
                </c:pt>
                <c:pt idx="764">
                  <c:v>0.14677757244686179</c:v>
                </c:pt>
                <c:pt idx="765">
                  <c:v>0.14677757244686179</c:v>
                </c:pt>
                <c:pt idx="766" formatCode="General">
                  <c:v>0.14677757244686179</c:v>
                </c:pt>
                <c:pt idx="767">
                  <c:v>0.14336414052949289</c:v>
                </c:pt>
                <c:pt idx="768">
                  <c:v>0.14336414052949289</c:v>
                </c:pt>
                <c:pt idx="769" formatCode="General">
                  <c:v>0.14336414052949289</c:v>
                </c:pt>
                <c:pt idx="770">
                  <c:v>0.13986745417511501</c:v>
                </c:pt>
                <c:pt idx="771" formatCode="General">
                  <c:v>0.13986745417511501</c:v>
                </c:pt>
                <c:pt idx="772">
                  <c:v>0.13637076782073712</c:v>
                </c:pt>
                <c:pt idx="773" formatCode="General">
                  <c:v>0.13637076782073712</c:v>
                </c:pt>
                <c:pt idx="774">
                  <c:v>0.13287408146635923</c:v>
                </c:pt>
                <c:pt idx="775" formatCode="General">
                  <c:v>0.13287408146635923</c:v>
                </c:pt>
                <c:pt idx="776">
                  <c:v>0.12937739511198137</c:v>
                </c:pt>
                <c:pt idx="777" formatCode="General">
                  <c:v>0.12937739511198137</c:v>
                </c:pt>
                <c:pt idx="778">
                  <c:v>0.12588070875760352</c:v>
                </c:pt>
                <c:pt idx="779">
                  <c:v>0.12588070875760352</c:v>
                </c:pt>
                <c:pt idx="780">
                  <c:v>0.12588070875760352</c:v>
                </c:pt>
                <c:pt idx="781" formatCode="General">
                  <c:v>0.12588070875760352</c:v>
                </c:pt>
                <c:pt idx="782">
                  <c:v>0.12217833497061517</c:v>
                </c:pt>
                <c:pt idx="783">
                  <c:v>0.12217833497061517</c:v>
                </c:pt>
                <c:pt idx="784">
                  <c:v>0.12217833497061517</c:v>
                </c:pt>
                <c:pt idx="785" formatCode="General">
                  <c:v>0.12217833497061517</c:v>
                </c:pt>
                <c:pt idx="786">
                  <c:v>0.11823709835865985</c:v>
                </c:pt>
                <c:pt idx="787" formatCode="General">
                  <c:v>0.11823709835865985</c:v>
                </c:pt>
                <c:pt idx="788">
                  <c:v>0.11429586174670452</c:v>
                </c:pt>
                <c:pt idx="789" formatCode="General">
                  <c:v>0.11429586174670452</c:v>
                </c:pt>
                <c:pt idx="790">
                  <c:v>0.1103546251347492</c:v>
                </c:pt>
                <c:pt idx="791">
                  <c:v>0.1103546251347492</c:v>
                </c:pt>
                <c:pt idx="792" formatCode="General">
                  <c:v>0.1103546251347492</c:v>
                </c:pt>
                <c:pt idx="793">
                  <c:v>0.10626741679642515</c:v>
                </c:pt>
                <c:pt idx="794" formatCode="General">
                  <c:v>0.10626741679642515</c:v>
                </c:pt>
                <c:pt idx="795">
                  <c:v>0.10218020845810111</c:v>
                </c:pt>
                <c:pt idx="796">
                  <c:v>0.10218020845810111</c:v>
                </c:pt>
                <c:pt idx="797" formatCode="General">
                  <c:v>0.10218020845810111</c:v>
                </c:pt>
                <c:pt idx="798">
                  <c:v>9.7922699772346897E-2</c:v>
                </c:pt>
                <c:pt idx="799" formatCode="General">
                  <c:v>9.7922699772346897E-2</c:v>
                </c:pt>
                <c:pt idx="800">
                  <c:v>9.3665191086592686E-2</c:v>
                </c:pt>
                <c:pt idx="801">
                  <c:v>9.3665191086592686E-2</c:v>
                </c:pt>
                <c:pt idx="802">
                  <c:v>9.3665191086592686E-2</c:v>
                </c:pt>
                <c:pt idx="803" formatCode="General">
                  <c:v>9.3665191086592686E-2</c:v>
                </c:pt>
                <c:pt idx="804">
                  <c:v>8.8981931532263053E-2</c:v>
                </c:pt>
                <c:pt idx="805">
                  <c:v>8.8981931532263053E-2</c:v>
                </c:pt>
                <c:pt idx="806">
                  <c:v>8.8981931532263053E-2</c:v>
                </c:pt>
                <c:pt idx="807" formatCode="General">
                  <c:v>8.8981931532263053E-2</c:v>
                </c:pt>
                <c:pt idx="808">
                  <c:v>8.374770026565935E-2</c:v>
                </c:pt>
                <c:pt idx="809">
                  <c:v>8.374770026565935E-2</c:v>
                </c:pt>
                <c:pt idx="810" formatCode="General">
                  <c:v>8.374770026565935E-2</c:v>
                </c:pt>
                <c:pt idx="811">
                  <c:v>7.8164520247948732E-2</c:v>
                </c:pt>
                <c:pt idx="812" formatCode="General">
                  <c:v>7.8164520247948732E-2</c:v>
                </c:pt>
                <c:pt idx="813">
                  <c:v>7.2581340230238114E-2</c:v>
                </c:pt>
                <c:pt idx="814">
                  <c:v>7.2581340230238114E-2</c:v>
                </c:pt>
                <c:pt idx="815" formatCode="General">
                  <c:v>7.2581340230238114E-2</c:v>
                </c:pt>
                <c:pt idx="816">
                  <c:v>6.6532895211051601E-2</c:v>
                </c:pt>
                <c:pt idx="817">
                  <c:v>6.6532895211051601E-2</c:v>
                </c:pt>
                <c:pt idx="818" formatCode="General">
                  <c:v>6.6532895211051601E-2</c:v>
                </c:pt>
                <c:pt idx="819">
                  <c:v>5.9879605689946443E-2</c:v>
                </c:pt>
                <c:pt idx="820">
                  <c:v>5.9879605689946443E-2</c:v>
                </c:pt>
                <c:pt idx="821">
                  <c:v>5.9879605689946443E-2</c:v>
                </c:pt>
                <c:pt idx="822">
                  <c:v>5.9879605689946443E-2</c:v>
                </c:pt>
                <c:pt idx="823" formatCode="General">
                  <c:v>5.9879605689946443E-2</c:v>
                </c:pt>
                <c:pt idx="824">
                  <c:v>4.9899671408288701E-2</c:v>
                </c:pt>
                <c:pt idx="825">
                  <c:v>4.9899671408288701E-2</c:v>
                </c:pt>
                <c:pt idx="826">
                  <c:v>4.9899671408288701E-2</c:v>
                </c:pt>
                <c:pt idx="827" formatCode="General">
                  <c:v>4.9899671408288701E-2</c:v>
                </c:pt>
                <c:pt idx="828">
                  <c:v>3.3266447605525801E-2</c:v>
                </c:pt>
                <c:pt idx="829">
                  <c:v>3.3266447605525801E-2</c:v>
                </c:pt>
                <c:pt idx="830" formatCode="General">
                  <c:v>3.3266447605525801E-2</c:v>
                </c:pt>
                <c:pt idx="831">
                  <c:v>0</c:v>
                </c:pt>
              </c:numCache>
            </c:numRef>
          </c:yVal>
          <c:smooth val="0"/>
          <c:extLst xmlns:c16r2="http://schemas.microsoft.com/office/drawing/2015/06/chart">
            <c:ext xmlns:c16="http://schemas.microsoft.com/office/drawing/2014/chart" uri="{C3380CC4-5D6E-409C-BE32-E72D297353CC}">
              <c16:uniqueId val="{00000001-8CE5-40BD-A312-9BF3B083AF1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57532384"/>
        <c:axId val="257534736"/>
      </c:scatterChart>
      <c:valAx>
        <c:axId val="257532384"/>
        <c:scaling>
          <c:orientation val="minMax"/>
          <c:max val="5475"/>
        </c:scaling>
        <c:delete val="0"/>
        <c:axPos val="b"/>
        <c:title>
          <c:tx>
            <c:rich>
              <a:bodyPr/>
              <a:lstStyle/>
              <a:p>
                <a:pPr>
                  <a:defRPr lang="ja-JP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1800" b="1" i="0" baseline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Follow-up (years)</a:t>
                </a:r>
                <a:endParaRPr lang="ja-JP" altLang="ja-JP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lang="ja-JP" sz="1600">
                <a:solidFill>
                  <a:schemeClr val="bg1"/>
                </a:solidFill>
              </a:defRPr>
            </a:pPr>
            <a:endParaRPr lang="ja-JP"/>
          </a:p>
        </c:txPr>
        <c:crossAx val="257534736"/>
        <c:crosses val="autoZero"/>
        <c:crossBetween val="midCat"/>
        <c:majorUnit val="365"/>
      </c:valAx>
      <c:valAx>
        <c:axId val="257534736"/>
        <c:scaling>
          <c:orientation val="minMax"/>
          <c:max val="1"/>
          <c:min val="0"/>
        </c:scaling>
        <c:delete val="0"/>
        <c:axPos val="l"/>
        <c:title>
          <c:tx>
            <c:rich>
              <a:bodyPr/>
              <a:lstStyle/>
              <a:p>
                <a:pPr>
                  <a:defRPr lang="ja-JP">
                    <a:latin typeface="Times New Roman" panose="02020603050405020304" pitchFamily="18" charset="0"/>
                    <a:cs typeface="Times New Roman" panose="02020603050405020304" pitchFamily="18" charset="0"/>
                  </a:defRPr>
                </a:pPr>
                <a:r>
                  <a:rPr lang="en-US" altLang="ja-JP" sz="1800" b="1" i="0" baseline="0">
                    <a:effectLst/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Survival (%)</a:t>
                </a:r>
                <a:endParaRPr lang="ja-JP" altLang="ja-JP">
                  <a:effectLst/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c:rich>
          </c:tx>
          <c:layout/>
          <c:overlay val="0"/>
        </c:title>
        <c:numFmt formatCode="0.00" sourceLinked="0"/>
        <c:majorTickMark val="out"/>
        <c:minorTickMark val="none"/>
        <c:tickLblPos val="nextTo"/>
        <c:txPr>
          <a:bodyPr/>
          <a:lstStyle/>
          <a:p>
            <a:pPr>
              <a:defRPr lang="ja-JP" sz="1600" baseline="0">
                <a:solidFill>
                  <a:schemeClr val="bg1"/>
                </a:solidFill>
              </a:defRPr>
            </a:pPr>
            <a:endParaRPr lang="ja-JP"/>
          </a:p>
        </c:txPr>
        <c:crossAx val="257532384"/>
        <c:crosses val="autoZero"/>
        <c:crossBetween val="midCat"/>
        <c:majorUnit val="0.2"/>
      </c:valAx>
      <c:spPr>
        <a:noFill/>
      </c:spPr>
    </c:plotArea>
    <c:legend>
      <c:legendPos val="r"/>
      <c:layout>
        <c:manualLayout>
          <c:xMode val="edge"/>
          <c:yMode val="edge"/>
          <c:x val="0.626958914941801"/>
          <c:y val="0.14944120656644708"/>
          <c:w val="0.17906745825123821"/>
          <c:h val="0.13005797540318065"/>
        </c:manualLayout>
      </c:layout>
      <c:overlay val="1"/>
      <c:txPr>
        <a:bodyPr/>
        <a:lstStyle/>
        <a:p>
          <a:pPr>
            <a:defRPr lang="ja-JP" sz="1800">
              <a:latin typeface="Times New Roman" panose="02020603050405020304" pitchFamily="18" charset="0"/>
              <a:cs typeface="Times New Roman" panose="02020603050405020304" pitchFamily="18" charset="0"/>
            </a:defRPr>
          </a:pPr>
          <a:endParaRPr lang="ja-JP"/>
        </a:p>
      </c:txPr>
    </c:legend>
    <c:plotVisOnly val="1"/>
    <c:dispBlanksAs val="gap"/>
    <c:showDLblsOverMax val="0"/>
  </c:chart>
  <c:txPr>
    <a:bodyPr/>
    <a:lstStyle/>
    <a:p>
      <a:pPr>
        <a:defRPr sz="900"/>
      </a:pPr>
      <a:endParaRPr lang="ja-JP"/>
    </a:p>
  </c:txPr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896146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2401051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8411935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9536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608116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1809289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90815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0017598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669495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97546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847413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CAA1B98-2565-4640-9826-E68C6A0BAA94}" type="datetimeFigureOut">
              <a:rPr kumimoji="1" lang="ja-JP" altLang="en-US" smtClean="0"/>
              <a:t>2021/3/18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345674-18AF-40ED-9392-D46B9A03E06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153992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7" name="グラフ 3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494283272"/>
              </p:ext>
            </p:extLst>
          </p:nvPr>
        </p:nvGraphicFramePr>
        <p:xfrm>
          <a:off x="337351" y="990907"/>
          <a:ext cx="11523216" cy="5026097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正方形/長方形 5"/>
          <p:cNvSpPr/>
          <p:nvPr/>
        </p:nvSpPr>
        <p:spPr>
          <a:xfrm>
            <a:off x="8468447" y="3620279"/>
            <a:ext cx="2784737" cy="64633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LD score &lt;7 vs. </a:t>
            </a:r>
            <a:r>
              <a:rPr lang="ja-JP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≧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</a:p>
          <a:p>
            <a:pPr algn="ctr"/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(log-rank test, </a:t>
            </a:r>
            <a:r>
              <a:rPr lang="en-US" altLang="ja-JP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P</a:t>
            </a:r>
            <a:r>
              <a:rPr lang="en-US" altLang="ja-JP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= 0.0012) </a:t>
            </a:r>
            <a:endParaRPr lang="ja-JP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テキスト ボックス 1"/>
          <p:cNvSpPr txBox="1"/>
          <p:nvPr/>
        </p:nvSpPr>
        <p:spPr>
          <a:xfrm>
            <a:off x="825625" y="93764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9" name="テキスト ボックス 8"/>
          <p:cNvSpPr txBox="1"/>
          <p:nvPr/>
        </p:nvSpPr>
        <p:spPr>
          <a:xfrm>
            <a:off x="825626" y="173811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0" name="テキスト ボックス 9"/>
          <p:cNvSpPr txBox="1"/>
          <p:nvPr/>
        </p:nvSpPr>
        <p:spPr>
          <a:xfrm>
            <a:off x="825625" y="2535114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テキスト ボックス 10"/>
          <p:cNvSpPr txBox="1"/>
          <p:nvPr/>
        </p:nvSpPr>
        <p:spPr>
          <a:xfrm>
            <a:off x="825625" y="3353345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テキスト ボックス 11"/>
          <p:cNvSpPr txBox="1"/>
          <p:nvPr/>
        </p:nvSpPr>
        <p:spPr>
          <a:xfrm>
            <a:off x="825623" y="415131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825623" y="494290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テキスト ボックス 13"/>
          <p:cNvSpPr txBox="1"/>
          <p:nvPr/>
        </p:nvSpPr>
        <p:spPr>
          <a:xfrm>
            <a:off x="2435445" y="5122626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テキスト ボックス 14"/>
          <p:cNvSpPr txBox="1"/>
          <p:nvPr/>
        </p:nvSpPr>
        <p:spPr>
          <a:xfrm>
            <a:off x="3115702" y="5125017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テキスト ボックス 15"/>
          <p:cNvSpPr txBox="1"/>
          <p:nvPr/>
        </p:nvSpPr>
        <p:spPr>
          <a:xfrm>
            <a:off x="1084552" y="5121927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746313" y="5125017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テキスト ボックス 17"/>
          <p:cNvSpPr txBox="1"/>
          <p:nvPr/>
        </p:nvSpPr>
        <p:spPr>
          <a:xfrm>
            <a:off x="3780974" y="5118174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4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9" name="テキスト ボックス 18"/>
          <p:cNvSpPr txBox="1"/>
          <p:nvPr/>
        </p:nvSpPr>
        <p:spPr>
          <a:xfrm>
            <a:off x="4460483" y="5118822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テキスト ボックス 19"/>
          <p:cNvSpPr txBox="1"/>
          <p:nvPr/>
        </p:nvSpPr>
        <p:spPr>
          <a:xfrm>
            <a:off x="5146273" y="5119470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6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1" name="テキスト ボックス 20"/>
          <p:cNvSpPr txBox="1"/>
          <p:nvPr/>
        </p:nvSpPr>
        <p:spPr>
          <a:xfrm>
            <a:off x="5820422" y="5120206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7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/>
          <p:cNvSpPr txBox="1"/>
          <p:nvPr/>
        </p:nvSpPr>
        <p:spPr>
          <a:xfrm>
            <a:off x="6511583" y="5120808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8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3" name="テキスト ボックス 22"/>
          <p:cNvSpPr txBox="1"/>
          <p:nvPr/>
        </p:nvSpPr>
        <p:spPr>
          <a:xfrm>
            <a:off x="7183512" y="5121048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9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4" name="テキスト ボックス 23"/>
          <p:cNvSpPr txBox="1"/>
          <p:nvPr/>
        </p:nvSpPr>
        <p:spPr>
          <a:xfrm>
            <a:off x="7854148" y="512534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テキスト ボックス 24"/>
          <p:cNvSpPr txBox="1"/>
          <p:nvPr/>
        </p:nvSpPr>
        <p:spPr>
          <a:xfrm>
            <a:off x="8527004" y="5125017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1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6" name="テキスト ボックス 25"/>
          <p:cNvSpPr txBox="1"/>
          <p:nvPr/>
        </p:nvSpPr>
        <p:spPr>
          <a:xfrm>
            <a:off x="9219275" y="5125017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テキスト ボックス 26"/>
          <p:cNvSpPr txBox="1"/>
          <p:nvPr/>
        </p:nvSpPr>
        <p:spPr>
          <a:xfrm>
            <a:off x="9877893" y="5125341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3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テキスト ボックス 27"/>
          <p:cNvSpPr txBox="1"/>
          <p:nvPr/>
        </p:nvSpPr>
        <p:spPr>
          <a:xfrm>
            <a:off x="10568505" y="5118123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9" name="テキスト ボックス 28"/>
          <p:cNvSpPr txBox="1"/>
          <p:nvPr/>
        </p:nvSpPr>
        <p:spPr>
          <a:xfrm>
            <a:off x="11240244" y="5118123"/>
            <a:ext cx="50602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1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5</a:t>
            </a:r>
            <a:endParaRPr kumimoji="1" lang="ja-JP" altLang="en-US" sz="1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正方形/長方形 2"/>
          <p:cNvSpPr/>
          <p:nvPr/>
        </p:nvSpPr>
        <p:spPr>
          <a:xfrm>
            <a:off x="53262" y="282426"/>
            <a:ext cx="12067713" cy="5232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200000"/>
              </a:lnSpc>
              <a:spcAft>
                <a:spcPts val="0"/>
              </a:spcAft>
            </a:pPr>
            <a:r>
              <a:rPr lang="en-US" altLang="ja-JP" sz="1400" b="1" dirty="0" smtClean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Supplementary Figure </a:t>
            </a:r>
            <a:r>
              <a:rPr lang="en-US" altLang="ja-JP" sz="1400" b="1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1. Cumulative 15-year survival rates by MELD score in patients with decompensated HCV-related cirrhosis (N=969). </a:t>
            </a:r>
            <a:endParaRPr lang="ja-JP" altLang="ja-JP" sz="1400" dirty="0">
              <a:effectLst/>
              <a:latin typeface="ＭＳ 明朝" panose="02020609040205080304" pitchFamily="17" charset="-128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4722225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67</TotalTime>
  <Words>64</Words>
  <Application>Microsoft Office PowerPoint</Application>
  <PresentationFormat>ワイド画面</PresentationFormat>
  <Paragraphs>27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8" baseType="lpstr">
      <vt:lpstr>ＭＳ Ｐゴシック</vt:lpstr>
      <vt:lpstr>ＭＳ 明朝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unshun</dc:creator>
  <cp:lastModifiedBy>俊一郎 藤山</cp:lastModifiedBy>
  <cp:revision>68</cp:revision>
  <cp:lastPrinted>2020-10-22T11:43:42Z</cp:lastPrinted>
  <dcterms:created xsi:type="dcterms:W3CDTF">2019-10-17T11:56:30Z</dcterms:created>
  <dcterms:modified xsi:type="dcterms:W3CDTF">2021-03-18T11:17:57Z</dcterms:modified>
</cp:coreProperties>
</file>